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9" d="100"/>
          <a:sy n="79" d="100"/>
        </p:scale>
        <p:origin x="42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en-US" sz="2000" b="0" i="0" u="none" strike="noStrike" kern="1200" spc="70" baseline="0">
                <a:solidFill>
                  <a:prstClr val="black">
                    <a:lumMod val="50000"/>
                    <a:lumOff val="50000"/>
                  </a:prst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2000" b="1" i="0" u="none" strike="noStrike" kern="1200" spc="70" baseline="0" dirty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S-GY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en-US" sz="2000" b="0" i="0" u="none" strike="noStrike" kern="1200" spc="70" baseline="0">
              <a:solidFill>
                <a:prstClr val="black">
                  <a:lumMod val="50000"/>
                  <a:lumOff val="50000"/>
                </a:prst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292RILs'!$J$1</c:f>
              <c:strCache>
                <c:ptCount val="1"/>
                <c:pt idx="0">
                  <c:v>GY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13026924759405073"/>
                  <c:y val="-0.36077282006415867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 algn="ctr" rtl="0">
                      <a:defRPr lang="en-US" sz="1197" b="0" i="0" u="none" strike="noStrike" kern="1200" baseline="0">
                        <a:solidFill>
                          <a:prstClr val="black">
                            <a:lumMod val="50000"/>
                            <a:lumOff val="50000"/>
                          </a:prst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b="1" baseline="0" dirty="0">
                        <a:solidFill>
                          <a:schemeClr val="tx1"/>
                        </a:solidFill>
                      </a:rPr>
                      <a:t>y = 38.027x - 20.725</a:t>
                    </a:r>
                    <a:br>
                      <a:rPr lang="en-US" b="1" baseline="0" dirty="0">
                        <a:solidFill>
                          <a:schemeClr val="tx1"/>
                        </a:solidFill>
                      </a:rPr>
                    </a:br>
                    <a:r>
                      <a:rPr lang="en-US" b="1" baseline="0" dirty="0">
                        <a:solidFill>
                          <a:schemeClr val="tx1"/>
                        </a:solidFill>
                      </a:rPr>
                      <a:t>R² = 0.5349</a:t>
                    </a:r>
                    <a:endParaRPr lang="en-US" b="1" dirty="0">
                      <a:solidFill>
                        <a:schemeClr val="tx1"/>
                      </a:solidFill>
                    </a:endParaRP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 algn="ctr" rtl="0">
                    <a:defRPr lang="en-US" sz="1197" b="0" i="0" u="none" strike="noStrike" kern="1200" baseline="0">
                      <a:solidFill>
                        <a:prstClr val="black">
                          <a:lumMod val="50000"/>
                          <a:lumOff val="50000"/>
                        </a:prst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'292RILs'!$C$2:$C$293</c:f>
              <c:numCache>
                <c:formatCode>0.00</c:formatCode>
                <c:ptCount val="292"/>
                <c:pt idx="0">
                  <c:v>1.9959402332223899</c:v>
                </c:pt>
                <c:pt idx="1">
                  <c:v>1.7010409489342999</c:v>
                </c:pt>
                <c:pt idx="2">
                  <c:v>1.7538984964256601</c:v>
                </c:pt>
                <c:pt idx="3">
                  <c:v>2.1202700382137198</c:v>
                </c:pt>
                <c:pt idx="4">
                  <c:v>1.86016474960495</c:v>
                </c:pt>
                <c:pt idx="5">
                  <c:v>2.02459559916465</c:v>
                </c:pt>
                <c:pt idx="6">
                  <c:v>1.8986805680741701</c:v>
                </c:pt>
                <c:pt idx="7">
                  <c:v>1.7995638994424099</c:v>
                </c:pt>
                <c:pt idx="8">
                  <c:v>1.4983483682813401</c:v>
                </c:pt>
                <c:pt idx="9">
                  <c:v>1.4346610815227601</c:v>
                </c:pt>
                <c:pt idx="10">
                  <c:v>1.78202085995205</c:v>
                </c:pt>
                <c:pt idx="11">
                  <c:v>1.8128312155541899</c:v>
                </c:pt>
                <c:pt idx="12">
                  <c:v>1.80050424232443</c:v>
                </c:pt>
                <c:pt idx="13">
                  <c:v>1.96915561557782</c:v>
                </c:pt>
                <c:pt idx="14">
                  <c:v>1.76293972199335</c:v>
                </c:pt>
                <c:pt idx="15">
                  <c:v>1.8432152221424001</c:v>
                </c:pt>
                <c:pt idx="16">
                  <c:v>1.89655218620795</c:v>
                </c:pt>
                <c:pt idx="17">
                  <c:v>1.7675393050295101</c:v>
                </c:pt>
                <c:pt idx="18">
                  <c:v>1.8501555464141799</c:v>
                </c:pt>
                <c:pt idx="19">
                  <c:v>1.9695972045071799</c:v>
                </c:pt>
                <c:pt idx="20">
                  <c:v>1.79908834944313</c:v>
                </c:pt>
                <c:pt idx="21">
                  <c:v>1.6958142108822201</c:v>
                </c:pt>
                <c:pt idx="22">
                  <c:v>1.8927024450313601</c:v>
                </c:pt>
                <c:pt idx="23">
                  <c:v>1.8815942872395599</c:v>
                </c:pt>
                <c:pt idx="24">
                  <c:v>1.816502448339</c:v>
                </c:pt>
                <c:pt idx="25">
                  <c:v>1.1069573323547801</c:v>
                </c:pt>
                <c:pt idx="26">
                  <c:v>1.8412464449434101</c:v>
                </c:pt>
                <c:pt idx="27">
                  <c:v>1.8074570782814401</c:v>
                </c:pt>
                <c:pt idx="28">
                  <c:v>1.88670446501889</c:v>
                </c:pt>
                <c:pt idx="29">
                  <c:v>1.52658405921604</c:v>
                </c:pt>
                <c:pt idx="30">
                  <c:v>1.94985501899495</c:v>
                </c:pt>
                <c:pt idx="31">
                  <c:v>1.9208156679425501</c:v>
                </c:pt>
                <c:pt idx="32">
                  <c:v>1.84141587775785</c:v>
                </c:pt>
                <c:pt idx="33">
                  <c:v>2.1203325210847899</c:v>
                </c:pt>
                <c:pt idx="34">
                  <c:v>1.96262877140271</c:v>
                </c:pt>
                <c:pt idx="35">
                  <c:v>1.64964087030344</c:v>
                </c:pt>
                <c:pt idx="36">
                  <c:v>2.1024034402664098</c:v>
                </c:pt>
                <c:pt idx="37">
                  <c:v>1.8748986957698199</c:v>
                </c:pt>
                <c:pt idx="38">
                  <c:v>1.87905909540523</c:v>
                </c:pt>
                <c:pt idx="39">
                  <c:v>2.0394128589621898</c:v>
                </c:pt>
                <c:pt idx="40">
                  <c:v>1.91055750448782</c:v>
                </c:pt>
                <c:pt idx="41">
                  <c:v>1.8528545978475199</c:v>
                </c:pt>
                <c:pt idx="42">
                  <c:v>1.7186796895983201</c:v>
                </c:pt>
                <c:pt idx="43">
                  <c:v>1.3932885813276701</c:v>
                </c:pt>
                <c:pt idx="44">
                  <c:v>1.9618199851879801</c:v>
                </c:pt>
                <c:pt idx="45">
                  <c:v>1.6909564263099099</c:v>
                </c:pt>
                <c:pt idx="46">
                  <c:v>1.11341195475067</c:v>
                </c:pt>
                <c:pt idx="47">
                  <c:v>1.8885358273403801</c:v>
                </c:pt>
                <c:pt idx="48">
                  <c:v>2.0773801759166202</c:v>
                </c:pt>
                <c:pt idx="49">
                  <c:v>1.7925304269151801</c:v>
                </c:pt>
                <c:pt idx="50">
                  <c:v>1.6820473462054599</c:v>
                </c:pt>
                <c:pt idx="51">
                  <c:v>1.5062225894019901</c:v>
                </c:pt>
                <c:pt idx="52">
                  <c:v>2.0868953994453299</c:v>
                </c:pt>
                <c:pt idx="53">
                  <c:v>1.8559538417361601</c:v>
                </c:pt>
                <c:pt idx="54">
                  <c:v>2.1376346909651698</c:v>
                </c:pt>
                <c:pt idx="55">
                  <c:v>1.9073019047443001</c:v>
                </c:pt>
                <c:pt idx="56">
                  <c:v>1.9005139664613999</c:v>
                </c:pt>
                <c:pt idx="57">
                  <c:v>1.8134817603653</c:v>
                </c:pt>
                <c:pt idx="58">
                  <c:v>2.1138404926682499</c:v>
                </c:pt>
                <c:pt idx="59">
                  <c:v>1.5733022369233201</c:v>
                </c:pt>
                <c:pt idx="60">
                  <c:v>2.0993018792795399</c:v>
                </c:pt>
                <c:pt idx="61">
                  <c:v>1.6480320849984</c:v>
                </c:pt>
                <c:pt idx="62">
                  <c:v>1.6303711003572501</c:v>
                </c:pt>
                <c:pt idx="63">
                  <c:v>1.45377949242593</c:v>
                </c:pt>
                <c:pt idx="64">
                  <c:v>2.0550246939457701</c:v>
                </c:pt>
                <c:pt idx="65">
                  <c:v>1.95900681534941</c:v>
                </c:pt>
                <c:pt idx="66">
                  <c:v>1.7563936572829899</c:v>
                </c:pt>
                <c:pt idx="67">
                  <c:v>1.81193743122615</c:v>
                </c:pt>
                <c:pt idx="68">
                  <c:v>1.51904168521187</c:v>
                </c:pt>
                <c:pt idx="69">
                  <c:v>1.95400093761921</c:v>
                </c:pt>
                <c:pt idx="70">
                  <c:v>1.33466545505067</c:v>
                </c:pt>
                <c:pt idx="71">
                  <c:v>1.2759151264874899</c:v>
                </c:pt>
                <c:pt idx="72">
                  <c:v>1.80350604364546</c:v>
                </c:pt>
                <c:pt idx="73">
                  <c:v>1.72524641263562</c:v>
                </c:pt>
                <c:pt idx="74">
                  <c:v>2.0981650181133999</c:v>
                </c:pt>
                <c:pt idx="75">
                  <c:v>1.78849088751399</c:v>
                </c:pt>
                <c:pt idx="76">
                  <c:v>1.8799502427641499</c:v>
                </c:pt>
                <c:pt idx="77">
                  <c:v>1.7376809469307299</c:v>
                </c:pt>
                <c:pt idx="78">
                  <c:v>1.7008080405902199</c:v>
                </c:pt>
                <c:pt idx="79">
                  <c:v>1.2849430026228801</c:v>
                </c:pt>
                <c:pt idx="80">
                  <c:v>1.8416808223165499</c:v>
                </c:pt>
                <c:pt idx="81">
                  <c:v>2.0705400046154301</c:v>
                </c:pt>
                <c:pt idx="82">
                  <c:v>1.63383814253018</c:v>
                </c:pt>
                <c:pt idx="83">
                  <c:v>1.78528397158944</c:v>
                </c:pt>
                <c:pt idx="84">
                  <c:v>1.9405699133193901</c:v>
                </c:pt>
                <c:pt idx="85">
                  <c:v>1.5250543203854601</c:v>
                </c:pt>
                <c:pt idx="86">
                  <c:v>1.5308609205627399</c:v>
                </c:pt>
                <c:pt idx="87">
                  <c:v>1.3591224790109</c:v>
                </c:pt>
                <c:pt idx="88">
                  <c:v>1.6137133032547499</c:v>
                </c:pt>
                <c:pt idx="89">
                  <c:v>1.79072471056209</c:v>
                </c:pt>
                <c:pt idx="90">
                  <c:v>1.8221760750117</c:v>
                </c:pt>
                <c:pt idx="91">
                  <c:v>1.88900671805041</c:v>
                </c:pt>
                <c:pt idx="92">
                  <c:v>1.8717168909250499</c:v>
                </c:pt>
                <c:pt idx="93">
                  <c:v>1.7306684868672799</c:v>
                </c:pt>
                <c:pt idx="94">
                  <c:v>2.0214876415210101</c:v>
                </c:pt>
                <c:pt idx="95">
                  <c:v>1.7455581666931601</c:v>
                </c:pt>
                <c:pt idx="96">
                  <c:v>1.7233884593592601</c:v>
                </c:pt>
                <c:pt idx="97">
                  <c:v>2.0895177542328498</c:v>
                </c:pt>
                <c:pt idx="98">
                  <c:v>1.85095998213893</c:v>
                </c:pt>
                <c:pt idx="99">
                  <c:v>1.8254346344147201</c:v>
                </c:pt>
                <c:pt idx="100">
                  <c:v>1.98595777057305</c:v>
                </c:pt>
                <c:pt idx="101">
                  <c:v>1.99757473555919</c:v>
                </c:pt>
                <c:pt idx="102">
                  <c:v>1.9291343091934701</c:v>
                </c:pt>
                <c:pt idx="103">
                  <c:v>1.77632962876791</c:v>
                </c:pt>
                <c:pt idx="104">
                  <c:v>2.0006169917899701</c:v>
                </c:pt>
                <c:pt idx="105">
                  <c:v>1.8886750737133799</c:v>
                </c:pt>
                <c:pt idx="106">
                  <c:v>2.0876838845519199</c:v>
                </c:pt>
                <c:pt idx="107">
                  <c:v>2.0123346773289801</c:v>
                </c:pt>
                <c:pt idx="108">
                  <c:v>1.8637451649121299</c:v>
                </c:pt>
                <c:pt idx="109">
                  <c:v>1.9826510147426699</c:v>
                </c:pt>
                <c:pt idx="110">
                  <c:v>2.1330886802924098</c:v>
                </c:pt>
                <c:pt idx="111">
                  <c:v>1.76708735165265</c:v>
                </c:pt>
                <c:pt idx="112">
                  <c:v>1.5644799834821299</c:v>
                </c:pt>
                <c:pt idx="113">
                  <c:v>1.8774256138904599</c:v>
                </c:pt>
                <c:pt idx="114">
                  <c:v>1.89056140743182</c:v>
                </c:pt>
                <c:pt idx="115">
                  <c:v>2.0927592666200301</c:v>
                </c:pt>
                <c:pt idx="116">
                  <c:v>1.88675165111499</c:v>
                </c:pt>
                <c:pt idx="117">
                  <c:v>1.5295485339272501</c:v>
                </c:pt>
                <c:pt idx="118">
                  <c:v>1.8819802009695801</c:v>
                </c:pt>
                <c:pt idx="119">
                  <c:v>1.76895708551181</c:v>
                </c:pt>
                <c:pt idx="120">
                  <c:v>1.8828602978906299</c:v>
                </c:pt>
                <c:pt idx="121">
                  <c:v>1.8700741312793301</c:v>
                </c:pt>
                <c:pt idx="122">
                  <c:v>1.9020887080395099</c:v>
                </c:pt>
                <c:pt idx="123">
                  <c:v>2.0276902903911602</c:v>
                </c:pt>
                <c:pt idx="124">
                  <c:v>1.90229818341212</c:v>
                </c:pt>
                <c:pt idx="125">
                  <c:v>1.7915647946225299</c:v>
                </c:pt>
                <c:pt idx="126">
                  <c:v>1.93022510295914</c:v>
                </c:pt>
                <c:pt idx="127">
                  <c:v>1.9106776368726199</c:v>
                </c:pt>
                <c:pt idx="128">
                  <c:v>2.1408259093870301</c:v>
                </c:pt>
                <c:pt idx="129">
                  <c:v>2.0738583117137002</c:v>
                </c:pt>
                <c:pt idx="130">
                  <c:v>1.97320214199346</c:v>
                </c:pt>
                <c:pt idx="131">
                  <c:v>1.8882812591984699</c:v>
                </c:pt>
                <c:pt idx="132">
                  <c:v>2.0505360800479902</c:v>
                </c:pt>
                <c:pt idx="133">
                  <c:v>1.73804176208404</c:v>
                </c:pt>
                <c:pt idx="134">
                  <c:v>1.94044594816923</c:v>
                </c:pt>
                <c:pt idx="135">
                  <c:v>2.0722353935369902</c:v>
                </c:pt>
                <c:pt idx="136">
                  <c:v>1.4407233857150501</c:v>
                </c:pt>
                <c:pt idx="137">
                  <c:v>2.09826414104367</c:v>
                </c:pt>
                <c:pt idx="138">
                  <c:v>1.6492861247130599</c:v>
                </c:pt>
                <c:pt idx="139">
                  <c:v>1.9964221891928</c:v>
                </c:pt>
                <c:pt idx="140">
                  <c:v>1.93578393760676</c:v>
                </c:pt>
                <c:pt idx="141">
                  <c:v>1.8309768015452801</c:v>
                </c:pt>
                <c:pt idx="142">
                  <c:v>1.58229239089575</c:v>
                </c:pt>
                <c:pt idx="143">
                  <c:v>1.88509318807855</c:v>
                </c:pt>
                <c:pt idx="144">
                  <c:v>2.0563837847176099</c:v>
                </c:pt>
                <c:pt idx="145">
                  <c:v>1.80518951578779</c:v>
                </c:pt>
                <c:pt idx="146">
                  <c:v>2.0517008990284502</c:v>
                </c:pt>
                <c:pt idx="147">
                  <c:v>1.7403502006490701</c:v>
                </c:pt>
                <c:pt idx="148">
                  <c:v>1.77285510788483</c:v>
                </c:pt>
                <c:pt idx="149">
                  <c:v>2.0844528472445498</c:v>
                </c:pt>
                <c:pt idx="150">
                  <c:v>2.0288096560787299</c:v>
                </c:pt>
                <c:pt idx="151">
                  <c:v>1.8125248331893</c:v>
                </c:pt>
                <c:pt idx="152">
                  <c:v>2.1560013818255199</c:v>
                </c:pt>
                <c:pt idx="153">
                  <c:v>1.8568164068323401</c:v>
                </c:pt>
                <c:pt idx="154">
                  <c:v>1.8488459687803001</c:v>
                </c:pt>
                <c:pt idx="155">
                  <c:v>1.8818202185698201</c:v>
                </c:pt>
                <c:pt idx="156">
                  <c:v>1.6538379221899</c:v>
                </c:pt>
                <c:pt idx="157">
                  <c:v>1.87505132203637</c:v>
                </c:pt>
                <c:pt idx="158">
                  <c:v>2.08762104290324</c:v>
                </c:pt>
                <c:pt idx="159">
                  <c:v>1.88889149701852</c:v>
                </c:pt>
                <c:pt idx="160">
                  <c:v>2.1378245085838299</c:v>
                </c:pt>
                <c:pt idx="161">
                  <c:v>1.8849262786579499</c:v>
                </c:pt>
                <c:pt idx="162">
                  <c:v>2.0192837870737401</c:v>
                </c:pt>
                <c:pt idx="163">
                  <c:v>2.09394376461294</c:v>
                </c:pt>
                <c:pt idx="164">
                  <c:v>2.0319722474589201</c:v>
                </c:pt>
                <c:pt idx="165">
                  <c:v>1.61369663759264</c:v>
                </c:pt>
                <c:pt idx="166">
                  <c:v>1.83694635782083</c:v>
                </c:pt>
                <c:pt idx="167">
                  <c:v>1.80638808151881</c:v>
                </c:pt>
                <c:pt idx="168">
                  <c:v>1.89653959543194</c:v>
                </c:pt>
                <c:pt idx="169">
                  <c:v>1.92562433567169</c:v>
                </c:pt>
                <c:pt idx="170">
                  <c:v>1.7505937566033201</c:v>
                </c:pt>
                <c:pt idx="171">
                  <c:v>1.8945761030760999</c:v>
                </c:pt>
                <c:pt idx="172">
                  <c:v>1.9719979003549699</c:v>
                </c:pt>
                <c:pt idx="173">
                  <c:v>1.66099714395246</c:v>
                </c:pt>
                <c:pt idx="174">
                  <c:v>2.0604522796840099</c:v>
                </c:pt>
                <c:pt idx="175">
                  <c:v>1.8822569152184301</c:v>
                </c:pt>
                <c:pt idx="176">
                  <c:v>1.89446100165431</c:v>
                </c:pt>
                <c:pt idx="177">
                  <c:v>2.0386962836447302</c:v>
                </c:pt>
                <c:pt idx="178">
                  <c:v>1.82090032772826</c:v>
                </c:pt>
                <c:pt idx="179">
                  <c:v>1.87214001922967</c:v>
                </c:pt>
                <c:pt idx="180">
                  <c:v>1.7502019094886101</c:v>
                </c:pt>
                <c:pt idx="181">
                  <c:v>1.76389064848817</c:v>
                </c:pt>
                <c:pt idx="182">
                  <c:v>2.02945308963676</c:v>
                </c:pt>
                <c:pt idx="183">
                  <c:v>1.1441315942852399</c:v>
                </c:pt>
                <c:pt idx="184">
                  <c:v>2.1096060650183501</c:v>
                </c:pt>
                <c:pt idx="185">
                  <c:v>1.7344159508327699</c:v>
                </c:pt>
                <c:pt idx="186">
                  <c:v>1.87563592100688</c:v>
                </c:pt>
                <c:pt idx="187">
                  <c:v>1.9530971965622499</c:v>
                </c:pt>
                <c:pt idx="188">
                  <c:v>2.0187915982034799</c:v>
                </c:pt>
                <c:pt idx="189">
                  <c:v>2.0006863325051101</c:v>
                </c:pt>
                <c:pt idx="190">
                  <c:v>1.80030595459133</c:v>
                </c:pt>
                <c:pt idx="191">
                  <c:v>1.88828220045388</c:v>
                </c:pt>
                <c:pt idx="192">
                  <c:v>2.1465314854308102</c:v>
                </c:pt>
                <c:pt idx="193">
                  <c:v>1.86826641876082</c:v>
                </c:pt>
                <c:pt idx="194">
                  <c:v>1.68730652295299</c:v>
                </c:pt>
                <c:pt idx="195">
                  <c:v>1.85856245517297</c:v>
                </c:pt>
                <c:pt idx="196">
                  <c:v>2.06341070418169</c:v>
                </c:pt>
                <c:pt idx="197">
                  <c:v>1.44448670129117</c:v>
                </c:pt>
                <c:pt idx="198">
                  <c:v>2.01013388729953</c:v>
                </c:pt>
                <c:pt idx="199">
                  <c:v>2.0463674128731899</c:v>
                </c:pt>
                <c:pt idx="200">
                  <c:v>1.6194548940880999</c:v>
                </c:pt>
                <c:pt idx="201">
                  <c:v>2.0260322720117898</c:v>
                </c:pt>
                <c:pt idx="202">
                  <c:v>1.9403596042352</c:v>
                </c:pt>
                <c:pt idx="203">
                  <c:v>1.60251356444987</c:v>
                </c:pt>
                <c:pt idx="204">
                  <c:v>2.02557769978936</c:v>
                </c:pt>
                <c:pt idx="205">
                  <c:v>1.4161133950650899</c:v>
                </c:pt>
                <c:pt idx="206">
                  <c:v>2.04325368145971</c:v>
                </c:pt>
                <c:pt idx="207">
                  <c:v>1.48491209924773</c:v>
                </c:pt>
                <c:pt idx="208">
                  <c:v>1.9953845756014801</c:v>
                </c:pt>
                <c:pt idx="209">
                  <c:v>1.8469473352368799</c:v>
                </c:pt>
                <c:pt idx="210">
                  <c:v>1.9735632526337701</c:v>
                </c:pt>
                <c:pt idx="211">
                  <c:v>1.81464084781591</c:v>
                </c:pt>
                <c:pt idx="212">
                  <c:v>1.76257514108211</c:v>
                </c:pt>
                <c:pt idx="213">
                  <c:v>1.7104563465745899</c:v>
                </c:pt>
                <c:pt idx="214">
                  <c:v>1.87444572877282</c:v>
                </c:pt>
                <c:pt idx="215">
                  <c:v>1.87828712494054</c:v>
                </c:pt>
                <c:pt idx="216">
                  <c:v>1.52299618670881</c:v>
                </c:pt>
                <c:pt idx="217">
                  <c:v>1.79297070520466</c:v>
                </c:pt>
                <c:pt idx="218">
                  <c:v>1.7732790221235699</c:v>
                </c:pt>
                <c:pt idx="219">
                  <c:v>1.92670853500021</c:v>
                </c:pt>
                <c:pt idx="220">
                  <c:v>1.28216245230077</c:v>
                </c:pt>
                <c:pt idx="221">
                  <c:v>1.8761318506562701</c:v>
                </c:pt>
                <c:pt idx="222">
                  <c:v>2.0206010235958001</c:v>
                </c:pt>
                <c:pt idx="223">
                  <c:v>1.67017234774682</c:v>
                </c:pt>
                <c:pt idx="224">
                  <c:v>1.6001232290494101</c:v>
                </c:pt>
                <c:pt idx="225">
                  <c:v>2.1507667506925801</c:v>
                </c:pt>
                <c:pt idx="226">
                  <c:v>1.6550679640808399</c:v>
                </c:pt>
                <c:pt idx="227">
                  <c:v>1.6316229695289399</c:v>
                </c:pt>
                <c:pt idx="228">
                  <c:v>2.1440416491760601</c:v>
                </c:pt>
                <c:pt idx="229">
                  <c:v>1.6624124997351299</c:v>
                </c:pt>
                <c:pt idx="230">
                  <c:v>2.1303823126033401</c:v>
                </c:pt>
                <c:pt idx="231">
                  <c:v>1.7402323553430099</c:v>
                </c:pt>
                <c:pt idx="232">
                  <c:v>1.9032136535575299</c:v>
                </c:pt>
                <c:pt idx="233">
                  <c:v>1.8471793814316899</c:v>
                </c:pt>
                <c:pt idx="234">
                  <c:v>1.7644600831983599</c:v>
                </c:pt>
                <c:pt idx="235">
                  <c:v>1.4969314735235499</c:v>
                </c:pt>
                <c:pt idx="236">
                  <c:v>1.7241222492500601</c:v>
                </c:pt>
                <c:pt idx="237">
                  <c:v>1.75663668538553</c:v>
                </c:pt>
                <c:pt idx="238">
                  <c:v>1.7988413480872001</c:v>
                </c:pt>
                <c:pt idx="239">
                  <c:v>1.33892604343012</c:v>
                </c:pt>
                <c:pt idx="240">
                  <c:v>1.7921575914876999</c:v>
                </c:pt>
                <c:pt idx="241">
                  <c:v>1.87749560130244</c:v>
                </c:pt>
                <c:pt idx="242">
                  <c:v>1.8704989524829201</c:v>
                </c:pt>
                <c:pt idx="243">
                  <c:v>2.1182734099332898</c:v>
                </c:pt>
                <c:pt idx="244">
                  <c:v>1.8667810332318999</c:v>
                </c:pt>
                <c:pt idx="245">
                  <c:v>1.87945548691801</c:v>
                </c:pt>
                <c:pt idx="246">
                  <c:v>1.8443484902949401</c:v>
                </c:pt>
                <c:pt idx="247">
                  <c:v>1.1612715517018699</c:v>
                </c:pt>
                <c:pt idx="248">
                  <c:v>1.86661973792418</c:v>
                </c:pt>
                <c:pt idx="249">
                  <c:v>1.6736739831163601</c:v>
                </c:pt>
                <c:pt idx="250">
                  <c:v>1.9074250253803799</c:v>
                </c:pt>
                <c:pt idx="251">
                  <c:v>1.7984528049070201</c:v>
                </c:pt>
                <c:pt idx="252">
                  <c:v>1.74732999229787</c:v>
                </c:pt>
                <c:pt idx="253">
                  <c:v>2.08153483437084</c:v>
                </c:pt>
                <c:pt idx="254">
                  <c:v>2.1289417352692399</c:v>
                </c:pt>
                <c:pt idx="255">
                  <c:v>1.6279043558890101</c:v>
                </c:pt>
                <c:pt idx="256">
                  <c:v>1.8552582905789701</c:v>
                </c:pt>
                <c:pt idx="257">
                  <c:v>1.9078730605663901</c:v>
                </c:pt>
                <c:pt idx="258">
                  <c:v>1.98529589197736</c:v>
                </c:pt>
                <c:pt idx="259">
                  <c:v>1.71853031039418</c:v>
                </c:pt>
                <c:pt idx="260">
                  <c:v>1.8294938354361601</c:v>
                </c:pt>
                <c:pt idx="261">
                  <c:v>1.73057357035479</c:v>
                </c:pt>
                <c:pt idx="262">
                  <c:v>1.9402780486319999</c:v>
                </c:pt>
                <c:pt idx="263">
                  <c:v>1.86222781375295</c:v>
                </c:pt>
                <c:pt idx="264">
                  <c:v>1.5592463186387</c:v>
                </c:pt>
                <c:pt idx="265">
                  <c:v>1.84346003465782</c:v>
                </c:pt>
                <c:pt idx="266">
                  <c:v>1.9744668194334201</c:v>
                </c:pt>
                <c:pt idx="267">
                  <c:v>1.99006909086346</c:v>
                </c:pt>
                <c:pt idx="268">
                  <c:v>1.7248329374839899</c:v>
                </c:pt>
                <c:pt idx="269">
                  <c:v>2.0729114822324899</c:v>
                </c:pt>
                <c:pt idx="270">
                  <c:v>1.7051220480948801</c:v>
                </c:pt>
                <c:pt idx="271">
                  <c:v>1.94429986085111</c:v>
                </c:pt>
                <c:pt idx="272">
                  <c:v>1.1900920279906599</c:v>
                </c:pt>
                <c:pt idx="273">
                  <c:v>1.38753921181004</c:v>
                </c:pt>
                <c:pt idx="274">
                  <c:v>2.15244958890609</c:v>
                </c:pt>
                <c:pt idx="275">
                  <c:v>2.0766015398112598</c:v>
                </c:pt>
                <c:pt idx="276">
                  <c:v>1.33111904369227</c:v>
                </c:pt>
                <c:pt idx="277">
                  <c:v>1.9302377850585599</c:v>
                </c:pt>
                <c:pt idx="278">
                  <c:v>1.6772178240358999</c:v>
                </c:pt>
                <c:pt idx="279">
                  <c:v>2.0019244496793802</c:v>
                </c:pt>
                <c:pt idx="280">
                  <c:v>1.8292409495570401</c:v>
                </c:pt>
                <c:pt idx="281">
                  <c:v>1.81352590756101</c:v>
                </c:pt>
                <c:pt idx="282">
                  <c:v>1.8356109941401</c:v>
                </c:pt>
                <c:pt idx="283">
                  <c:v>1.91575944229633</c:v>
                </c:pt>
                <c:pt idx="284">
                  <c:v>2.08000241264034</c:v>
                </c:pt>
                <c:pt idx="285">
                  <c:v>1.7835484894229601</c:v>
                </c:pt>
                <c:pt idx="286">
                  <c:v>1.7727563692562101</c:v>
                </c:pt>
                <c:pt idx="287">
                  <c:v>2.1141863777707299</c:v>
                </c:pt>
                <c:pt idx="288">
                  <c:v>2.0978672781385801</c:v>
                </c:pt>
                <c:pt idx="289">
                  <c:v>1.91393840263096</c:v>
                </c:pt>
                <c:pt idx="290">
                  <c:v>1.9005793828622699</c:v>
                </c:pt>
                <c:pt idx="291">
                  <c:v>1.84570546103183</c:v>
                </c:pt>
              </c:numCache>
            </c:numRef>
          </c:xVal>
          <c:yVal>
            <c:numRef>
              <c:f>'292RILs'!$J$2:$J$293</c:f>
              <c:numCache>
                <c:formatCode>0.00</c:formatCode>
                <c:ptCount val="292"/>
                <c:pt idx="0">
                  <c:v>51.957344674538902</c:v>
                </c:pt>
                <c:pt idx="1">
                  <c:v>42.771643100609801</c:v>
                </c:pt>
                <c:pt idx="2">
                  <c:v>36.275734582754403</c:v>
                </c:pt>
                <c:pt idx="3">
                  <c:v>62.301912168801003</c:v>
                </c:pt>
                <c:pt idx="4">
                  <c:v>43.706431614574903</c:v>
                </c:pt>
                <c:pt idx="5">
                  <c:v>56.135867366873804</c:v>
                </c:pt>
                <c:pt idx="6">
                  <c:v>51.2944565960887</c:v>
                </c:pt>
                <c:pt idx="7">
                  <c:v>53.970787103864303</c:v>
                </c:pt>
                <c:pt idx="8">
                  <c:v>40.604188915017602</c:v>
                </c:pt>
                <c:pt idx="9">
                  <c:v>40.041307834199202</c:v>
                </c:pt>
                <c:pt idx="10">
                  <c:v>43.513287681726197</c:v>
                </c:pt>
                <c:pt idx="11">
                  <c:v>52.320438525230102</c:v>
                </c:pt>
                <c:pt idx="12">
                  <c:v>44.0640446264728</c:v>
                </c:pt>
                <c:pt idx="13">
                  <c:v>44.081247203647102</c:v>
                </c:pt>
                <c:pt idx="14">
                  <c:v>52.288865921826599</c:v>
                </c:pt>
                <c:pt idx="15">
                  <c:v>46.315033124096303</c:v>
                </c:pt>
                <c:pt idx="16">
                  <c:v>39.750668300323902</c:v>
                </c:pt>
                <c:pt idx="17">
                  <c:v>53.598909553703002</c:v>
                </c:pt>
                <c:pt idx="18">
                  <c:v>52.850468621291199</c:v>
                </c:pt>
                <c:pt idx="19">
                  <c:v>53.824491255124002</c:v>
                </c:pt>
                <c:pt idx="20">
                  <c:v>46.009881115306499</c:v>
                </c:pt>
                <c:pt idx="21">
                  <c:v>36.518496356028898</c:v>
                </c:pt>
                <c:pt idx="22">
                  <c:v>41.294593337536803</c:v>
                </c:pt>
                <c:pt idx="23">
                  <c:v>45.958022477564199</c:v>
                </c:pt>
                <c:pt idx="24">
                  <c:v>47.925405991737797</c:v>
                </c:pt>
                <c:pt idx="25">
                  <c:v>11.005013147725499</c:v>
                </c:pt>
                <c:pt idx="26">
                  <c:v>43.149014657858302</c:v>
                </c:pt>
                <c:pt idx="27">
                  <c:v>53.469521150627997</c:v>
                </c:pt>
                <c:pt idx="28">
                  <c:v>40.944698749079997</c:v>
                </c:pt>
                <c:pt idx="29">
                  <c:v>32.014345066134403</c:v>
                </c:pt>
                <c:pt idx="30">
                  <c:v>51.698314560610299</c:v>
                </c:pt>
                <c:pt idx="31">
                  <c:v>49.5472115631514</c:v>
                </c:pt>
                <c:pt idx="32">
                  <c:v>45.452687935141299</c:v>
                </c:pt>
                <c:pt idx="33">
                  <c:v>56.477835898016998</c:v>
                </c:pt>
                <c:pt idx="34">
                  <c:v>57.646610273687102</c:v>
                </c:pt>
                <c:pt idx="35">
                  <c:v>35.198572115527199</c:v>
                </c:pt>
                <c:pt idx="36">
                  <c:v>54.745406828150102</c:v>
                </c:pt>
                <c:pt idx="37">
                  <c:v>58.886155693562301</c:v>
                </c:pt>
                <c:pt idx="38">
                  <c:v>57.813059728038503</c:v>
                </c:pt>
                <c:pt idx="39">
                  <c:v>45.3360657903945</c:v>
                </c:pt>
                <c:pt idx="40">
                  <c:v>49.148935289332698</c:v>
                </c:pt>
                <c:pt idx="41">
                  <c:v>55.830019836239799</c:v>
                </c:pt>
                <c:pt idx="42">
                  <c:v>35.488658441692998</c:v>
                </c:pt>
                <c:pt idx="43">
                  <c:v>22.9230942592167</c:v>
                </c:pt>
                <c:pt idx="44">
                  <c:v>50.987414970437598</c:v>
                </c:pt>
                <c:pt idx="45">
                  <c:v>37.639477014459899</c:v>
                </c:pt>
                <c:pt idx="46">
                  <c:v>26.260706683640802</c:v>
                </c:pt>
                <c:pt idx="47">
                  <c:v>65.342128094534004</c:v>
                </c:pt>
                <c:pt idx="48">
                  <c:v>57.132777307313802</c:v>
                </c:pt>
                <c:pt idx="49">
                  <c:v>52.942317860753299</c:v>
                </c:pt>
                <c:pt idx="50">
                  <c:v>36.192499055746303</c:v>
                </c:pt>
                <c:pt idx="51">
                  <c:v>35.808306822742701</c:v>
                </c:pt>
                <c:pt idx="52">
                  <c:v>65.940997210174103</c:v>
                </c:pt>
                <c:pt idx="53">
                  <c:v>55.479718011180601</c:v>
                </c:pt>
                <c:pt idx="54">
                  <c:v>52.476360151777001</c:v>
                </c:pt>
                <c:pt idx="55">
                  <c:v>60.067806928850999</c:v>
                </c:pt>
                <c:pt idx="56">
                  <c:v>48.187534194490098</c:v>
                </c:pt>
                <c:pt idx="57">
                  <c:v>55.1249011884182</c:v>
                </c:pt>
                <c:pt idx="58">
                  <c:v>55.985237010011502</c:v>
                </c:pt>
                <c:pt idx="59">
                  <c:v>27.087416721333302</c:v>
                </c:pt>
                <c:pt idx="60">
                  <c:v>68.706426638715897</c:v>
                </c:pt>
                <c:pt idx="61">
                  <c:v>46.287502298341401</c:v>
                </c:pt>
                <c:pt idx="62">
                  <c:v>45.557343681110197</c:v>
                </c:pt>
                <c:pt idx="63">
                  <c:v>26.2363858130403</c:v>
                </c:pt>
                <c:pt idx="64">
                  <c:v>55.0889600719618</c:v>
                </c:pt>
                <c:pt idx="65">
                  <c:v>52.524908477023502</c:v>
                </c:pt>
                <c:pt idx="66">
                  <c:v>37.279506690300302</c:v>
                </c:pt>
                <c:pt idx="67">
                  <c:v>37.280760875793298</c:v>
                </c:pt>
                <c:pt idx="68">
                  <c:v>36.513203740657502</c:v>
                </c:pt>
                <c:pt idx="69">
                  <c:v>51.499183753849202</c:v>
                </c:pt>
                <c:pt idx="70">
                  <c:v>29.989878195759399</c:v>
                </c:pt>
                <c:pt idx="71">
                  <c:v>30.264070948353002</c:v>
                </c:pt>
                <c:pt idx="72">
                  <c:v>44.420751026515298</c:v>
                </c:pt>
                <c:pt idx="73">
                  <c:v>41.204080758129301</c:v>
                </c:pt>
                <c:pt idx="74">
                  <c:v>91.606073652148197</c:v>
                </c:pt>
                <c:pt idx="75">
                  <c:v>51.4538919554142</c:v>
                </c:pt>
                <c:pt idx="76">
                  <c:v>52.257724782601699</c:v>
                </c:pt>
                <c:pt idx="77">
                  <c:v>41.883586558693402</c:v>
                </c:pt>
                <c:pt idx="78">
                  <c:v>55.985770233278103</c:v>
                </c:pt>
                <c:pt idx="79">
                  <c:v>34.834295964417201</c:v>
                </c:pt>
                <c:pt idx="80">
                  <c:v>36.450295257813103</c:v>
                </c:pt>
                <c:pt idx="81">
                  <c:v>60.367729123519702</c:v>
                </c:pt>
                <c:pt idx="82">
                  <c:v>32.833699196186501</c:v>
                </c:pt>
                <c:pt idx="83">
                  <c:v>55.1766964575895</c:v>
                </c:pt>
                <c:pt idx="84">
                  <c:v>60.788045673866797</c:v>
                </c:pt>
                <c:pt idx="85">
                  <c:v>44.021895952107599</c:v>
                </c:pt>
                <c:pt idx="86">
                  <c:v>39.662430744794896</c:v>
                </c:pt>
                <c:pt idx="87">
                  <c:v>42.157074676474203</c:v>
                </c:pt>
                <c:pt idx="88">
                  <c:v>43.820711719690799</c:v>
                </c:pt>
                <c:pt idx="89">
                  <c:v>33.451728178817397</c:v>
                </c:pt>
                <c:pt idx="90">
                  <c:v>57.561746528463701</c:v>
                </c:pt>
                <c:pt idx="91">
                  <c:v>51.712057837297202</c:v>
                </c:pt>
                <c:pt idx="92">
                  <c:v>43.956505956896898</c:v>
                </c:pt>
                <c:pt idx="93">
                  <c:v>51.491973636038999</c:v>
                </c:pt>
                <c:pt idx="94">
                  <c:v>51.1557460392157</c:v>
                </c:pt>
                <c:pt idx="95">
                  <c:v>41.3552172189655</c:v>
                </c:pt>
                <c:pt idx="96">
                  <c:v>55.837959642689398</c:v>
                </c:pt>
                <c:pt idx="97">
                  <c:v>53.100681114625203</c:v>
                </c:pt>
                <c:pt idx="98">
                  <c:v>48.851892450463502</c:v>
                </c:pt>
                <c:pt idx="99">
                  <c:v>47.014493453573699</c:v>
                </c:pt>
                <c:pt idx="100">
                  <c:v>57.709021870382799</c:v>
                </c:pt>
                <c:pt idx="101">
                  <c:v>50.382026362019197</c:v>
                </c:pt>
                <c:pt idx="102">
                  <c:v>54.301830040616103</c:v>
                </c:pt>
                <c:pt idx="103">
                  <c:v>53.3092043057109</c:v>
                </c:pt>
                <c:pt idx="104">
                  <c:v>57.380538514855701</c:v>
                </c:pt>
                <c:pt idx="105">
                  <c:v>50.653768749940497</c:v>
                </c:pt>
                <c:pt idx="106">
                  <c:v>58.1498290470239</c:v>
                </c:pt>
                <c:pt idx="107">
                  <c:v>55.144211539154099</c:v>
                </c:pt>
                <c:pt idx="108">
                  <c:v>47.268708965696398</c:v>
                </c:pt>
                <c:pt idx="109">
                  <c:v>60.554003979487398</c:v>
                </c:pt>
                <c:pt idx="110">
                  <c:v>58.029094726566001</c:v>
                </c:pt>
                <c:pt idx="111">
                  <c:v>46.511996841510602</c:v>
                </c:pt>
                <c:pt idx="112">
                  <c:v>53.983375533290101</c:v>
                </c:pt>
                <c:pt idx="113">
                  <c:v>55.984390680700997</c:v>
                </c:pt>
                <c:pt idx="114">
                  <c:v>38.2669073819592</c:v>
                </c:pt>
                <c:pt idx="115">
                  <c:v>62.872046583534299</c:v>
                </c:pt>
                <c:pt idx="116">
                  <c:v>47.833191000408902</c:v>
                </c:pt>
                <c:pt idx="117">
                  <c:v>35.479141377455498</c:v>
                </c:pt>
                <c:pt idx="118">
                  <c:v>38.5450316088642</c:v>
                </c:pt>
                <c:pt idx="119">
                  <c:v>36.593646739771501</c:v>
                </c:pt>
                <c:pt idx="120">
                  <c:v>50.675617729720898</c:v>
                </c:pt>
                <c:pt idx="121">
                  <c:v>47.875000223918597</c:v>
                </c:pt>
                <c:pt idx="122">
                  <c:v>46.497694145880601</c:v>
                </c:pt>
                <c:pt idx="123">
                  <c:v>67.381201316268104</c:v>
                </c:pt>
                <c:pt idx="124">
                  <c:v>50.203723995422997</c:v>
                </c:pt>
                <c:pt idx="125">
                  <c:v>50.182298367662099</c:v>
                </c:pt>
                <c:pt idx="126">
                  <c:v>51.734990809434898</c:v>
                </c:pt>
                <c:pt idx="127">
                  <c:v>59.143708578343798</c:v>
                </c:pt>
                <c:pt idx="128">
                  <c:v>68.750486625857206</c:v>
                </c:pt>
                <c:pt idx="129">
                  <c:v>59.730723265990797</c:v>
                </c:pt>
                <c:pt idx="130">
                  <c:v>64.000037661753694</c:v>
                </c:pt>
                <c:pt idx="131">
                  <c:v>52.9300700683389</c:v>
                </c:pt>
                <c:pt idx="132">
                  <c:v>54.107976589964501</c:v>
                </c:pt>
                <c:pt idx="133">
                  <c:v>43.3712740744242</c:v>
                </c:pt>
                <c:pt idx="134">
                  <c:v>62.252320503296303</c:v>
                </c:pt>
                <c:pt idx="135">
                  <c:v>59.062773152919497</c:v>
                </c:pt>
                <c:pt idx="136">
                  <c:v>41.451976885765703</c:v>
                </c:pt>
                <c:pt idx="137">
                  <c:v>52.280663841156503</c:v>
                </c:pt>
                <c:pt idx="138">
                  <c:v>38.817761873689697</c:v>
                </c:pt>
                <c:pt idx="139">
                  <c:v>49.953092689133101</c:v>
                </c:pt>
                <c:pt idx="140">
                  <c:v>50.7901054259708</c:v>
                </c:pt>
                <c:pt idx="141">
                  <c:v>46.897362993995799</c:v>
                </c:pt>
                <c:pt idx="142">
                  <c:v>38.013117875310698</c:v>
                </c:pt>
                <c:pt idx="143">
                  <c:v>52.1830017744957</c:v>
                </c:pt>
                <c:pt idx="144">
                  <c:v>52.597014964985704</c:v>
                </c:pt>
                <c:pt idx="145">
                  <c:v>51.228540371538401</c:v>
                </c:pt>
                <c:pt idx="146">
                  <c:v>59.6015498963041</c:v>
                </c:pt>
                <c:pt idx="147">
                  <c:v>51.294137732436198</c:v>
                </c:pt>
                <c:pt idx="148">
                  <c:v>42.745771414567301</c:v>
                </c:pt>
                <c:pt idx="149">
                  <c:v>55.986942966754498</c:v>
                </c:pt>
                <c:pt idx="150">
                  <c:v>68.5858939747541</c:v>
                </c:pt>
                <c:pt idx="151">
                  <c:v>64.120231987433499</c:v>
                </c:pt>
                <c:pt idx="152">
                  <c:v>62.066579838241402</c:v>
                </c:pt>
                <c:pt idx="153">
                  <c:v>38.2099764799759</c:v>
                </c:pt>
                <c:pt idx="154">
                  <c:v>43.378614547410002</c:v>
                </c:pt>
                <c:pt idx="155">
                  <c:v>48.341167101290402</c:v>
                </c:pt>
                <c:pt idx="156">
                  <c:v>40.008305594520202</c:v>
                </c:pt>
                <c:pt idx="157">
                  <c:v>43.104513676037897</c:v>
                </c:pt>
                <c:pt idx="158">
                  <c:v>58.591407897853898</c:v>
                </c:pt>
                <c:pt idx="159">
                  <c:v>57.239472366260102</c:v>
                </c:pt>
                <c:pt idx="160">
                  <c:v>66.417619158143197</c:v>
                </c:pt>
                <c:pt idx="161">
                  <c:v>41.839510105909604</c:v>
                </c:pt>
                <c:pt idx="162">
                  <c:v>57.705600040980499</c:v>
                </c:pt>
                <c:pt idx="163">
                  <c:v>71.845330696863002</c:v>
                </c:pt>
                <c:pt idx="164">
                  <c:v>69.687445028667597</c:v>
                </c:pt>
                <c:pt idx="165">
                  <c:v>57.628070525103603</c:v>
                </c:pt>
                <c:pt idx="166">
                  <c:v>53.7801555564334</c:v>
                </c:pt>
                <c:pt idx="167">
                  <c:v>34.021865571547401</c:v>
                </c:pt>
                <c:pt idx="168">
                  <c:v>56.269201505416198</c:v>
                </c:pt>
                <c:pt idx="169">
                  <c:v>36.615026128511403</c:v>
                </c:pt>
                <c:pt idx="170">
                  <c:v>44.374492462144701</c:v>
                </c:pt>
                <c:pt idx="171">
                  <c:v>54.861530760228099</c:v>
                </c:pt>
                <c:pt idx="172">
                  <c:v>46.5924667383848</c:v>
                </c:pt>
                <c:pt idx="173">
                  <c:v>44.863214228609699</c:v>
                </c:pt>
                <c:pt idx="174">
                  <c:v>69.294002741893394</c:v>
                </c:pt>
                <c:pt idx="175">
                  <c:v>48.330419402011003</c:v>
                </c:pt>
                <c:pt idx="176">
                  <c:v>37.201799069606103</c:v>
                </c:pt>
                <c:pt idx="177">
                  <c:v>63.062625034976399</c:v>
                </c:pt>
                <c:pt idx="178">
                  <c:v>46.196775303214899</c:v>
                </c:pt>
                <c:pt idx="179">
                  <c:v>54.595542182999097</c:v>
                </c:pt>
                <c:pt idx="180">
                  <c:v>49.2358465934851</c:v>
                </c:pt>
                <c:pt idx="181">
                  <c:v>36.282900669287102</c:v>
                </c:pt>
                <c:pt idx="182">
                  <c:v>62.725846417218897</c:v>
                </c:pt>
                <c:pt idx="183">
                  <c:v>25.286174962320001</c:v>
                </c:pt>
                <c:pt idx="184">
                  <c:v>48.119021013053498</c:v>
                </c:pt>
                <c:pt idx="185">
                  <c:v>41.305029796026403</c:v>
                </c:pt>
                <c:pt idx="186">
                  <c:v>51.222140684092999</c:v>
                </c:pt>
                <c:pt idx="187">
                  <c:v>63.082843542471203</c:v>
                </c:pt>
                <c:pt idx="188">
                  <c:v>54.110998416685099</c:v>
                </c:pt>
                <c:pt idx="189">
                  <c:v>54.358045881792201</c:v>
                </c:pt>
                <c:pt idx="190">
                  <c:v>59.896159216009401</c:v>
                </c:pt>
                <c:pt idx="191">
                  <c:v>49.364997188090001</c:v>
                </c:pt>
                <c:pt idx="192">
                  <c:v>82.533111474886397</c:v>
                </c:pt>
                <c:pt idx="193">
                  <c:v>42.6963995207186</c:v>
                </c:pt>
                <c:pt idx="194">
                  <c:v>46.9318982879632</c:v>
                </c:pt>
                <c:pt idx="195">
                  <c:v>42.747116778246799</c:v>
                </c:pt>
                <c:pt idx="196">
                  <c:v>55.968275870753601</c:v>
                </c:pt>
                <c:pt idx="197">
                  <c:v>51.357750183771103</c:v>
                </c:pt>
                <c:pt idx="198">
                  <c:v>50.940698079266902</c:v>
                </c:pt>
                <c:pt idx="199">
                  <c:v>61.2426488489942</c:v>
                </c:pt>
                <c:pt idx="200">
                  <c:v>25.739404860154099</c:v>
                </c:pt>
                <c:pt idx="201">
                  <c:v>60.9526189518593</c:v>
                </c:pt>
                <c:pt idx="202">
                  <c:v>50.786478976156197</c:v>
                </c:pt>
                <c:pt idx="203">
                  <c:v>42.945633911629898</c:v>
                </c:pt>
                <c:pt idx="204">
                  <c:v>48.424983749691101</c:v>
                </c:pt>
                <c:pt idx="205">
                  <c:v>27.0795983767667</c:v>
                </c:pt>
                <c:pt idx="206">
                  <c:v>66.945208395021297</c:v>
                </c:pt>
                <c:pt idx="207">
                  <c:v>32.030996054648199</c:v>
                </c:pt>
                <c:pt idx="208">
                  <c:v>62.1833689373765</c:v>
                </c:pt>
                <c:pt idx="209">
                  <c:v>53.555277533638801</c:v>
                </c:pt>
                <c:pt idx="210">
                  <c:v>61.025117851253697</c:v>
                </c:pt>
                <c:pt idx="211">
                  <c:v>53.663313012231399</c:v>
                </c:pt>
                <c:pt idx="212">
                  <c:v>63.266373805367003</c:v>
                </c:pt>
                <c:pt idx="213">
                  <c:v>43.355905393436402</c:v>
                </c:pt>
                <c:pt idx="214">
                  <c:v>51.513445023945202</c:v>
                </c:pt>
                <c:pt idx="215">
                  <c:v>49.025746960379401</c:v>
                </c:pt>
                <c:pt idx="216">
                  <c:v>35.975434560650001</c:v>
                </c:pt>
                <c:pt idx="217">
                  <c:v>32.4970642059738</c:v>
                </c:pt>
                <c:pt idx="218">
                  <c:v>41.959738029905999</c:v>
                </c:pt>
                <c:pt idx="219">
                  <c:v>51.2277874025201</c:v>
                </c:pt>
                <c:pt idx="220">
                  <c:v>32.874929237867001</c:v>
                </c:pt>
                <c:pt idx="221">
                  <c:v>48.623699333613899</c:v>
                </c:pt>
                <c:pt idx="222">
                  <c:v>53.533519025555499</c:v>
                </c:pt>
                <c:pt idx="223">
                  <c:v>44.449269643087497</c:v>
                </c:pt>
                <c:pt idx="224">
                  <c:v>50.849719417562603</c:v>
                </c:pt>
                <c:pt idx="225">
                  <c:v>58.928301624837601</c:v>
                </c:pt>
                <c:pt idx="226">
                  <c:v>39.294943278619499</c:v>
                </c:pt>
                <c:pt idx="227">
                  <c:v>33.929453335607903</c:v>
                </c:pt>
                <c:pt idx="228">
                  <c:v>47.438050852109498</c:v>
                </c:pt>
                <c:pt idx="229">
                  <c:v>55.321545316568702</c:v>
                </c:pt>
                <c:pt idx="230">
                  <c:v>62.260278560113598</c:v>
                </c:pt>
                <c:pt idx="231">
                  <c:v>37.062101176065603</c:v>
                </c:pt>
                <c:pt idx="232">
                  <c:v>41.359821991464798</c:v>
                </c:pt>
                <c:pt idx="233">
                  <c:v>51.830368230334201</c:v>
                </c:pt>
                <c:pt idx="234">
                  <c:v>60.367057698531099</c:v>
                </c:pt>
                <c:pt idx="235">
                  <c:v>30.783667680638601</c:v>
                </c:pt>
                <c:pt idx="236">
                  <c:v>36.231173253873898</c:v>
                </c:pt>
                <c:pt idx="237">
                  <c:v>46.512719917005697</c:v>
                </c:pt>
                <c:pt idx="238">
                  <c:v>57.549866119129703</c:v>
                </c:pt>
                <c:pt idx="239">
                  <c:v>32.4983583597784</c:v>
                </c:pt>
                <c:pt idx="240">
                  <c:v>43.859049306681797</c:v>
                </c:pt>
                <c:pt idx="241">
                  <c:v>46.362084104648403</c:v>
                </c:pt>
                <c:pt idx="242">
                  <c:v>50.970601809431798</c:v>
                </c:pt>
                <c:pt idx="243">
                  <c:v>54.993363155662898</c:v>
                </c:pt>
                <c:pt idx="244">
                  <c:v>36.445739115191301</c:v>
                </c:pt>
                <c:pt idx="245">
                  <c:v>52.527213569949502</c:v>
                </c:pt>
                <c:pt idx="246">
                  <c:v>47.504516517108797</c:v>
                </c:pt>
                <c:pt idx="247">
                  <c:v>19.642799027984001</c:v>
                </c:pt>
                <c:pt idx="248">
                  <c:v>55.527124698879703</c:v>
                </c:pt>
                <c:pt idx="249">
                  <c:v>45.400957699525499</c:v>
                </c:pt>
                <c:pt idx="250">
                  <c:v>43.650952962151202</c:v>
                </c:pt>
                <c:pt idx="251">
                  <c:v>41.741460252751999</c:v>
                </c:pt>
                <c:pt idx="252">
                  <c:v>45.835141100735697</c:v>
                </c:pt>
                <c:pt idx="253">
                  <c:v>57.623130586868598</c:v>
                </c:pt>
                <c:pt idx="254">
                  <c:v>80.227205535190393</c:v>
                </c:pt>
                <c:pt idx="255">
                  <c:v>32.2910221023376</c:v>
                </c:pt>
                <c:pt idx="256">
                  <c:v>49.144646510577097</c:v>
                </c:pt>
                <c:pt idx="257">
                  <c:v>53.382074849850603</c:v>
                </c:pt>
                <c:pt idx="258">
                  <c:v>65.567685423797101</c:v>
                </c:pt>
                <c:pt idx="259">
                  <c:v>46.020502168840899</c:v>
                </c:pt>
                <c:pt idx="260">
                  <c:v>54.7613336219788</c:v>
                </c:pt>
                <c:pt idx="261">
                  <c:v>36.6812974237479</c:v>
                </c:pt>
                <c:pt idx="262">
                  <c:v>42.3206720500337</c:v>
                </c:pt>
                <c:pt idx="263">
                  <c:v>43.925047381836599</c:v>
                </c:pt>
                <c:pt idx="264">
                  <c:v>37.7859462132636</c:v>
                </c:pt>
                <c:pt idx="265">
                  <c:v>53.662456086035199</c:v>
                </c:pt>
                <c:pt idx="266">
                  <c:v>46.557322110846997</c:v>
                </c:pt>
                <c:pt idx="267">
                  <c:v>52.240147855931099</c:v>
                </c:pt>
                <c:pt idx="268">
                  <c:v>39.062826890898897</c:v>
                </c:pt>
                <c:pt idx="269">
                  <c:v>49.842999619024198</c:v>
                </c:pt>
                <c:pt idx="270">
                  <c:v>34.491414720439998</c:v>
                </c:pt>
                <c:pt idx="271">
                  <c:v>61.312921522282302</c:v>
                </c:pt>
                <c:pt idx="272">
                  <c:v>30.5539452250881</c:v>
                </c:pt>
                <c:pt idx="273">
                  <c:v>47.6389141568471</c:v>
                </c:pt>
                <c:pt idx="274">
                  <c:v>62.1950448361805</c:v>
                </c:pt>
                <c:pt idx="275">
                  <c:v>61.710498221314403</c:v>
                </c:pt>
                <c:pt idx="276">
                  <c:v>28.501742895187899</c:v>
                </c:pt>
                <c:pt idx="277">
                  <c:v>53.607976319671202</c:v>
                </c:pt>
                <c:pt idx="278">
                  <c:v>47.8683696575212</c:v>
                </c:pt>
                <c:pt idx="279">
                  <c:v>52.196696624883799</c:v>
                </c:pt>
                <c:pt idx="280">
                  <c:v>48.187934864054803</c:v>
                </c:pt>
                <c:pt idx="281">
                  <c:v>61.843450770241297</c:v>
                </c:pt>
                <c:pt idx="282">
                  <c:v>47.453440566848499</c:v>
                </c:pt>
                <c:pt idx="283">
                  <c:v>43.272571874250403</c:v>
                </c:pt>
                <c:pt idx="284">
                  <c:v>52.718433909246002</c:v>
                </c:pt>
                <c:pt idx="285">
                  <c:v>53.050669869240501</c:v>
                </c:pt>
                <c:pt idx="286">
                  <c:v>37.665440132271698</c:v>
                </c:pt>
                <c:pt idx="287">
                  <c:v>68.231226071423905</c:v>
                </c:pt>
                <c:pt idx="288">
                  <c:v>51.8371752561563</c:v>
                </c:pt>
                <c:pt idx="289">
                  <c:v>58.683164422586302</c:v>
                </c:pt>
                <c:pt idx="290">
                  <c:v>52.136219041930502</c:v>
                </c:pt>
                <c:pt idx="291">
                  <c:v>50.7542158979911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C3C-43B2-A87F-0B389D94F64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1129648"/>
        <c:axId val="1242913664"/>
      </c:scatterChart>
      <c:valAx>
        <c:axId val="124112964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197" b="0" i="0" u="none" strike="noStrike" kern="1200" baseline="0">
                <a:solidFill>
                  <a:schemeClr val="dk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42913664"/>
        <c:crosses val="autoZero"/>
        <c:crossBetween val="midCat"/>
      </c:valAx>
      <c:valAx>
        <c:axId val="12429136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197" b="0" i="0" u="none" strike="noStrike" kern="1200" baseline="0">
                <a:solidFill>
                  <a:schemeClr val="dk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4112964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en-US" sz="1197" b="0" i="0" u="none" strike="noStrike" kern="1200" baseline="0">
          <a:solidFill>
            <a:schemeClr val="dk1"/>
          </a:solidFill>
          <a:latin typeface="+mn-lt"/>
          <a:ea typeface="+mn-ea"/>
          <a:cs typeface="+mn-cs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en-US" sz="2000" b="0" i="0" u="none" strike="noStrike" kern="1200" spc="70" baseline="0">
                <a:solidFill>
                  <a:prstClr val="black">
                    <a:lumMod val="50000"/>
                    <a:lumOff val="50000"/>
                  </a:prst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2000" b="1" i="0" u="none" strike="noStrike" kern="1200" spc="70" baseline="0" dirty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Pod-GY</a:t>
            </a:r>
          </a:p>
        </c:rich>
      </c:tx>
      <c:layout>
        <c:manualLayout>
          <c:xMode val="edge"/>
          <c:yMode val="edge"/>
          <c:x val="0.38820822397200355"/>
          <c:y val="2.777777777777777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en-US" sz="2000" b="0" i="0" u="none" strike="noStrike" kern="1200" spc="70" baseline="0">
              <a:solidFill>
                <a:prstClr val="black">
                  <a:lumMod val="50000"/>
                  <a:lumOff val="50000"/>
                </a:prst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292RILs'!$J$1</c:f>
              <c:strCache>
                <c:ptCount val="1"/>
                <c:pt idx="0">
                  <c:v>GY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17824606299212598"/>
                  <c:y val="-0.17129629629629631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 algn="ctr" rtl="0">
                      <a:defRPr lang="en-US" sz="1197" b="0" i="0" u="none" strike="noStrike" kern="1200" baseline="0">
                        <a:solidFill>
                          <a:prstClr val="black">
                            <a:lumMod val="50000"/>
                            <a:lumOff val="50000"/>
                          </a:prst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y = 0.1288x + 14.486</a:t>
                    </a:r>
                    <a:b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</a:b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R² = 0.8149</a:t>
                    </a: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 algn="ctr" rtl="0">
                    <a:defRPr lang="en-US" sz="1197" b="0" i="0" u="none" strike="noStrike" kern="1200" baseline="0">
                      <a:solidFill>
                        <a:prstClr val="black">
                          <a:lumMod val="50000"/>
                          <a:lumOff val="50000"/>
                        </a:prst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'292RILs'!$D$2:$D$293</c:f>
              <c:numCache>
                <c:formatCode>0.00</c:formatCode>
                <c:ptCount val="292"/>
                <c:pt idx="0">
                  <c:v>316.42259999999999</c:v>
                </c:pt>
                <c:pt idx="1">
                  <c:v>222.29599999999999</c:v>
                </c:pt>
                <c:pt idx="2">
                  <c:v>181.40910000000002</c:v>
                </c:pt>
                <c:pt idx="3">
                  <c:v>431.51</c:v>
                </c:pt>
                <c:pt idx="4">
                  <c:v>288.53440000000001</c:v>
                </c:pt>
                <c:pt idx="5">
                  <c:v>366.97130000000004</c:v>
                </c:pt>
                <c:pt idx="6">
                  <c:v>271.3134</c:v>
                </c:pt>
                <c:pt idx="7">
                  <c:v>295.05779999999999</c:v>
                </c:pt>
                <c:pt idx="8">
                  <c:v>184.71030000000002</c:v>
                </c:pt>
                <c:pt idx="9">
                  <c:v>196.97290000000001</c:v>
                </c:pt>
                <c:pt idx="10">
                  <c:v>203.89490000000001</c:v>
                </c:pt>
                <c:pt idx="11">
                  <c:v>296.5994</c:v>
                </c:pt>
                <c:pt idx="12">
                  <c:v>248.2895</c:v>
                </c:pt>
                <c:pt idx="13">
                  <c:v>217.21280000000002</c:v>
                </c:pt>
                <c:pt idx="14">
                  <c:v>226.08440000000002</c:v>
                </c:pt>
                <c:pt idx="15">
                  <c:v>251.14000000000001</c:v>
                </c:pt>
                <c:pt idx="16">
                  <c:v>207.11240000000001</c:v>
                </c:pt>
                <c:pt idx="17">
                  <c:v>311.92880000000002</c:v>
                </c:pt>
                <c:pt idx="18">
                  <c:v>257.37150000000003</c:v>
                </c:pt>
                <c:pt idx="19">
                  <c:v>339.55770000000001</c:v>
                </c:pt>
                <c:pt idx="20">
                  <c:v>231.85990000000001</c:v>
                </c:pt>
                <c:pt idx="21">
                  <c:v>181.71800000000002</c:v>
                </c:pt>
                <c:pt idx="22">
                  <c:v>257.47360000000003</c:v>
                </c:pt>
                <c:pt idx="23">
                  <c:v>293.12440000000004</c:v>
                </c:pt>
                <c:pt idx="24">
                  <c:v>246.3211</c:v>
                </c:pt>
                <c:pt idx="25">
                  <c:v>46.890000000000015</c:v>
                </c:pt>
                <c:pt idx="26">
                  <c:v>222.7184</c:v>
                </c:pt>
                <c:pt idx="27">
                  <c:v>255.21850000000001</c:v>
                </c:pt>
                <c:pt idx="28">
                  <c:v>207.4622</c:v>
                </c:pt>
                <c:pt idx="29">
                  <c:v>187.59</c:v>
                </c:pt>
                <c:pt idx="30">
                  <c:v>268.16160000000002</c:v>
                </c:pt>
                <c:pt idx="31">
                  <c:v>295.39449999999999</c:v>
                </c:pt>
                <c:pt idx="32">
                  <c:v>242.70510000000002</c:v>
                </c:pt>
                <c:pt idx="33">
                  <c:v>366.07170000000002</c:v>
                </c:pt>
                <c:pt idx="34">
                  <c:v>268.77179999999998</c:v>
                </c:pt>
                <c:pt idx="35">
                  <c:v>178.9393</c:v>
                </c:pt>
                <c:pt idx="36">
                  <c:v>331.9622</c:v>
                </c:pt>
                <c:pt idx="37">
                  <c:v>334.8381</c:v>
                </c:pt>
                <c:pt idx="38">
                  <c:v>252.50030000000001</c:v>
                </c:pt>
                <c:pt idx="39">
                  <c:v>274.45300000000003</c:v>
                </c:pt>
                <c:pt idx="40">
                  <c:v>269.46080000000001</c:v>
                </c:pt>
                <c:pt idx="41">
                  <c:v>328.5437</c:v>
                </c:pt>
                <c:pt idx="42">
                  <c:v>143.27000000000001</c:v>
                </c:pt>
                <c:pt idx="43">
                  <c:v>92.640000000000015</c:v>
                </c:pt>
                <c:pt idx="44">
                  <c:v>298.12430000000001</c:v>
                </c:pt>
                <c:pt idx="45">
                  <c:v>196.93670000000003</c:v>
                </c:pt>
                <c:pt idx="46">
                  <c:v>118.08000000000001</c:v>
                </c:pt>
                <c:pt idx="47">
                  <c:v>307.1336</c:v>
                </c:pt>
                <c:pt idx="48">
                  <c:v>407.77</c:v>
                </c:pt>
                <c:pt idx="49">
                  <c:v>294.25720000000001</c:v>
                </c:pt>
                <c:pt idx="50">
                  <c:v>181.3768</c:v>
                </c:pt>
                <c:pt idx="51">
                  <c:v>161.82</c:v>
                </c:pt>
                <c:pt idx="52">
                  <c:v>431.08000000000004</c:v>
                </c:pt>
                <c:pt idx="53">
                  <c:v>283.77640000000002</c:v>
                </c:pt>
                <c:pt idx="54">
                  <c:v>283.95780000000002</c:v>
                </c:pt>
                <c:pt idx="55">
                  <c:v>339.35140000000001</c:v>
                </c:pt>
                <c:pt idx="56">
                  <c:v>289.07510000000002</c:v>
                </c:pt>
                <c:pt idx="57">
                  <c:v>255.48490000000001</c:v>
                </c:pt>
                <c:pt idx="58">
                  <c:v>271.22270000000003</c:v>
                </c:pt>
                <c:pt idx="59">
                  <c:v>135.60000000000002</c:v>
                </c:pt>
                <c:pt idx="60">
                  <c:v>421.68</c:v>
                </c:pt>
                <c:pt idx="61">
                  <c:v>271.85169999999999</c:v>
                </c:pt>
                <c:pt idx="62">
                  <c:v>229.36630000000002</c:v>
                </c:pt>
                <c:pt idx="63">
                  <c:v>133.12</c:v>
                </c:pt>
                <c:pt idx="64">
                  <c:v>353.12790000000001</c:v>
                </c:pt>
                <c:pt idx="65">
                  <c:v>260.09989999999999</c:v>
                </c:pt>
                <c:pt idx="66">
                  <c:v>180.23020000000002</c:v>
                </c:pt>
                <c:pt idx="67">
                  <c:v>190.8098</c:v>
                </c:pt>
                <c:pt idx="68">
                  <c:v>209.27340000000001</c:v>
                </c:pt>
                <c:pt idx="69">
                  <c:v>282.15949999999998</c:v>
                </c:pt>
                <c:pt idx="70">
                  <c:v>136.18</c:v>
                </c:pt>
                <c:pt idx="71">
                  <c:v>136.43</c:v>
                </c:pt>
                <c:pt idx="72">
                  <c:v>285.24110000000002</c:v>
                </c:pt>
                <c:pt idx="73">
                  <c:v>238.55690000000001</c:v>
                </c:pt>
                <c:pt idx="74">
                  <c:v>576.81999999999994</c:v>
                </c:pt>
                <c:pt idx="75">
                  <c:v>270.88400000000001</c:v>
                </c:pt>
                <c:pt idx="76">
                  <c:v>302.77570000000003</c:v>
                </c:pt>
                <c:pt idx="77">
                  <c:v>226.10860000000002</c:v>
                </c:pt>
                <c:pt idx="78">
                  <c:v>287.9402</c:v>
                </c:pt>
                <c:pt idx="79">
                  <c:v>174.19800000000001</c:v>
                </c:pt>
                <c:pt idx="80">
                  <c:v>188.46750000000003</c:v>
                </c:pt>
                <c:pt idx="81">
                  <c:v>392.32</c:v>
                </c:pt>
                <c:pt idx="82">
                  <c:v>179.49940000000001</c:v>
                </c:pt>
                <c:pt idx="83">
                  <c:v>267.18580000000003</c:v>
                </c:pt>
                <c:pt idx="84">
                  <c:v>264.89449999999999</c:v>
                </c:pt>
                <c:pt idx="85">
                  <c:v>251.40430000000001</c:v>
                </c:pt>
                <c:pt idx="86">
                  <c:v>166.60000000000002</c:v>
                </c:pt>
                <c:pt idx="87">
                  <c:v>202.5394</c:v>
                </c:pt>
                <c:pt idx="88">
                  <c:v>233.8424</c:v>
                </c:pt>
                <c:pt idx="89">
                  <c:v>148.83000000000001</c:v>
                </c:pt>
                <c:pt idx="90">
                  <c:v>342.00869999999998</c:v>
                </c:pt>
                <c:pt idx="91">
                  <c:v>231.5222</c:v>
                </c:pt>
                <c:pt idx="92">
                  <c:v>231.9572</c:v>
                </c:pt>
                <c:pt idx="93">
                  <c:v>269.39109999999999</c:v>
                </c:pt>
                <c:pt idx="94">
                  <c:v>299.32620000000003</c:v>
                </c:pt>
                <c:pt idx="95">
                  <c:v>180.14640000000003</c:v>
                </c:pt>
                <c:pt idx="96">
                  <c:v>252.79670000000002</c:v>
                </c:pt>
                <c:pt idx="97">
                  <c:v>288.60900000000004</c:v>
                </c:pt>
                <c:pt idx="98">
                  <c:v>284.66849999999999</c:v>
                </c:pt>
                <c:pt idx="99">
                  <c:v>174.08820000000003</c:v>
                </c:pt>
                <c:pt idx="100">
                  <c:v>320.51060000000001</c:v>
                </c:pt>
                <c:pt idx="101">
                  <c:v>326.55549999999999</c:v>
                </c:pt>
                <c:pt idx="102">
                  <c:v>286.18510000000003</c:v>
                </c:pt>
                <c:pt idx="103">
                  <c:v>285.47860000000003</c:v>
                </c:pt>
                <c:pt idx="104">
                  <c:v>294.7561</c:v>
                </c:pt>
                <c:pt idx="105">
                  <c:v>304.29380000000003</c:v>
                </c:pt>
                <c:pt idx="106">
                  <c:v>337.17880000000002</c:v>
                </c:pt>
                <c:pt idx="107">
                  <c:v>341.56870000000004</c:v>
                </c:pt>
                <c:pt idx="108">
                  <c:v>256.41849999999999</c:v>
                </c:pt>
                <c:pt idx="109">
                  <c:v>330.23419999999999</c:v>
                </c:pt>
                <c:pt idx="110">
                  <c:v>430.35</c:v>
                </c:pt>
                <c:pt idx="111">
                  <c:v>223.51760000000002</c:v>
                </c:pt>
                <c:pt idx="112">
                  <c:v>261.19639999999998</c:v>
                </c:pt>
                <c:pt idx="113">
                  <c:v>308.1148</c:v>
                </c:pt>
                <c:pt idx="114">
                  <c:v>217.78980000000001</c:v>
                </c:pt>
                <c:pt idx="115">
                  <c:v>356.47019999999998</c:v>
                </c:pt>
                <c:pt idx="116">
                  <c:v>251.00380000000001</c:v>
                </c:pt>
                <c:pt idx="117">
                  <c:v>171.02530000000002</c:v>
                </c:pt>
                <c:pt idx="118">
                  <c:v>239.4083</c:v>
                </c:pt>
                <c:pt idx="119">
                  <c:v>185.2319</c:v>
                </c:pt>
                <c:pt idx="120">
                  <c:v>262.45679999999999</c:v>
                </c:pt>
                <c:pt idx="121">
                  <c:v>262.46460000000002</c:v>
                </c:pt>
                <c:pt idx="122">
                  <c:v>284.84129999999999</c:v>
                </c:pt>
                <c:pt idx="123">
                  <c:v>337.80079999999998</c:v>
                </c:pt>
                <c:pt idx="124">
                  <c:v>298.154</c:v>
                </c:pt>
                <c:pt idx="125">
                  <c:v>260.48149999999998</c:v>
                </c:pt>
                <c:pt idx="126">
                  <c:v>325.74170000000004</c:v>
                </c:pt>
                <c:pt idx="127">
                  <c:v>299.11099999999999</c:v>
                </c:pt>
                <c:pt idx="128">
                  <c:v>347.77</c:v>
                </c:pt>
                <c:pt idx="129">
                  <c:v>321.97840000000002</c:v>
                </c:pt>
                <c:pt idx="130">
                  <c:v>319.79329999999999</c:v>
                </c:pt>
                <c:pt idx="131">
                  <c:v>266.98180000000002</c:v>
                </c:pt>
                <c:pt idx="132">
                  <c:v>321.71609999999998</c:v>
                </c:pt>
                <c:pt idx="133">
                  <c:v>209.47149999999999</c:v>
                </c:pt>
                <c:pt idx="134">
                  <c:v>300.79070000000002</c:v>
                </c:pt>
                <c:pt idx="135">
                  <c:v>343.52930000000003</c:v>
                </c:pt>
                <c:pt idx="136">
                  <c:v>201.5231</c:v>
                </c:pt>
                <c:pt idx="137">
                  <c:v>340.75360000000001</c:v>
                </c:pt>
                <c:pt idx="138">
                  <c:v>209.16320000000002</c:v>
                </c:pt>
                <c:pt idx="139">
                  <c:v>296.41290000000004</c:v>
                </c:pt>
                <c:pt idx="140">
                  <c:v>321.37220000000002</c:v>
                </c:pt>
                <c:pt idx="141">
                  <c:v>274.57069999999999</c:v>
                </c:pt>
                <c:pt idx="142">
                  <c:v>175.346</c:v>
                </c:pt>
                <c:pt idx="143">
                  <c:v>264.78300000000002</c:v>
                </c:pt>
                <c:pt idx="144">
                  <c:v>260.59870000000001</c:v>
                </c:pt>
                <c:pt idx="145">
                  <c:v>253.60170000000002</c:v>
                </c:pt>
                <c:pt idx="146">
                  <c:v>303.29149999999998</c:v>
                </c:pt>
                <c:pt idx="147">
                  <c:v>258.9228</c:v>
                </c:pt>
                <c:pt idx="148">
                  <c:v>241.42760000000001</c:v>
                </c:pt>
                <c:pt idx="149">
                  <c:v>368.09000000000003</c:v>
                </c:pt>
                <c:pt idx="150">
                  <c:v>366.89179999999999</c:v>
                </c:pt>
                <c:pt idx="151">
                  <c:v>353.93549999999999</c:v>
                </c:pt>
                <c:pt idx="152">
                  <c:v>355.86380000000003</c:v>
                </c:pt>
                <c:pt idx="153">
                  <c:v>231.86020000000002</c:v>
                </c:pt>
                <c:pt idx="154">
                  <c:v>203.7799</c:v>
                </c:pt>
                <c:pt idx="155">
                  <c:v>293.77590000000004</c:v>
                </c:pt>
                <c:pt idx="156">
                  <c:v>212.97310000000002</c:v>
                </c:pt>
                <c:pt idx="157">
                  <c:v>232.81870000000001</c:v>
                </c:pt>
                <c:pt idx="158">
                  <c:v>320.90230000000003</c:v>
                </c:pt>
                <c:pt idx="159">
                  <c:v>290.63139999999999</c:v>
                </c:pt>
                <c:pt idx="160">
                  <c:v>408.26</c:v>
                </c:pt>
                <c:pt idx="161">
                  <c:v>271.22630000000004</c:v>
                </c:pt>
                <c:pt idx="162">
                  <c:v>312.65300000000002</c:v>
                </c:pt>
                <c:pt idx="163">
                  <c:v>405.88</c:v>
                </c:pt>
                <c:pt idx="164">
                  <c:v>400.54</c:v>
                </c:pt>
                <c:pt idx="165">
                  <c:v>316.64170000000001</c:v>
                </c:pt>
                <c:pt idx="166">
                  <c:v>275.79390000000001</c:v>
                </c:pt>
                <c:pt idx="167">
                  <c:v>172.84690000000001</c:v>
                </c:pt>
                <c:pt idx="168">
                  <c:v>302.68959999999998</c:v>
                </c:pt>
                <c:pt idx="169">
                  <c:v>197.4092</c:v>
                </c:pt>
                <c:pt idx="170">
                  <c:v>251.93890000000002</c:v>
                </c:pt>
                <c:pt idx="171">
                  <c:v>323.54820000000001</c:v>
                </c:pt>
                <c:pt idx="172">
                  <c:v>255.85940000000002</c:v>
                </c:pt>
                <c:pt idx="173">
                  <c:v>231.06970000000001</c:v>
                </c:pt>
                <c:pt idx="174">
                  <c:v>344.79830000000004</c:v>
                </c:pt>
                <c:pt idx="175">
                  <c:v>254.62780000000001</c:v>
                </c:pt>
                <c:pt idx="176">
                  <c:v>199.07420000000002</c:v>
                </c:pt>
                <c:pt idx="177">
                  <c:v>355.21010000000001</c:v>
                </c:pt>
                <c:pt idx="178">
                  <c:v>231.96</c:v>
                </c:pt>
                <c:pt idx="179">
                  <c:v>303.45330000000001</c:v>
                </c:pt>
                <c:pt idx="180">
                  <c:v>300.11060000000003</c:v>
                </c:pt>
                <c:pt idx="181">
                  <c:v>160.18</c:v>
                </c:pt>
                <c:pt idx="182">
                  <c:v>395.64</c:v>
                </c:pt>
                <c:pt idx="183">
                  <c:v>99.920000000000016</c:v>
                </c:pt>
                <c:pt idx="184">
                  <c:v>278.64089999999999</c:v>
                </c:pt>
                <c:pt idx="185">
                  <c:v>222.4272</c:v>
                </c:pt>
                <c:pt idx="186">
                  <c:v>289.90559999999999</c:v>
                </c:pt>
                <c:pt idx="187">
                  <c:v>284.2122</c:v>
                </c:pt>
                <c:pt idx="188">
                  <c:v>307.24419999999998</c:v>
                </c:pt>
                <c:pt idx="189">
                  <c:v>376.37</c:v>
                </c:pt>
                <c:pt idx="190">
                  <c:v>346.99270000000001</c:v>
                </c:pt>
                <c:pt idx="191">
                  <c:v>294.25150000000002</c:v>
                </c:pt>
                <c:pt idx="192">
                  <c:v>455.39</c:v>
                </c:pt>
                <c:pt idx="193">
                  <c:v>201.38640000000001</c:v>
                </c:pt>
                <c:pt idx="194">
                  <c:v>237.97329999999999</c:v>
                </c:pt>
                <c:pt idx="195">
                  <c:v>222.58170000000001</c:v>
                </c:pt>
                <c:pt idx="196">
                  <c:v>319.625</c:v>
                </c:pt>
                <c:pt idx="197">
                  <c:v>235.2509</c:v>
                </c:pt>
                <c:pt idx="198">
                  <c:v>285.90340000000003</c:v>
                </c:pt>
                <c:pt idx="199">
                  <c:v>379.29</c:v>
                </c:pt>
                <c:pt idx="200">
                  <c:v>123.44</c:v>
                </c:pt>
                <c:pt idx="201">
                  <c:v>316.6823</c:v>
                </c:pt>
                <c:pt idx="202">
                  <c:v>263.21199999999999</c:v>
                </c:pt>
                <c:pt idx="203">
                  <c:v>215.17020000000002</c:v>
                </c:pt>
                <c:pt idx="204">
                  <c:v>305.15269999999998</c:v>
                </c:pt>
                <c:pt idx="205">
                  <c:v>119.65</c:v>
                </c:pt>
                <c:pt idx="206">
                  <c:v>372.95</c:v>
                </c:pt>
                <c:pt idx="207">
                  <c:v>158.21</c:v>
                </c:pt>
                <c:pt idx="208">
                  <c:v>338.28570000000002</c:v>
                </c:pt>
                <c:pt idx="209">
                  <c:v>326.041</c:v>
                </c:pt>
                <c:pt idx="210">
                  <c:v>298.24540000000002</c:v>
                </c:pt>
                <c:pt idx="211">
                  <c:v>370.19</c:v>
                </c:pt>
                <c:pt idx="212">
                  <c:v>300.71660000000003</c:v>
                </c:pt>
                <c:pt idx="213">
                  <c:v>250.9109</c:v>
                </c:pt>
                <c:pt idx="214">
                  <c:v>281.3331</c:v>
                </c:pt>
                <c:pt idx="215">
                  <c:v>274.80500000000001</c:v>
                </c:pt>
                <c:pt idx="216">
                  <c:v>184.18440000000001</c:v>
                </c:pt>
                <c:pt idx="217">
                  <c:v>148.09</c:v>
                </c:pt>
                <c:pt idx="218">
                  <c:v>172.5351</c:v>
                </c:pt>
                <c:pt idx="219">
                  <c:v>318.57240000000002</c:v>
                </c:pt>
                <c:pt idx="220">
                  <c:v>154.51</c:v>
                </c:pt>
                <c:pt idx="221">
                  <c:v>291.37869999999998</c:v>
                </c:pt>
                <c:pt idx="222">
                  <c:v>315.1474</c:v>
                </c:pt>
                <c:pt idx="223">
                  <c:v>216.80760000000001</c:v>
                </c:pt>
                <c:pt idx="224">
                  <c:v>246.4093</c:v>
                </c:pt>
                <c:pt idx="225">
                  <c:v>355.08910000000003</c:v>
                </c:pt>
                <c:pt idx="226">
                  <c:v>172.94720000000001</c:v>
                </c:pt>
                <c:pt idx="227">
                  <c:v>155.52000000000001</c:v>
                </c:pt>
                <c:pt idx="228">
                  <c:v>308.40640000000002</c:v>
                </c:pt>
                <c:pt idx="229">
                  <c:v>253.21170000000001</c:v>
                </c:pt>
                <c:pt idx="230">
                  <c:v>355.11700000000002</c:v>
                </c:pt>
                <c:pt idx="231">
                  <c:v>176.8818</c:v>
                </c:pt>
                <c:pt idx="232">
                  <c:v>224.82040000000001</c:v>
                </c:pt>
                <c:pt idx="233">
                  <c:v>252.74700000000001</c:v>
                </c:pt>
                <c:pt idx="234">
                  <c:v>258.92329999999998</c:v>
                </c:pt>
                <c:pt idx="235">
                  <c:v>135.74</c:v>
                </c:pt>
                <c:pt idx="236">
                  <c:v>213.18389999999999</c:v>
                </c:pt>
                <c:pt idx="237">
                  <c:v>210.15390000000002</c:v>
                </c:pt>
                <c:pt idx="238">
                  <c:v>329.464</c:v>
                </c:pt>
                <c:pt idx="239">
                  <c:v>162.67000000000002</c:v>
                </c:pt>
                <c:pt idx="240">
                  <c:v>272.04360000000003</c:v>
                </c:pt>
                <c:pt idx="241">
                  <c:v>249.15</c:v>
                </c:pt>
                <c:pt idx="242">
                  <c:v>283.3546</c:v>
                </c:pt>
                <c:pt idx="243">
                  <c:v>430.40999999999997</c:v>
                </c:pt>
                <c:pt idx="244">
                  <c:v>235.4308</c:v>
                </c:pt>
                <c:pt idx="245">
                  <c:v>345.0677</c:v>
                </c:pt>
                <c:pt idx="246">
                  <c:v>259.47230000000002</c:v>
                </c:pt>
                <c:pt idx="247">
                  <c:v>81.360000000000014</c:v>
                </c:pt>
                <c:pt idx="248">
                  <c:v>358.173</c:v>
                </c:pt>
                <c:pt idx="249">
                  <c:v>182.73500000000001</c:v>
                </c:pt>
                <c:pt idx="250">
                  <c:v>289.65260000000001</c:v>
                </c:pt>
                <c:pt idx="251">
                  <c:v>230.4949</c:v>
                </c:pt>
                <c:pt idx="252">
                  <c:v>233.8227</c:v>
                </c:pt>
                <c:pt idx="253">
                  <c:v>388.47</c:v>
                </c:pt>
                <c:pt idx="254">
                  <c:v>462.90999999999997</c:v>
                </c:pt>
                <c:pt idx="255">
                  <c:v>161.46</c:v>
                </c:pt>
                <c:pt idx="256">
                  <c:v>249.2345</c:v>
                </c:pt>
                <c:pt idx="257">
                  <c:v>314.69670000000002</c:v>
                </c:pt>
                <c:pt idx="258">
                  <c:v>345.19050000000004</c:v>
                </c:pt>
                <c:pt idx="259">
                  <c:v>221.06229999999999</c:v>
                </c:pt>
                <c:pt idx="260">
                  <c:v>291.06549999999999</c:v>
                </c:pt>
                <c:pt idx="261">
                  <c:v>166.94</c:v>
                </c:pt>
                <c:pt idx="262">
                  <c:v>275.09780000000001</c:v>
                </c:pt>
                <c:pt idx="263">
                  <c:v>264.42020000000002</c:v>
                </c:pt>
                <c:pt idx="264">
                  <c:v>186.42500000000001</c:v>
                </c:pt>
                <c:pt idx="265">
                  <c:v>328.0539</c:v>
                </c:pt>
                <c:pt idx="266">
                  <c:v>233.02170000000001</c:v>
                </c:pt>
                <c:pt idx="267">
                  <c:v>263.85579999999999</c:v>
                </c:pt>
                <c:pt idx="268">
                  <c:v>173.21390000000002</c:v>
                </c:pt>
                <c:pt idx="269">
                  <c:v>320.25150000000002</c:v>
                </c:pt>
                <c:pt idx="270">
                  <c:v>195.87979999999999</c:v>
                </c:pt>
                <c:pt idx="271">
                  <c:v>367.36279999999999</c:v>
                </c:pt>
                <c:pt idx="272">
                  <c:v>148.68</c:v>
                </c:pt>
                <c:pt idx="273">
                  <c:v>240.03579999999999</c:v>
                </c:pt>
                <c:pt idx="274">
                  <c:v>450.59000000000003</c:v>
                </c:pt>
                <c:pt idx="275">
                  <c:v>354.7423</c:v>
                </c:pt>
                <c:pt idx="276">
                  <c:v>133.82000000000002</c:v>
                </c:pt>
                <c:pt idx="277">
                  <c:v>345.41829999999999</c:v>
                </c:pt>
                <c:pt idx="278">
                  <c:v>254.82490000000001</c:v>
                </c:pt>
                <c:pt idx="279">
                  <c:v>342.89049999999997</c:v>
                </c:pt>
                <c:pt idx="280">
                  <c:v>223.52670000000001</c:v>
                </c:pt>
                <c:pt idx="281">
                  <c:v>373.75</c:v>
                </c:pt>
                <c:pt idx="282">
                  <c:v>289.82690000000002</c:v>
                </c:pt>
                <c:pt idx="283">
                  <c:v>269.85880000000003</c:v>
                </c:pt>
                <c:pt idx="284">
                  <c:v>256.10180000000003</c:v>
                </c:pt>
                <c:pt idx="285">
                  <c:v>254.3237</c:v>
                </c:pt>
                <c:pt idx="286">
                  <c:v>208.59270000000001</c:v>
                </c:pt>
                <c:pt idx="287">
                  <c:v>374.97</c:v>
                </c:pt>
                <c:pt idx="288">
                  <c:v>323.41129999999998</c:v>
                </c:pt>
                <c:pt idx="289">
                  <c:v>324.2747</c:v>
                </c:pt>
                <c:pt idx="290">
                  <c:v>265.51300000000003</c:v>
                </c:pt>
                <c:pt idx="291">
                  <c:v>238.75480000000002</c:v>
                </c:pt>
              </c:numCache>
            </c:numRef>
          </c:xVal>
          <c:yVal>
            <c:numRef>
              <c:f>'292RILs'!$J$2:$J$293</c:f>
              <c:numCache>
                <c:formatCode>0.00</c:formatCode>
                <c:ptCount val="292"/>
                <c:pt idx="0">
                  <c:v>51.957344674538902</c:v>
                </c:pt>
                <c:pt idx="1">
                  <c:v>42.771643100609801</c:v>
                </c:pt>
                <c:pt idx="2">
                  <c:v>36.275734582754403</c:v>
                </c:pt>
                <c:pt idx="3">
                  <c:v>62.301912168801003</c:v>
                </c:pt>
                <c:pt idx="4">
                  <c:v>43.706431614574903</c:v>
                </c:pt>
                <c:pt idx="5">
                  <c:v>56.135867366873804</c:v>
                </c:pt>
                <c:pt idx="6">
                  <c:v>51.2944565960887</c:v>
                </c:pt>
                <c:pt idx="7">
                  <c:v>53.970787103864303</c:v>
                </c:pt>
                <c:pt idx="8">
                  <c:v>40.604188915017602</c:v>
                </c:pt>
                <c:pt idx="9">
                  <c:v>40.041307834199202</c:v>
                </c:pt>
                <c:pt idx="10">
                  <c:v>43.513287681726197</c:v>
                </c:pt>
                <c:pt idx="11">
                  <c:v>52.320438525230102</c:v>
                </c:pt>
                <c:pt idx="12">
                  <c:v>44.0640446264728</c:v>
                </c:pt>
                <c:pt idx="13">
                  <c:v>44.081247203647102</c:v>
                </c:pt>
                <c:pt idx="14">
                  <c:v>52.288865921826599</c:v>
                </c:pt>
                <c:pt idx="15">
                  <c:v>46.315033124096303</c:v>
                </c:pt>
                <c:pt idx="16">
                  <c:v>39.750668300323902</c:v>
                </c:pt>
                <c:pt idx="17">
                  <c:v>53.598909553703002</c:v>
                </c:pt>
                <c:pt idx="18">
                  <c:v>52.850468621291199</c:v>
                </c:pt>
                <c:pt idx="19">
                  <c:v>53.824491255124002</c:v>
                </c:pt>
                <c:pt idx="20">
                  <c:v>46.009881115306499</c:v>
                </c:pt>
                <c:pt idx="21">
                  <c:v>36.518496356028898</c:v>
                </c:pt>
                <c:pt idx="22">
                  <c:v>41.294593337536803</c:v>
                </c:pt>
                <c:pt idx="23">
                  <c:v>45.958022477564199</c:v>
                </c:pt>
                <c:pt idx="24">
                  <c:v>47.925405991737797</c:v>
                </c:pt>
                <c:pt idx="25">
                  <c:v>11.005013147725499</c:v>
                </c:pt>
                <c:pt idx="26">
                  <c:v>43.149014657858302</c:v>
                </c:pt>
                <c:pt idx="27">
                  <c:v>53.469521150627997</c:v>
                </c:pt>
                <c:pt idx="28">
                  <c:v>40.944698749079997</c:v>
                </c:pt>
                <c:pt idx="29">
                  <c:v>32.014345066134403</c:v>
                </c:pt>
                <c:pt idx="30">
                  <c:v>51.698314560610299</c:v>
                </c:pt>
                <c:pt idx="31">
                  <c:v>49.5472115631514</c:v>
                </c:pt>
                <c:pt idx="32">
                  <c:v>45.452687935141299</c:v>
                </c:pt>
                <c:pt idx="33">
                  <c:v>56.477835898016998</c:v>
                </c:pt>
                <c:pt idx="34">
                  <c:v>57.646610273687102</c:v>
                </c:pt>
                <c:pt idx="35">
                  <c:v>35.198572115527199</c:v>
                </c:pt>
                <c:pt idx="36">
                  <c:v>54.745406828150102</c:v>
                </c:pt>
                <c:pt idx="37">
                  <c:v>58.886155693562301</c:v>
                </c:pt>
                <c:pt idx="38">
                  <c:v>57.813059728038503</c:v>
                </c:pt>
                <c:pt idx="39">
                  <c:v>45.3360657903945</c:v>
                </c:pt>
                <c:pt idx="40">
                  <c:v>49.148935289332698</c:v>
                </c:pt>
                <c:pt idx="41">
                  <c:v>55.830019836239799</c:v>
                </c:pt>
                <c:pt idx="42">
                  <c:v>35.488658441692998</c:v>
                </c:pt>
                <c:pt idx="43">
                  <c:v>22.9230942592167</c:v>
                </c:pt>
                <c:pt idx="44">
                  <c:v>50.987414970437598</c:v>
                </c:pt>
                <c:pt idx="45">
                  <c:v>37.639477014459899</c:v>
                </c:pt>
                <c:pt idx="46">
                  <c:v>26.260706683640802</c:v>
                </c:pt>
                <c:pt idx="47">
                  <c:v>65.342128094534004</c:v>
                </c:pt>
                <c:pt idx="48">
                  <c:v>57.132777307313802</c:v>
                </c:pt>
                <c:pt idx="49">
                  <c:v>52.942317860753299</c:v>
                </c:pt>
                <c:pt idx="50">
                  <c:v>36.192499055746303</c:v>
                </c:pt>
                <c:pt idx="51">
                  <c:v>35.808306822742701</c:v>
                </c:pt>
                <c:pt idx="52">
                  <c:v>65.940997210174103</c:v>
                </c:pt>
                <c:pt idx="53">
                  <c:v>55.479718011180601</c:v>
                </c:pt>
                <c:pt idx="54">
                  <c:v>52.476360151777001</c:v>
                </c:pt>
                <c:pt idx="55">
                  <c:v>60.067806928850999</c:v>
                </c:pt>
                <c:pt idx="56">
                  <c:v>48.187534194490098</c:v>
                </c:pt>
                <c:pt idx="57">
                  <c:v>55.1249011884182</c:v>
                </c:pt>
                <c:pt idx="58">
                  <c:v>55.985237010011502</c:v>
                </c:pt>
                <c:pt idx="59">
                  <c:v>27.087416721333302</c:v>
                </c:pt>
                <c:pt idx="60">
                  <c:v>68.706426638715897</c:v>
                </c:pt>
                <c:pt idx="61">
                  <c:v>46.287502298341401</c:v>
                </c:pt>
                <c:pt idx="62">
                  <c:v>45.557343681110197</c:v>
                </c:pt>
                <c:pt idx="63">
                  <c:v>26.2363858130403</c:v>
                </c:pt>
                <c:pt idx="64">
                  <c:v>55.0889600719618</c:v>
                </c:pt>
                <c:pt idx="65">
                  <c:v>52.524908477023502</c:v>
                </c:pt>
                <c:pt idx="66">
                  <c:v>37.279506690300302</c:v>
                </c:pt>
                <c:pt idx="67">
                  <c:v>37.280760875793298</c:v>
                </c:pt>
                <c:pt idx="68">
                  <c:v>36.513203740657502</c:v>
                </c:pt>
                <c:pt idx="69">
                  <c:v>51.499183753849202</c:v>
                </c:pt>
                <c:pt idx="70">
                  <c:v>29.989878195759399</c:v>
                </c:pt>
                <c:pt idx="71">
                  <c:v>30.264070948353002</c:v>
                </c:pt>
                <c:pt idx="72">
                  <c:v>44.420751026515298</c:v>
                </c:pt>
                <c:pt idx="73">
                  <c:v>41.204080758129301</c:v>
                </c:pt>
                <c:pt idx="74">
                  <c:v>91.606073652148197</c:v>
                </c:pt>
                <c:pt idx="75">
                  <c:v>51.4538919554142</c:v>
                </c:pt>
                <c:pt idx="76">
                  <c:v>52.257724782601699</c:v>
                </c:pt>
                <c:pt idx="77">
                  <c:v>41.883586558693402</c:v>
                </c:pt>
                <c:pt idx="78">
                  <c:v>55.985770233278103</c:v>
                </c:pt>
                <c:pt idx="79">
                  <c:v>34.834295964417201</c:v>
                </c:pt>
                <c:pt idx="80">
                  <c:v>36.450295257813103</c:v>
                </c:pt>
                <c:pt idx="81">
                  <c:v>60.367729123519702</c:v>
                </c:pt>
                <c:pt idx="82">
                  <c:v>32.833699196186501</c:v>
                </c:pt>
                <c:pt idx="83">
                  <c:v>55.1766964575895</c:v>
                </c:pt>
                <c:pt idx="84">
                  <c:v>60.788045673866797</c:v>
                </c:pt>
                <c:pt idx="85">
                  <c:v>44.021895952107599</c:v>
                </c:pt>
                <c:pt idx="86">
                  <c:v>39.662430744794896</c:v>
                </c:pt>
                <c:pt idx="87">
                  <c:v>42.157074676474203</c:v>
                </c:pt>
                <c:pt idx="88">
                  <c:v>43.820711719690799</c:v>
                </c:pt>
                <c:pt idx="89">
                  <c:v>33.451728178817397</c:v>
                </c:pt>
                <c:pt idx="90">
                  <c:v>57.561746528463701</c:v>
                </c:pt>
                <c:pt idx="91">
                  <c:v>51.712057837297202</c:v>
                </c:pt>
                <c:pt idx="92">
                  <c:v>43.956505956896898</c:v>
                </c:pt>
                <c:pt idx="93">
                  <c:v>51.491973636038999</c:v>
                </c:pt>
                <c:pt idx="94">
                  <c:v>51.1557460392157</c:v>
                </c:pt>
                <c:pt idx="95">
                  <c:v>41.3552172189655</c:v>
                </c:pt>
                <c:pt idx="96">
                  <c:v>55.837959642689398</c:v>
                </c:pt>
                <c:pt idx="97">
                  <c:v>53.100681114625203</c:v>
                </c:pt>
                <c:pt idx="98">
                  <c:v>48.851892450463502</c:v>
                </c:pt>
                <c:pt idx="99">
                  <c:v>47.014493453573699</c:v>
                </c:pt>
                <c:pt idx="100">
                  <c:v>57.709021870382799</c:v>
                </c:pt>
                <c:pt idx="101">
                  <c:v>50.382026362019197</c:v>
                </c:pt>
                <c:pt idx="102">
                  <c:v>54.301830040616103</c:v>
                </c:pt>
                <c:pt idx="103">
                  <c:v>53.3092043057109</c:v>
                </c:pt>
                <c:pt idx="104">
                  <c:v>57.380538514855701</c:v>
                </c:pt>
                <c:pt idx="105">
                  <c:v>50.653768749940497</c:v>
                </c:pt>
                <c:pt idx="106">
                  <c:v>58.1498290470239</c:v>
                </c:pt>
                <c:pt idx="107">
                  <c:v>55.144211539154099</c:v>
                </c:pt>
                <c:pt idx="108">
                  <c:v>47.268708965696398</c:v>
                </c:pt>
                <c:pt idx="109">
                  <c:v>60.554003979487398</c:v>
                </c:pt>
                <c:pt idx="110">
                  <c:v>58.029094726566001</c:v>
                </c:pt>
                <c:pt idx="111">
                  <c:v>46.511996841510602</c:v>
                </c:pt>
                <c:pt idx="112">
                  <c:v>53.983375533290101</c:v>
                </c:pt>
                <c:pt idx="113">
                  <c:v>55.984390680700997</c:v>
                </c:pt>
                <c:pt idx="114">
                  <c:v>38.2669073819592</c:v>
                </c:pt>
                <c:pt idx="115">
                  <c:v>62.872046583534299</c:v>
                </c:pt>
                <c:pt idx="116">
                  <c:v>47.833191000408902</c:v>
                </c:pt>
                <c:pt idx="117">
                  <c:v>35.479141377455498</c:v>
                </c:pt>
                <c:pt idx="118">
                  <c:v>38.5450316088642</c:v>
                </c:pt>
                <c:pt idx="119">
                  <c:v>36.593646739771501</c:v>
                </c:pt>
                <c:pt idx="120">
                  <c:v>50.675617729720898</c:v>
                </c:pt>
                <c:pt idx="121">
                  <c:v>47.875000223918597</c:v>
                </c:pt>
                <c:pt idx="122">
                  <c:v>46.497694145880601</c:v>
                </c:pt>
                <c:pt idx="123">
                  <c:v>67.381201316268104</c:v>
                </c:pt>
                <c:pt idx="124">
                  <c:v>50.203723995422997</c:v>
                </c:pt>
                <c:pt idx="125">
                  <c:v>50.182298367662099</c:v>
                </c:pt>
                <c:pt idx="126">
                  <c:v>51.734990809434898</c:v>
                </c:pt>
                <c:pt idx="127">
                  <c:v>59.143708578343798</c:v>
                </c:pt>
                <c:pt idx="128">
                  <c:v>68.750486625857206</c:v>
                </c:pt>
                <c:pt idx="129">
                  <c:v>59.730723265990797</c:v>
                </c:pt>
                <c:pt idx="130">
                  <c:v>64.000037661753694</c:v>
                </c:pt>
                <c:pt idx="131">
                  <c:v>52.9300700683389</c:v>
                </c:pt>
                <c:pt idx="132">
                  <c:v>54.107976589964501</c:v>
                </c:pt>
                <c:pt idx="133">
                  <c:v>43.3712740744242</c:v>
                </c:pt>
                <c:pt idx="134">
                  <c:v>62.252320503296303</c:v>
                </c:pt>
                <c:pt idx="135">
                  <c:v>59.062773152919497</c:v>
                </c:pt>
                <c:pt idx="136">
                  <c:v>41.451976885765703</c:v>
                </c:pt>
                <c:pt idx="137">
                  <c:v>52.280663841156503</c:v>
                </c:pt>
                <c:pt idx="138">
                  <c:v>38.817761873689697</c:v>
                </c:pt>
                <c:pt idx="139">
                  <c:v>49.953092689133101</c:v>
                </c:pt>
                <c:pt idx="140">
                  <c:v>50.7901054259708</c:v>
                </c:pt>
                <c:pt idx="141">
                  <c:v>46.897362993995799</c:v>
                </c:pt>
                <c:pt idx="142">
                  <c:v>38.013117875310698</c:v>
                </c:pt>
                <c:pt idx="143">
                  <c:v>52.1830017744957</c:v>
                </c:pt>
                <c:pt idx="144">
                  <c:v>52.597014964985704</c:v>
                </c:pt>
                <c:pt idx="145">
                  <c:v>51.228540371538401</c:v>
                </c:pt>
                <c:pt idx="146">
                  <c:v>59.6015498963041</c:v>
                </c:pt>
                <c:pt idx="147">
                  <c:v>51.294137732436198</c:v>
                </c:pt>
                <c:pt idx="148">
                  <c:v>42.745771414567301</c:v>
                </c:pt>
                <c:pt idx="149">
                  <c:v>55.986942966754498</c:v>
                </c:pt>
                <c:pt idx="150">
                  <c:v>68.5858939747541</c:v>
                </c:pt>
                <c:pt idx="151">
                  <c:v>64.120231987433499</c:v>
                </c:pt>
                <c:pt idx="152">
                  <c:v>62.066579838241402</c:v>
                </c:pt>
                <c:pt idx="153">
                  <c:v>38.2099764799759</c:v>
                </c:pt>
                <c:pt idx="154">
                  <c:v>43.378614547410002</c:v>
                </c:pt>
                <c:pt idx="155">
                  <c:v>48.341167101290402</c:v>
                </c:pt>
                <c:pt idx="156">
                  <c:v>40.008305594520202</c:v>
                </c:pt>
                <c:pt idx="157">
                  <c:v>43.104513676037897</c:v>
                </c:pt>
                <c:pt idx="158">
                  <c:v>58.591407897853898</c:v>
                </c:pt>
                <c:pt idx="159">
                  <c:v>57.239472366260102</c:v>
                </c:pt>
                <c:pt idx="160">
                  <c:v>66.417619158143197</c:v>
                </c:pt>
                <c:pt idx="161">
                  <c:v>41.839510105909604</c:v>
                </c:pt>
                <c:pt idx="162">
                  <c:v>57.705600040980499</c:v>
                </c:pt>
                <c:pt idx="163">
                  <c:v>71.845330696863002</c:v>
                </c:pt>
                <c:pt idx="164">
                  <c:v>69.687445028667597</c:v>
                </c:pt>
                <c:pt idx="165">
                  <c:v>57.628070525103603</c:v>
                </c:pt>
                <c:pt idx="166">
                  <c:v>53.7801555564334</c:v>
                </c:pt>
                <c:pt idx="167">
                  <c:v>34.021865571547401</c:v>
                </c:pt>
                <c:pt idx="168">
                  <c:v>56.269201505416198</c:v>
                </c:pt>
                <c:pt idx="169">
                  <c:v>36.615026128511403</c:v>
                </c:pt>
                <c:pt idx="170">
                  <c:v>44.374492462144701</c:v>
                </c:pt>
                <c:pt idx="171">
                  <c:v>54.861530760228099</c:v>
                </c:pt>
                <c:pt idx="172">
                  <c:v>46.5924667383848</c:v>
                </c:pt>
                <c:pt idx="173">
                  <c:v>44.863214228609699</c:v>
                </c:pt>
                <c:pt idx="174">
                  <c:v>69.294002741893394</c:v>
                </c:pt>
                <c:pt idx="175">
                  <c:v>48.330419402011003</c:v>
                </c:pt>
                <c:pt idx="176">
                  <c:v>37.201799069606103</c:v>
                </c:pt>
                <c:pt idx="177">
                  <c:v>63.062625034976399</c:v>
                </c:pt>
                <c:pt idx="178">
                  <c:v>46.196775303214899</c:v>
                </c:pt>
                <c:pt idx="179">
                  <c:v>54.595542182999097</c:v>
                </c:pt>
                <c:pt idx="180">
                  <c:v>49.2358465934851</c:v>
                </c:pt>
                <c:pt idx="181">
                  <c:v>36.282900669287102</c:v>
                </c:pt>
                <c:pt idx="182">
                  <c:v>62.725846417218897</c:v>
                </c:pt>
                <c:pt idx="183">
                  <c:v>25.286174962320001</c:v>
                </c:pt>
                <c:pt idx="184">
                  <c:v>48.119021013053498</c:v>
                </c:pt>
                <c:pt idx="185">
                  <c:v>41.305029796026403</c:v>
                </c:pt>
                <c:pt idx="186">
                  <c:v>51.222140684092999</c:v>
                </c:pt>
                <c:pt idx="187">
                  <c:v>63.082843542471203</c:v>
                </c:pt>
                <c:pt idx="188">
                  <c:v>54.110998416685099</c:v>
                </c:pt>
                <c:pt idx="189">
                  <c:v>54.358045881792201</c:v>
                </c:pt>
                <c:pt idx="190">
                  <c:v>59.896159216009401</c:v>
                </c:pt>
                <c:pt idx="191">
                  <c:v>49.364997188090001</c:v>
                </c:pt>
                <c:pt idx="192">
                  <c:v>82.533111474886397</c:v>
                </c:pt>
                <c:pt idx="193">
                  <c:v>42.6963995207186</c:v>
                </c:pt>
                <c:pt idx="194">
                  <c:v>46.9318982879632</c:v>
                </c:pt>
                <c:pt idx="195">
                  <c:v>42.747116778246799</c:v>
                </c:pt>
                <c:pt idx="196">
                  <c:v>55.968275870753601</c:v>
                </c:pt>
                <c:pt idx="197">
                  <c:v>51.357750183771103</c:v>
                </c:pt>
                <c:pt idx="198">
                  <c:v>50.940698079266902</c:v>
                </c:pt>
                <c:pt idx="199">
                  <c:v>61.2426488489942</c:v>
                </c:pt>
                <c:pt idx="200">
                  <c:v>25.739404860154099</c:v>
                </c:pt>
                <c:pt idx="201">
                  <c:v>60.9526189518593</c:v>
                </c:pt>
                <c:pt idx="202">
                  <c:v>50.786478976156197</c:v>
                </c:pt>
                <c:pt idx="203">
                  <c:v>42.945633911629898</c:v>
                </c:pt>
                <c:pt idx="204">
                  <c:v>48.424983749691101</c:v>
                </c:pt>
                <c:pt idx="205">
                  <c:v>27.0795983767667</c:v>
                </c:pt>
                <c:pt idx="206">
                  <c:v>66.945208395021297</c:v>
                </c:pt>
                <c:pt idx="207">
                  <c:v>32.030996054648199</c:v>
                </c:pt>
                <c:pt idx="208">
                  <c:v>62.1833689373765</c:v>
                </c:pt>
                <c:pt idx="209">
                  <c:v>53.555277533638801</c:v>
                </c:pt>
                <c:pt idx="210">
                  <c:v>61.025117851253697</c:v>
                </c:pt>
                <c:pt idx="211">
                  <c:v>53.663313012231399</c:v>
                </c:pt>
                <c:pt idx="212">
                  <c:v>63.266373805367003</c:v>
                </c:pt>
                <c:pt idx="213">
                  <c:v>43.355905393436402</c:v>
                </c:pt>
                <c:pt idx="214">
                  <c:v>51.513445023945202</c:v>
                </c:pt>
                <c:pt idx="215">
                  <c:v>49.025746960379401</c:v>
                </c:pt>
                <c:pt idx="216">
                  <c:v>35.975434560650001</c:v>
                </c:pt>
                <c:pt idx="217">
                  <c:v>32.4970642059738</c:v>
                </c:pt>
                <c:pt idx="218">
                  <c:v>41.959738029905999</c:v>
                </c:pt>
                <c:pt idx="219">
                  <c:v>51.2277874025201</c:v>
                </c:pt>
                <c:pt idx="220">
                  <c:v>32.874929237867001</c:v>
                </c:pt>
                <c:pt idx="221">
                  <c:v>48.623699333613899</c:v>
                </c:pt>
                <c:pt idx="222">
                  <c:v>53.533519025555499</c:v>
                </c:pt>
                <c:pt idx="223">
                  <c:v>44.449269643087497</c:v>
                </c:pt>
                <c:pt idx="224">
                  <c:v>50.849719417562603</c:v>
                </c:pt>
                <c:pt idx="225">
                  <c:v>58.928301624837601</c:v>
                </c:pt>
                <c:pt idx="226">
                  <c:v>39.294943278619499</c:v>
                </c:pt>
                <c:pt idx="227">
                  <c:v>33.929453335607903</c:v>
                </c:pt>
                <c:pt idx="228">
                  <c:v>47.438050852109498</c:v>
                </c:pt>
                <c:pt idx="229">
                  <c:v>55.321545316568702</c:v>
                </c:pt>
                <c:pt idx="230">
                  <c:v>62.260278560113598</c:v>
                </c:pt>
                <c:pt idx="231">
                  <c:v>37.062101176065603</c:v>
                </c:pt>
                <c:pt idx="232">
                  <c:v>41.359821991464798</c:v>
                </c:pt>
                <c:pt idx="233">
                  <c:v>51.830368230334201</c:v>
                </c:pt>
                <c:pt idx="234">
                  <c:v>60.367057698531099</c:v>
                </c:pt>
                <c:pt idx="235">
                  <c:v>30.783667680638601</c:v>
                </c:pt>
                <c:pt idx="236">
                  <c:v>36.231173253873898</c:v>
                </c:pt>
                <c:pt idx="237">
                  <c:v>46.512719917005697</c:v>
                </c:pt>
                <c:pt idx="238">
                  <c:v>57.549866119129703</c:v>
                </c:pt>
                <c:pt idx="239">
                  <c:v>32.4983583597784</c:v>
                </c:pt>
                <c:pt idx="240">
                  <c:v>43.859049306681797</c:v>
                </c:pt>
                <c:pt idx="241">
                  <c:v>46.362084104648403</c:v>
                </c:pt>
                <c:pt idx="242">
                  <c:v>50.970601809431798</c:v>
                </c:pt>
                <c:pt idx="243">
                  <c:v>54.993363155662898</c:v>
                </c:pt>
                <c:pt idx="244">
                  <c:v>36.445739115191301</c:v>
                </c:pt>
                <c:pt idx="245">
                  <c:v>52.527213569949502</c:v>
                </c:pt>
                <c:pt idx="246">
                  <c:v>47.504516517108797</c:v>
                </c:pt>
                <c:pt idx="247">
                  <c:v>19.642799027984001</c:v>
                </c:pt>
                <c:pt idx="248">
                  <c:v>55.527124698879703</c:v>
                </c:pt>
                <c:pt idx="249">
                  <c:v>45.400957699525499</c:v>
                </c:pt>
                <c:pt idx="250">
                  <c:v>43.650952962151202</c:v>
                </c:pt>
                <c:pt idx="251">
                  <c:v>41.741460252751999</c:v>
                </c:pt>
                <c:pt idx="252">
                  <c:v>45.835141100735697</c:v>
                </c:pt>
                <c:pt idx="253">
                  <c:v>57.623130586868598</c:v>
                </c:pt>
                <c:pt idx="254">
                  <c:v>80.227205535190393</c:v>
                </c:pt>
                <c:pt idx="255">
                  <c:v>32.2910221023376</c:v>
                </c:pt>
                <c:pt idx="256">
                  <c:v>49.144646510577097</c:v>
                </c:pt>
                <c:pt idx="257">
                  <c:v>53.382074849850603</c:v>
                </c:pt>
                <c:pt idx="258">
                  <c:v>65.567685423797101</c:v>
                </c:pt>
                <c:pt idx="259">
                  <c:v>46.020502168840899</c:v>
                </c:pt>
                <c:pt idx="260">
                  <c:v>54.7613336219788</c:v>
                </c:pt>
                <c:pt idx="261">
                  <c:v>36.6812974237479</c:v>
                </c:pt>
                <c:pt idx="262">
                  <c:v>42.3206720500337</c:v>
                </c:pt>
                <c:pt idx="263">
                  <c:v>43.925047381836599</c:v>
                </c:pt>
                <c:pt idx="264">
                  <c:v>37.7859462132636</c:v>
                </c:pt>
                <c:pt idx="265">
                  <c:v>53.662456086035199</c:v>
                </c:pt>
                <c:pt idx="266">
                  <c:v>46.557322110846997</c:v>
                </c:pt>
                <c:pt idx="267">
                  <c:v>52.240147855931099</c:v>
                </c:pt>
                <c:pt idx="268">
                  <c:v>39.062826890898897</c:v>
                </c:pt>
                <c:pt idx="269">
                  <c:v>49.842999619024198</c:v>
                </c:pt>
                <c:pt idx="270">
                  <c:v>34.491414720439998</c:v>
                </c:pt>
                <c:pt idx="271">
                  <c:v>61.312921522282302</c:v>
                </c:pt>
                <c:pt idx="272">
                  <c:v>30.5539452250881</c:v>
                </c:pt>
                <c:pt idx="273">
                  <c:v>47.6389141568471</c:v>
                </c:pt>
                <c:pt idx="274">
                  <c:v>62.1950448361805</c:v>
                </c:pt>
                <c:pt idx="275">
                  <c:v>61.710498221314403</c:v>
                </c:pt>
                <c:pt idx="276">
                  <c:v>28.501742895187899</c:v>
                </c:pt>
                <c:pt idx="277">
                  <c:v>53.607976319671202</c:v>
                </c:pt>
                <c:pt idx="278">
                  <c:v>47.8683696575212</c:v>
                </c:pt>
                <c:pt idx="279">
                  <c:v>52.196696624883799</c:v>
                </c:pt>
                <c:pt idx="280">
                  <c:v>48.187934864054803</c:v>
                </c:pt>
                <c:pt idx="281">
                  <c:v>61.843450770241297</c:v>
                </c:pt>
                <c:pt idx="282">
                  <c:v>47.453440566848499</c:v>
                </c:pt>
                <c:pt idx="283">
                  <c:v>43.272571874250403</c:v>
                </c:pt>
                <c:pt idx="284">
                  <c:v>52.718433909246002</c:v>
                </c:pt>
                <c:pt idx="285">
                  <c:v>53.050669869240501</c:v>
                </c:pt>
                <c:pt idx="286">
                  <c:v>37.665440132271698</c:v>
                </c:pt>
                <c:pt idx="287">
                  <c:v>68.231226071423905</c:v>
                </c:pt>
                <c:pt idx="288">
                  <c:v>51.8371752561563</c:v>
                </c:pt>
                <c:pt idx="289">
                  <c:v>58.683164422586302</c:v>
                </c:pt>
                <c:pt idx="290">
                  <c:v>52.136219041930502</c:v>
                </c:pt>
                <c:pt idx="291">
                  <c:v>50.7542158979911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E93-4934-8F76-980A8A216F5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1129648"/>
        <c:axId val="1242913664"/>
      </c:scatterChart>
      <c:valAx>
        <c:axId val="124112964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42913664"/>
        <c:crosses val="autoZero"/>
        <c:crossBetween val="midCat"/>
      </c:valAx>
      <c:valAx>
        <c:axId val="12429136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4112964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en-US" sz="2000" b="0" i="0" u="none" strike="noStrike" kern="1200" spc="70" baseline="0">
                <a:solidFill>
                  <a:prstClr val="black">
                    <a:lumMod val="50000"/>
                    <a:lumOff val="50000"/>
                  </a:prst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2000" b="1" i="0" u="none" strike="noStrike" kern="1200" spc="70" baseline="0" dirty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S-GY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en-US" sz="2000" b="0" i="0" u="none" strike="noStrike" kern="1200" spc="70" baseline="0">
              <a:solidFill>
                <a:prstClr val="black">
                  <a:lumMod val="50000"/>
                  <a:lumOff val="50000"/>
                </a:prst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292RILs'!$J$1</c:f>
              <c:strCache>
                <c:ptCount val="1"/>
                <c:pt idx="0">
                  <c:v>GY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8.0097331583552062E-2"/>
                  <c:y val="-0.22907298046077573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 algn="ctr" rtl="0">
                      <a:defRPr lang="en-US" sz="1197" b="0" i="0" u="none" strike="noStrike" kern="1200" baseline="0">
                        <a:solidFill>
                          <a:prstClr val="black">
                            <a:lumMod val="50000"/>
                            <a:lumOff val="50000"/>
                          </a:prst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y = 0.1027x + 12.45</a:t>
                    </a:r>
                    <a:b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</a:b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R² = 0.7897</a:t>
                    </a: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 algn="ctr" rtl="0">
                    <a:defRPr lang="en-US" sz="1197" b="0" i="0" u="none" strike="noStrike" kern="1200" baseline="0">
                      <a:solidFill>
                        <a:prstClr val="black">
                          <a:lumMod val="50000"/>
                          <a:lumOff val="50000"/>
                        </a:prst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'292RILs'!$E$2:$E$293</c:f>
              <c:numCache>
                <c:formatCode>0.00</c:formatCode>
                <c:ptCount val="292"/>
                <c:pt idx="0">
                  <c:v>402.07500000000005</c:v>
                </c:pt>
                <c:pt idx="1">
                  <c:v>340.77019999999999</c:v>
                </c:pt>
                <c:pt idx="2">
                  <c:v>237.98000000000002</c:v>
                </c:pt>
                <c:pt idx="3">
                  <c:v>519.83000000000004</c:v>
                </c:pt>
                <c:pt idx="4">
                  <c:v>376.53140000000002</c:v>
                </c:pt>
                <c:pt idx="5">
                  <c:v>481.63</c:v>
                </c:pt>
                <c:pt idx="6">
                  <c:v>358.947</c:v>
                </c:pt>
                <c:pt idx="7">
                  <c:v>352.71350000000001</c:v>
                </c:pt>
                <c:pt idx="8">
                  <c:v>241.28000000000003</c:v>
                </c:pt>
                <c:pt idx="9">
                  <c:v>259.63420000000002</c:v>
                </c:pt>
                <c:pt idx="10">
                  <c:v>286.22670000000005</c:v>
                </c:pt>
                <c:pt idx="11">
                  <c:v>386.71190000000001</c:v>
                </c:pt>
                <c:pt idx="12">
                  <c:v>348.8485</c:v>
                </c:pt>
                <c:pt idx="13">
                  <c:v>306.7731</c:v>
                </c:pt>
                <c:pt idx="14">
                  <c:v>316.16970000000003</c:v>
                </c:pt>
                <c:pt idx="15">
                  <c:v>382.5437</c:v>
                </c:pt>
                <c:pt idx="16">
                  <c:v>266.71680000000003</c:v>
                </c:pt>
                <c:pt idx="17">
                  <c:v>454.27820000000003</c:v>
                </c:pt>
                <c:pt idx="18">
                  <c:v>373.28570000000002</c:v>
                </c:pt>
                <c:pt idx="19">
                  <c:v>477.25</c:v>
                </c:pt>
                <c:pt idx="20">
                  <c:v>292.27850000000001</c:v>
                </c:pt>
                <c:pt idx="21">
                  <c:v>244.48000000000002</c:v>
                </c:pt>
                <c:pt idx="22">
                  <c:v>333.21039999999999</c:v>
                </c:pt>
                <c:pt idx="23">
                  <c:v>389.24189999999999</c:v>
                </c:pt>
                <c:pt idx="24">
                  <c:v>328.50749999999999</c:v>
                </c:pt>
                <c:pt idx="25">
                  <c:v>61.830000000000041</c:v>
                </c:pt>
                <c:pt idx="26">
                  <c:v>312.3691</c:v>
                </c:pt>
                <c:pt idx="27">
                  <c:v>325.23590000000002</c:v>
                </c:pt>
                <c:pt idx="28">
                  <c:v>326.6696</c:v>
                </c:pt>
                <c:pt idx="29">
                  <c:v>258.53840000000002</c:v>
                </c:pt>
                <c:pt idx="30">
                  <c:v>358.5872</c:v>
                </c:pt>
                <c:pt idx="31">
                  <c:v>372.23270000000002</c:v>
                </c:pt>
                <c:pt idx="32">
                  <c:v>368.01070000000004</c:v>
                </c:pt>
                <c:pt idx="33">
                  <c:v>538.59</c:v>
                </c:pt>
                <c:pt idx="34">
                  <c:v>371.19940000000003</c:v>
                </c:pt>
                <c:pt idx="35">
                  <c:v>233.78000000000003</c:v>
                </c:pt>
                <c:pt idx="36">
                  <c:v>390.96430000000004</c:v>
                </c:pt>
                <c:pt idx="37">
                  <c:v>433.33960000000002</c:v>
                </c:pt>
                <c:pt idx="38">
                  <c:v>388.67310000000003</c:v>
                </c:pt>
                <c:pt idx="39">
                  <c:v>390.7176</c:v>
                </c:pt>
                <c:pt idx="40">
                  <c:v>367.82690000000002</c:v>
                </c:pt>
                <c:pt idx="41">
                  <c:v>422.8777</c:v>
                </c:pt>
                <c:pt idx="42">
                  <c:v>197.20000000000002</c:v>
                </c:pt>
                <c:pt idx="43">
                  <c:v>134.74</c:v>
                </c:pt>
                <c:pt idx="44">
                  <c:v>405.2919</c:v>
                </c:pt>
                <c:pt idx="45">
                  <c:v>295.06119999999999</c:v>
                </c:pt>
                <c:pt idx="46">
                  <c:v>141.49</c:v>
                </c:pt>
                <c:pt idx="47">
                  <c:v>386.10390000000001</c:v>
                </c:pt>
                <c:pt idx="48">
                  <c:v>529.83000000000004</c:v>
                </c:pt>
                <c:pt idx="49">
                  <c:v>410.62280000000004</c:v>
                </c:pt>
                <c:pt idx="50">
                  <c:v>243.61</c:v>
                </c:pt>
                <c:pt idx="51">
                  <c:v>223.78000000000003</c:v>
                </c:pt>
                <c:pt idx="52">
                  <c:v>575.48</c:v>
                </c:pt>
                <c:pt idx="53">
                  <c:v>354.2407</c:v>
                </c:pt>
                <c:pt idx="54">
                  <c:v>372.82730000000004</c:v>
                </c:pt>
                <c:pt idx="55">
                  <c:v>398.27520000000004</c:v>
                </c:pt>
                <c:pt idx="56">
                  <c:v>362.25260000000003</c:v>
                </c:pt>
                <c:pt idx="57">
                  <c:v>370.79580000000004</c:v>
                </c:pt>
                <c:pt idx="58">
                  <c:v>364.86250000000001</c:v>
                </c:pt>
                <c:pt idx="59">
                  <c:v>180.42000000000002</c:v>
                </c:pt>
                <c:pt idx="60">
                  <c:v>518.03</c:v>
                </c:pt>
                <c:pt idx="61">
                  <c:v>333.30720000000002</c:v>
                </c:pt>
                <c:pt idx="62">
                  <c:v>307.03899999999999</c:v>
                </c:pt>
                <c:pt idx="63">
                  <c:v>160.72000000000003</c:v>
                </c:pt>
                <c:pt idx="64">
                  <c:v>455.69</c:v>
                </c:pt>
                <c:pt idx="65">
                  <c:v>345.85640000000001</c:v>
                </c:pt>
                <c:pt idx="66">
                  <c:v>247.13</c:v>
                </c:pt>
                <c:pt idx="67">
                  <c:v>269.8587</c:v>
                </c:pt>
                <c:pt idx="68">
                  <c:v>282.14280000000002</c:v>
                </c:pt>
                <c:pt idx="69">
                  <c:v>424.82920000000001</c:v>
                </c:pt>
                <c:pt idx="70">
                  <c:v>184.68</c:v>
                </c:pt>
                <c:pt idx="71">
                  <c:v>178.36</c:v>
                </c:pt>
                <c:pt idx="72">
                  <c:v>355.77210000000002</c:v>
                </c:pt>
                <c:pt idx="73">
                  <c:v>319.61810000000003</c:v>
                </c:pt>
                <c:pt idx="74">
                  <c:v>665.43000000000006</c:v>
                </c:pt>
                <c:pt idx="75">
                  <c:v>354.19120000000004</c:v>
                </c:pt>
                <c:pt idx="76">
                  <c:v>360.18830000000003</c:v>
                </c:pt>
                <c:pt idx="77">
                  <c:v>315.58210000000003</c:v>
                </c:pt>
                <c:pt idx="78">
                  <c:v>353.27960000000002</c:v>
                </c:pt>
                <c:pt idx="79">
                  <c:v>233.60000000000002</c:v>
                </c:pt>
                <c:pt idx="80">
                  <c:v>284.75319999999999</c:v>
                </c:pt>
                <c:pt idx="81">
                  <c:v>528.88</c:v>
                </c:pt>
                <c:pt idx="82">
                  <c:v>220.84</c:v>
                </c:pt>
                <c:pt idx="83">
                  <c:v>346.94319999999999</c:v>
                </c:pt>
                <c:pt idx="84">
                  <c:v>335.88470000000001</c:v>
                </c:pt>
                <c:pt idx="85">
                  <c:v>315.88589999999999</c:v>
                </c:pt>
                <c:pt idx="86">
                  <c:v>231.62</c:v>
                </c:pt>
                <c:pt idx="87">
                  <c:v>253.19</c:v>
                </c:pt>
                <c:pt idx="88">
                  <c:v>293.17110000000002</c:v>
                </c:pt>
                <c:pt idx="89">
                  <c:v>238.76000000000002</c:v>
                </c:pt>
                <c:pt idx="90">
                  <c:v>412.50990000000002</c:v>
                </c:pt>
                <c:pt idx="91">
                  <c:v>321.62520000000001</c:v>
                </c:pt>
                <c:pt idx="92">
                  <c:v>304.47030000000001</c:v>
                </c:pt>
                <c:pt idx="93">
                  <c:v>381.00170000000003</c:v>
                </c:pt>
                <c:pt idx="94">
                  <c:v>394.45750000000004</c:v>
                </c:pt>
                <c:pt idx="95">
                  <c:v>301.15320000000003</c:v>
                </c:pt>
                <c:pt idx="96">
                  <c:v>369.89570000000003</c:v>
                </c:pt>
                <c:pt idx="97">
                  <c:v>398.35300000000001</c:v>
                </c:pt>
                <c:pt idx="98">
                  <c:v>379.16079999999999</c:v>
                </c:pt>
                <c:pt idx="99">
                  <c:v>266.89890000000003</c:v>
                </c:pt>
                <c:pt idx="100">
                  <c:v>405.03700000000003</c:v>
                </c:pt>
                <c:pt idx="101">
                  <c:v>406.64260000000002</c:v>
                </c:pt>
                <c:pt idx="102">
                  <c:v>385.6087</c:v>
                </c:pt>
                <c:pt idx="103">
                  <c:v>371.72290000000004</c:v>
                </c:pt>
                <c:pt idx="104">
                  <c:v>379.4255</c:v>
                </c:pt>
                <c:pt idx="105">
                  <c:v>400.9348</c:v>
                </c:pt>
                <c:pt idx="106">
                  <c:v>436.95390000000003</c:v>
                </c:pt>
                <c:pt idx="107">
                  <c:v>439.47900000000004</c:v>
                </c:pt>
                <c:pt idx="108">
                  <c:v>336.03450000000004</c:v>
                </c:pt>
                <c:pt idx="109">
                  <c:v>446.45460000000003</c:v>
                </c:pt>
                <c:pt idx="110">
                  <c:v>501.13</c:v>
                </c:pt>
                <c:pt idx="111">
                  <c:v>296.41810000000004</c:v>
                </c:pt>
                <c:pt idx="112">
                  <c:v>329.85480000000001</c:v>
                </c:pt>
                <c:pt idx="113">
                  <c:v>450.23670000000004</c:v>
                </c:pt>
                <c:pt idx="114">
                  <c:v>291.27690000000001</c:v>
                </c:pt>
                <c:pt idx="115">
                  <c:v>469.14</c:v>
                </c:pt>
                <c:pt idx="116">
                  <c:v>353.16680000000002</c:v>
                </c:pt>
                <c:pt idx="117">
                  <c:v>217.49</c:v>
                </c:pt>
                <c:pt idx="118">
                  <c:v>304.06650000000002</c:v>
                </c:pt>
                <c:pt idx="119">
                  <c:v>232.08</c:v>
                </c:pt>
                <c:pt idx="120">
                  <c:v>300.90280000000001</c:v>
                </c:pt>
                <c:pt idx="121">
                  <c:v>355.5727</c:v>
                </c:pt>
                <c:pt idx="122">
                  <c:v>386.90219999999999</c:v>
                </c:pt>
                <c:pt idx="123">
                  <c:v>518.76</c:v>
                </c:pt>
                <c:pt idx="124">
                  <c:v>428.31479999999999</c:v>
                </c:pt>
                <c:pt idx="125">
                  <c:v>386.70690000000002</c:v>
                </c:pt>
                <c:pt idx="126">
                  <c:v>403.15270000000004</c:v>
                </c:pt>
                <c:pt idx="127">
                  <c:v>379.84829999999999</c:v>
                </c:pt>
                <c:pt idx="128">
                  <c:v>446.69280000000003</c:v>
                </c:pt>
                <c:pt idx="129">
                  <c:v>373.8725</c:v>
                </c:pt>
                <c:pt idx="130">
                  <c:v>444.26170000000002</c:v>
                </c:pt>
                <c:pt idx="131">
                  <c:v>363.13820000000004</c:v>
                </c:pt>
                <c:pt idx="132">
                  <c:v>356.64690000000002</c:v>
                </c:pt>
                <c:pt idx="133">
                  <c:v>312.46870000000001</c:v>
                </c:pt>
                <c:pt idx="134">
                  <c:v>413.7244</c:v>
                </c:pt>
                <c:pt idx="135">
                  <c:v>408.12060000000002</c:v>
                </c:pt>
                <c:pt idx="136">
                  <c:v>262.00060000000002</c:v>
                </c:pt>
                <c:pt idx="137">
                  <c:v>464.71000000000004</c:v>
                </c:pt>
                <c:pt idx="138">
                  <c:v>248.20000000000002</c:v>
                </c:pt>
                <c:pt idx="139">
                  <c:v>376.69220000000001</c:v>
                </c:pt>
                <c:pt idx="140">
                  <c:v>390.30870000000004</c:v>
                </c:pt>
                <c:pt idx="141">
                  <c:v>356.46440000000001</c:v>
                </c:pt>
                <c:pt idx="142">
                  <c:v>266.74980000000005</c:v>
                </c:pt>
                <c:pt idx="143">
                  <c:v>345.48520000000002</c:v>
                </c:pt>
                <c:pt idx="144">
                  <c:v>355.27780000000001</c:v>
                </c:pt>
                <c:pt idx="145">
                  <c:v>356.45010000000002</c:v>
                </c:pt>
                <c:pt idx="146">
                  <c:v>405.04130000000004</c:v>
                </c:pt>
                <c:pt idx="147">
                  <c:v>372.4341</c:v>
                </c:pt>
                <c:pt idx="148">
                  <c:v>321.45780000000002</c:v>
                </c:pt>
                <c:pt idx="149">
                  <c:v>469.36</c:v>
                </c:pt>
                <c:pt idx="150">
                  <c:v>469.87</c:v>
                </c:pt>
                <c:pt idx="151">
                  <c:v>473.71000000000004</c:v>
                </c:pt>
                <c:pt idx="152">
                  <c:v>461.18</c:v>
                </c:pt>
                <c:pt idx="153">
                  <c:v>326.35050000000001</c:v>
                </c:pt>
                <c:pt idx="154">
                  <c:v>281.22430000000003</c:v>
                </c:pt>
                <c:pt idx="155">
                  <c:v>344.07170000000002</c:v>
                </c:pt>
                <c:pt idx="156">
                  <c:v>269.58270000000005</c:v>
                </c:pt>
                <c:pt idx="157">
                  <c:v>342.06530000000004</c:v>
                </c:pt>
                <c:pt idx="158">
                  <c:v>440.59520000000003</c:v>
                </c:pt>
                <c:pt idx="159">
                  <c:v>356.35310000000004</c:v>
                </c:pt>
                <c:pt idx="160">
                  <c:v>547.04</c:v>
                </c:pt>
                <c:pt idx="161">
                  <c:v>350.94</c:v>
                </c:pt>
                <c:pt idx="162">
                  <c:v>403.61500000000001</c:v>
                </c:pt>
                <c:pt idx="163">
                  <c:v>508</c:v>
                </c:pt>
                <c:pt idx="164">
                  <c:v>548.93000000000006</c:v>
                </c:pt>
                <c:pt idx="165">
                  <c:v>420.26580000000001</c:v>
                </c:pt>
                <c:pt idx="166">
                  <c:v>361.15120000000002</c:v>
                </c:pt>
                <c:pt idx="167">
                  <c:v>225.12</c:v>
                </c:pt>
                <c:pt idx="168">
                  <c:v>388.26460000000003</c:v>
                </c:pt>
                <c:pt idx="169">
                  <c:v>274.60570000000001</c:v>
                </c:pt>
                <c:pt idx="170">
                  <c:v>343.4751</c:v>
                </c:pt>
                <c:pt idx="171">
                  <c:v>459.91</c:v>
                </c:pt>
                <c:pt idx="172">
                  <c:v>373.53660000000002</c:v>
                </c:pt>
                <c:pt idx="173">
                  <c:v>335.71390000000002</c:v>
                </c:pt>
                <c:pt idx="174">
                  <c:v>430.50190000000003</c:v>
                </c:pt>
                <c:pt idx="175">
                  <c:v>409.94150000000002</c:v>
                </c:pt>
                <c:pt idx="176">
                  <c:v>271.91370000000001</c:v>
                </c:pt>
                <c:pt idx="177">
                  <c:v>506.53000000000003</c:v>
                </c:pt>
                <c:pt idx="178">
                  <c:v>327</c:v>
                </c:pt>
                <c:pt idx="179">
                  <c:v>377.46280000000002</c:v>
                </c:pt>
                <c:pt idx="180">
                  <c:v>383.27570000000003</c:v>
                </c:pt>
                <c:pt idx="181">
                  <c:v>201.65</c:v>
                </c:pt>
                <c:pt idx="182">
                  <c:v>517.62</c:v>
                </c:pt>
                <c:pt idx="183">
                  <c:v>144.37</c:v>
                </c:pt>
                <c:pt idx="184">
                  <c:v>349.43819999999999</c:v>
                </c:pt>
                <c:pt idx="185">
                  <c:v>307.77969999999999</c:v>
                </c:pt>
                <c:pt idx="186">
                  <c:v>356.04689999999999</c:v>
                </c:pt>
                <c:pt idx="187">
                  <c:v>408.3614</c:v>
                </c:pt>
                <c:pt idx="188">
                  <c:v>446.54910000000001</c:v>
                </c:pt>
                <c:pt idx="189">
                  <c:v>473.90000000000003</c:v>
                </c:pt>
                <c:pt idx="190">
                  <c:v>451.08510000000001</c:v>
                </c:pt>
                <c:pt idx="191">
                  <c:v>397.34140000000002</c:v>
                </c:pt>
                <c:pt idx="192">
                  <c:v>511.27</c:v>
                </c:pt>
                <c:pt idx="193">
                  <c:v>256.59379999999999</c:v>
                </c:pt>
                <c:pt idx="194">
                  <c:v>316.32890000000003</c:v>
                </c:pt>
                <c:pt idx="195">
                  <c:v>327.82080000000002</c:v>
                </c:pt>
                <c:pt idx="196">
                  <c:v>442.13420000000002</c:v>
                </c:pt>
                <c:pt idx="197">
                  <c:v>342.33359999999999</c:v>
                </c:pt>
                <c:pt idx="198">
                  <c:v>375.34050000000002</c:v>
                </c:pt>
                <c:pt idx="199">
                  <c:v>465.6</c:v>
                </c:pt>
                <c:pt idx="200">
                  <c:v>171.10000000000002</c:v>
                </c:pt>
                <c:pt idx="201">
                  <c:v>375.8152</c:v>
                </c:pt>
                <c:pt idx="202">
                  <c:v>360.55900000000003</c:v>
                </c:pt>
                <c:pt idx="203">
                  <c:v>307.43550000000005</c:v>
                </c:pt>
                <c:pt idx="204">
                  <c:v>441.81560000000002</c:v>
                </c:pt>
                <c:pt idx="205">
                  <c:v>170.29000000000002</c:v>
                </c:pt>
                <c:pt idx="206">
                  <c:v>449.3664</c:v>
                </c:pt>
                <c:pt idx="207">
                  <c:v>199.41000000000003</c:v>
                </c:pt>
                <c:pt idx="208">
                  <c:v>435.1995</c:v>
                </c:pt>
                <c:pt idx="209">
                  <c:v>376.00080000000003</c:v>
                </c:pt>
                <c:pt idx="210">
                  <c:v>460.98</c:v>
                </c:pt>
                <c:pt idx="211">
                  <c:v>497.59000000000003</c:v>
                </c:pt>
                <c:pt idx="212">
                  <c:v>422.69510000000002</c:v>
                </c:pt>
                <c:pt idx="213">
                  <c:v>311.9144</c:v>
                </c:pt>
                <c:pt idx="214">
                  <c:v>386.73900000000003</c:v>
                </c:pt>
                <c:pt idx="215">
                  <c:v>338.53120000000001</c:v>
                </c:pt>
                <c:pt idx="216">
                  <c:v>259.63930000000005</c:v>
                </c:pt>
                <c:pt idx="217">
                  <c:v>209.4</c:v>
                </c:pt>
                <c:pt idx="218">
                  <c:v>263.30930000000001</c:v>
                </c:pt>
                <c:pt idx="219">
                  <c:v>409.42360000000002</c:v>
                </c:pt>
                <c:pt idx="220">
                  <c:v>219.23000000000002</c:v>
                </c:pt>
                <c:pt idx="221">
                  <c:v>386.54330000000004</c:v>
                </c:pt>
                <c:pt idx="222">
                  <c:v>438.97040000000004</c:v>
                </c:pt>
                <c:pt idx="223">
                  <c:v>298.1925</c:v>
                </c:pt>
                <c:pt idx="224">
                  <c:v>336.27170000000001</c:v>
                </c:pt>
                <c:pt idx="225">
                  <c:v>428.55240000000003</c:v>
                </c:pt>
                <c:pt idx="226">
                  <c:v>254.52</c:v>
                </c:pt>
                <c:pt idx="227">
                  <c:v>200.20000000000002</c:v>
                </c:pt>
                <c:pt idx="228">
                  <c:v>381.99</c:v>
                </c:pt>
                <c:pt idx="229">
                  <c:v>339.5317</c:v>
                </c:pt>
                <c:pt idx="230">
                  <c:v>428.983</c:v>
                </c:pt>
                <c:pt idx="231">
                  <c:v>274.1891</c:v>
                </c:pt>
                <c:pt idx="232">
                  <c:v>271.11930000000001</c:v>
                </c:pt>
                <c:pt idx="233">
                  <c:v>325.43</c:v>
                </c:pt>
                <c:pt idx="234">
                  <c:v>339.04130000000004</c:v>
                </c:pt>
                <c:pt idx="235">
                  <c:v>184.56</c:v>
                </c:pt>
                <c:pt idx="236">
                  <c:v>258.80810000000002</c:v>
                </c:pt>
                <c:pt idx="237">
                  <c:v>327.94640000000004</c:v>
                </c:pt>
                <c:pt idx="238">
                  <c:v>432.36369999999999</c:v>
                </c:pt>
                <c:pt idx="239">
                  <c:v>213.87</c:v>
                </c:pt>
                <c:pt idx="240">
                  <c:v>356.45660000000004</c:v>
                </c:pt>
                <c:pt idx="241">
                  <c:v>313.41560000000004</c:v>
                </c:pt>
                <c:pt idx="242">
                  <c:v>384.44810000000001</c:v>
                </c:pt>
                <c:pt idx="243">
                  <c:v>554.55999999999995</c:v>
                </c:pt>
                <c:pt idx="244">
                  <c:v>338.80260000000004</c:v>
                </c:pt>
                <c:pt idx="245">
                  <c:v>423.20640000000003</c:v>
                </c:pt>
                <c:pt idx="246">
                  <c:v>313.38630000000001</c:v>
                </c:pt>
                <c:pt idx="247">
                  <c:v>112.36000000000001</c:v>
                </c:pt>
                <c:pt idx="248">
                  <c:v>455.90000000000003</c:v>
                </c:pt>
                <c:pt idx="249">
                  <c:v>268.6653</c:v>
                </c:pt>
                <c:pt idx="250">
                  <c:v>384.82260000000002</c:v>
                </c:pt>
                <c:pt idx="251">
                  <c:v>285.07830000000001</c:v>
                </c:pt>
                <c:pt idx="252">
                  <c:v>311.1431</c:v>
                </c:pt>
                <c:pt idx="253">
                  <c:v>539.23</c:v>
                </c:pt>
                <c:pt idx="254">
                  <c:v>517.87</c:v>
                </c:pt>
                <c:pt idx="255">
                  <c:v>208.65</c:v>
                </c:pt>
                <c:pt idx="256">
                  <c:v>338.27420000000001</c:v>
                </c:pt>
                <c:pt idx="257">
                  <c:v>382.44420000000002</c:v>
                </c:pt>
                <c:pt idx="258">
                  <c:v>465.81</c:v>
                </c:pt>
                <c:pt idx="259">
                  <c:v>274.68580000000003</c:v>
                </c:pt>
                <c:pt idx="260">
                  <c:v>448.05240000000003</c:v>
                </c:pt>
                <c:pt idx="261">
                  <c:v>225.20000000000002</c:v>
                </c:pt>
                <c:pt idx="262">
                  <c:v>352.17860000000002</c:v>
                </c:pt>
                <c:pt idx="263">
                  <c:v>391.85149999999999</c:v>
                </c:pt>
                <c:pt idx="264">
                  <c:v>258.9624</c:v>
                </c:pt>
                <c:pt idx="265">
                  <c:v>399.5566</c:v>
                </c:pt>
                <c:pt idx="266">
                  <c:v>286.4511</c:v>
                </c:pt>
                <c:pt idx="267">
                  <c:v>351.42320000000001</c:v>
                </c:pt>
                <c:pt idx="268">
                  <c:v>283.06350000000003</c:v>
                </c:pt>
                <c:pt idx="269">
                  <c:v>414.84030000000001</c:v>
                </c:pt>
                <c:pt idx="270">
                  <c:v>261.4676</c:v>
                </c:pt>
                <c:pt idx="271">
                  <c:v>467.65000000000003</c:v>
                </c:pt>
                <c:pt idx="272">
                  <c:v>198.48000000000002</c:v>
                </c:pt>
                <c:pt idx="273">
                  <c:v>307.94320000000005</c:v>
                </c:pt>
                <c:pt idx="274">
                  <c:v>575.04</c:v>
                </c:pt>
                <c:pt idx="275">
                  <c:v>443.29920000000004</c:v>
                </c:pt>
                <c:pt idx="276">
                  <c:v>173.47000000000003</c:v>
                </c:pt>
                <c:pt idx="277">
                  <c:v>444.33030000000002</c:v>
                </c:pt>
                <c:pt idx="278">
                  <c:v>363.5521</c:v>
                </c:pt>
                <c:pt idx="279">
                  <c:v>428.80290000000002</c:v>
                </c:pt>
                <c:pt idx="280">
                  <c:v>295.43290000000002</c:v>
                </c:pt>
                <c:pt idx="281">
                  <c:v>494.82000000000005</c:v>
                </c:pt>
                <c:pt idx="282">
                  <c:v>418.20190000000002</c:v>
                </c:pt>
                <c:pt idx="283">
                  <c:v>375.57240000000002</c:v>
                </c:pt>
                <c:pt idx="284">
                  <c:v>393.35790000000003</c:v>
                </c:pt>
                <c:pt idx="285">
                  <c:v>328.16570000000002</c:v>
                </c:pt>
                <c:pt idx="286">
                  <c:v>288.90980000000002</c:v>
                </c:pt>
                <c:pt idx="287">
                  <c:v>465.04</c:v>
                </c:pt>
                <c:pt idx="288">
                  <c:v>445.20950000000005</c:v>
                </c:pt>
                <c:pt idx="289">
                  <c:v>451.67420000000004</c:v>
                </c:pt>
                <c:pt idx="290">
                  <c:v>379.67720000000003</c:v>
                </c:pt>
                <c:pt idx="291">
                  <c:v>344.0446</c:v>
                </c:pt>
              </c:numCache>
            </c:numRef>
          </c:xVal>
          <c:yVal>
            <c:numRef>
              <c:f>'292RILs'!$J$2:$J$293</c:f>
              <c:numCache>
                <c:formatCode>0.00</c:formatCode>
                <c:ptCount val="292"/>
                <c:pt idx="0">
                  <c:v>51.957344674538902</c:v>
                </c:pt>
                <c:pt idx="1">
                  <c:v>42.771643100609801</c:v>
                </c:pt>
                <c:pt idx="2">
                  <c:v>36.275734582754403</c:v>
                </c:pt>
                <c:pt idx="3">
                  <c:v>62.301912168801003</c:v>
                </c:pt>
                <c:pt idx="4">
                  <c:v>43.706431614574903</c:v>
                </c:pt>
                <c:pt idx="5">
                  <c:v>56.135867366873804</c:v>
                </c:pt>
                <c:pt idx="6">
                  <c:v>51.2944565960887</c:v>
                </c:pt>
                <c:pt idx="7">
                  <c:v>53.970787103864303</c:v>
                </c:pt>
                <c:pt idx="8">
                  <c:v>40.604188915017602</c:v>
                </c:pt>
                <c:pt idx="9">
                  <c:v>40.041307834199202</c:v>
                </c:pt>
                <c:pt idx="10">
                  <c:v>43.513287681726197</c:v>
                </c:pt>
                <c:pt idx="11">
                  <c:v>52.320438525230102</c:v>
                </c:pt>
                <c:pt idx="12">
                  <c:v>44.0640446264728</c:v>
                </c:pt>
                <c:pt idx="13">
                  <c:v>44.081247203647102</c:v>
                </c:pt>
                <c:pt idx="14">
                  <c:v>52.288865921826599</c:v>
                </c:pt>
                <c:pt idx="15">
                  <c:v>46.315033124096303</c:v>
                </c:pt>
                <c:pt idx="16">
                  <c:v>39.750668300323902</c:v>
                </c:pt>
                <c:pt idx="17">
                  <c:v>53.598909553703002</c:v>
                </c:pt>
                <c:pt idx="18">
                  <c:v>52.850468621291199</c:v>
                </c:pt>
                <c:pt idx="19">
                  <c:v>53.824491255124002</c:v>
                </c:pt>
                <c:pt idx="20">
                  <c:v>46.009881115306499</c:v>
                </c:pt>
                <c:pt idx="21">
                  <c:v>36.518496356028898</c:v>
                </c:pt>
                <c:pt idx="22">
                  <c:v>41.294593337536803</c:v>
                </c:pt>
                <c:pt idx="23">
                  <c:v>45.958022477564199</c:v>
                </c:pt>
                <c:pt idx="24">
                  <c:v>47.925405991737797</c:v>
                </c:pt>
                <c:pt idx="25">
                  <c:v>11.005013147725499</c:v>
                </c:pt>
                <c:pt idx="26">
                  <c:v>43.149014657858302</c:v>
                </c:pt>
                <c:pt idx="27">
                  <c:v>53.469521150627997</c:v>
                </c:pt>
                <c:pt idx="28">
                  <c:v>40.944698749079997</c:v>
                </c:pt>
                <c:pt idx="29">
                  <c:v>32.014345066134403</c:v>
                </c:pt>
                <c:pt idx="30">
                  <c:v>51.698314560610299</c:v>
                </c:pt>
                <c:pt idx="31">
                  <c:v>49.5472115631514</c:v>
                </c:pt>
                <c:pt idx="32">
                  <c:v>45.452687935141299</c:v>
                </c:pt>
                <c:pt idx="33">
                  <c:v>56.477835898016998</c:v>
                </c:pt>
                <c:pt idx="34">
                  <c:v>57.646610273687102</c:v>
                </c:pt>
                <c:pt idx="35">
                  <c:v>35.198572115527199</c:v>
                </c:pt>
                <c:pt idx="36">
                  <c:v>54.745406828150102</c:v>
                </c:pt>
                <c:pt idx="37">
                  <c:v>58.886155693562301</c:v>
                </c:pt>
                <c:pt idx="38">
                  <c:v>57.813059728038503</c:v>
                </c:pt>
                <c:pt idx="39">
                  <c:v>45.3360657903945</c:v>
                </c:pt>
                <c:pt idx="40">
                  <c:v>49.148935289332698</c:v>
                </c:pt>
                <c:pt idx="41">
                  <c:v>55.830019836239799</c:v>
                </c:pt>
                <c:pt idx="42">
                  <c:v>35.488658441692998</c:v>
                </c:pt>
                <c:pt idx="43">
                  <c:v>22.9230942592167</c:v>
                </c:pt>
                <c:pt idx="44">
                  <c:v>50.987414970437598</c:v>
                </c:pt>
                <c:pt idx="45">
                  <c:v>37.639477014459899</c:v>
                </c:pt>
                <c:pt idx="46">
                  <c:v>26.260706683640802</c:v>
                </c:pt>
                <c:pt idx="47">
                  <c:v>65.342128094534004</c:v>
                </c:pt>
                <c:pt idx="48">
                  <c:v>57.132777307313802</c:v>
                </c:pt>
                <c:pt idx="49">
                  <c:v>52.942317860753299</c:v>
                </c:pt>
                <c:pt idx="50">
                  <c:v>36.192499055746303</c:v>
                </c:pt>
                <c:pt idx="51">
                  <c:v>35.808306822742701</c:v>
                </c:pt>
                <c:pt idx="52">
                  <c:v>65.940997210174103</c:v>
                </c:pt>
                <c:pt idx="53">
                  <c:v>55.479718011180601</c:v>
                </c:pt>
                <c:pt idx="54">
                  <c:v>52.476360151777001</c:v>
                </c:pt>
                <c:pt idx="55">
                  <c:v>60.067806928850999</c:v>
                </c:pt>
                <c:pt idx="56">
                  <c:v>48.187534194490098</c:v>
                </c:pt>
                <c:pt idx="57">
                  <c:v>55.1249011884182</c:v>
                </c:pt>
                <c:pt idx="58">
                  <c:v>55.985237010011502</c:v>
                </c:pt>
                <c:pt idx="59">
                  <c:v>27.087416721333302</c:v>
                </c:pt>
                <c:pt idx="60">
                  <c:v>68.706426638715897</c:v>
                </c:pt>
                <c:pt idx="61">
                  <c:v>46.287502298341401</c:v>
                </c:pt>
                <c:pt idx="62">
                  <c:v>45.557343681110197</c:v>
                </c:pt>
                <c:pt idx="63">
                  <c:v>26.2363858130403</c:v>
                </c:pt>
                <c:pt idx="64">
                  <c:v>55.0889600719618</c:v>
                </c:pt>
                <c:pt idx="65">
                  <c:v>52.524908477023502</c:v>
                </c:pt>
                <c:pt idx="66">
                  <c:v>37.279506690300302</c:v>
                </c:pt>
                <c:pt idx="67">
                  <c:v>37.280760875793298</c:v>
                </c:pt>
                <c:pt idx="68">
                  <c:v>36.513203740657502</c:v>
                </c:pt>
                <c:pt idx="69">
                  <c:v>51.499183753849202</c:v>
                </c:pt>
                <c:pt idx="70">
                  <c:v>29.989878195759399</c:v>
                </c:pt>
                <c:pt idx="71">
                  <c:v>30.264070948353002</c:v>
                </c:pt>
                <c:pt idx="72">
                  <c:v>44.420751026515298</c:v>
                </c:pt>
                <c:pt idx="73">
                  <c:v>41.204080758129301</c:v>
                </c:pt>
                <c:pt idx="74">
                  <c:v>91.606073652148197</c:v>
                </c:pt>
                <c:pt idx="75">
                  <c:v>51.4538919554142</c:v>
                </c:pt>
                <c:pt idx="76">
                  <c:v>52.257724782601699</c:v>
                </c:pt>
                <c:pt idx="77">
                  <c:v>41.883586558693402</c:v>
                </c:pt>
                <c:pt idx="78">
                  <c:v>55.985770233278103</c:v>
                </c:pt>
                <c:pt idx="79">
                  <c:v>34.834295964417201</c:v>
                </c:pt>
                <c:pt idx="80">
                  <c:v>36.450295257813103</c:v>
                </c:pt>
                <c:pt idx="81">
                  <c:v>60.367729123519702</c:v>
                </c:pt>
                <c:pt idx="82">
                  <c:v>32.833699196186501</c:v>
                </c:pt>
                <c:pt idx="83">
                  <c:v>55.1766964575895</c:v>
                </c:pt>
                <c:pt idx="84">
                  <c:v>60.788045673866797</c:v>
                </c:pt>
                <c:pt idx="85">
                  <c:v>44.021895952107599</c:v>
                </c:pt>
                <c:pt idx="86">
                  <c:v>39.662430744794896</c:v>
                </c:pt>
                <c:pt idx="87">
                  <c:v>42.157074676474203</c:v>
                </c:pt>
                <c:pt idx="88">
                  <c:v>43.820711719690799</c:v>
                </c:pt>
                <c:pt idx="89">
                  <c:v>33.451728178817397</c:v>
                </c:pt>
                <c:pt idx="90">
                  <c:v>57.561746528463701</c:v>
                </c:pt>
                <c:pt idx="91">
                  <c:v>51.712057837297202</c:v>
                </c:pt>
                <c:pt idx="92">
                  <c:v>43.956505956896898</c:v>
                </c:pt>
                <c:pt idx="93">
                  <c:v>51.491973636038999</c:v>
                </c:pt>
                <c:pt idx="94">
                  <c:v>51.1557460392157</c:v>
                </c:pt>
                <c:pt idx="95">
                  <c:v>41.3552172189655</c:v>
                </c:pt>
                <c:pt idx="96">
                  <c:v>55.837959642689398</c:v>
                </c:pt>
                <c:pt idx="97">
                  <c:v>53.100681114625203</c:v>
                </c:pt>
                <c:pt idx="98">
                  <c:v>48.851892450463502</c:v>
                </c:pt>
                <c:pt idx="99">
                  <c:v>47.014493453573699</c:v>
                </c:pt>
                <c:pt idx="100">
                  <c:v>57.709021870382799</c:v>
                </c:pt>
                <c:pt idx="101">
                  <c:v>50.382026362019197</c:v>
                </c:pt>
                <c:pt idx="102">
                  <c:v>54.301830040616103</c:v>
                </c:pt>
                <c:pt idx="103">
                  <c:v>53.3092043057109</c:v>
                </c:pt>
                <c:pt idx="104">
                  <c:v>57.380538514855701</c:v>
                </c:pt>
                <c:pt idx="105">
                  <c:v>50.653768749940497</c:v>
                </c:pt>
                <c:pt idx="106">
                  <c:v>58.1498290470239</c:v>
                </c:pt>
                <c:pt idx="107">
                  <c:v>55.144211539154099</c:v>
                </c:pt>
                <c:pt idx="108">
                  <c:v>47.268708965696398</c:v>
                </c:pt>
                <c:pt idx="109">
                  <c:v>60.554003979487398</c:v>
                </c:pt>
                <c:pt idx="110">
                  <c:v>58.029094726566001</c:v>
                </c:pt>
                <c:pt idx="111">
                  <c:v>46.511996841510602</c:v>
                </c:pt>
                <c:pt idx="112">
                  <c:v>53.983375533290101</c:v>
                </c:pt>
                <c:pt idx="113">
                  <c:v>55.984390680700997</c:v>
                </c:pt>
                <c:pt idx="114">
                  <c:v>38.2669073819592</c:v>
                </c:pt>
                <c:pt idx="115">
                  <c:v>62.872046583534299</c:v>
                </c:pt>
                <c:pt idx="116">
                  <c:v>47.833191000408902</c:v>
                </c:pt>
                <c:pt idx="117">
                  <c:v>35.479141377455498</c:v>
                </c:pt>
                <c:pt idx="118">
                  <c:v>38.5450316088642</c:v>
                </c:pt>
                <c:pt idx="119">
                  <c:v>36.593646739771501</c:v>
                </c:pt>
                <c:pt idx="120">
                  <c:v>50.675617729720898</c:v>
                </c:pt>
                <c:pt idx="121">
                  <c:v>47.875000223918597</c:v>
                </c:pt>
                <c:pt idx="122">
                  <c:v>46.497694145880601</c:v>
                </c:pt>
                <c:pt idx="123">
                  <c:v>67.381201316268104</c:v>
                </c:pt>
                <c:pt idx="124">
                  <c:v>50.203723995422997</c:v>
                </c:pt>
                <c:pt idx="125">
                  <c:v>50.182298367662099</c:v>
                </c:pt>
                <c:pt idx="126">
                  <c:v>51.734990809434898</c:v>
                </c:pt>
                <c:pt idx="127">
                  <c:v>59.143708578343798</c:v>
                </c:pt>
                <c:pt idx="128">
                  <c:v>68.750486625857206</c:v>
                </c:pt>
                <c:pt idx="129">
                  <c:v>59.730723265990797</c:v>
                </c:pt>
                <c:pt idx="130">
                  <c:v>64.000037661753694</c:v>
                </c:pt>
                <c:pt idx="131">
                  <c:v>52.9300700683389</c:v>
                </c:pt>
                <c:pt idx="132">
                  <c:v>54.107976589964501</c:v>
                </c:pt>
                <c:pt idx="133">
                  <c:v>43.3712740744242</c:v>
                </c:pt>
                <c:pt idx="134">
                  <c:v>62.252320503296303</c:v>
                </c:pt>
                <c:pt idx="135">
                  <c:v>59.062773152919497</c:v>
                </c:pt>
                <c:pt idx="136">
                  <c:v>41.451976885765703</c:v>
                </c:pt>
                <c:pt idx="137">
                  <c:v>52.280663841156503</c:v>
                </c:pt>
                <c:pt idx="138">
                  <c:v>38.817761873689697</c:v>
                </c:pt>
                <c:pt idx="139">
                  <c:v>49.953092689133101</c:v>
                </c:pt>
                <c:pt idx="140">
                  <c:v>50.7901054259708</c:v>
                </c:pt>
                <c:pt idx="141">
                  <c:v>46.897362993995799</c:v>
                </c:pt>
                <c:pt idx="142">
                  <c:v>38.013117875310698</c:v>
                </c:pt>
                <c:pt idx="143">
                  <c:v>52.1830017744957</c:v>
                </c:pt>
                <c:pt idx="144">
                  <c:v>52.597014964985704</c:v>
                </c:pt>
                <c:pt idx="145">
                  <c:v>51.228540371538401</c:v>
                </c:pt>
                <c:pt idx="146">
                  <c:v>59.6015498963041</c:v>
                </c:pt>
                <c:pt idx="147">
                  <c:v>51.294137732436198</c:v>
                </c:pt>
                <c:pt idx="148">
                  <c:v>42.745771414567301</c:v>
                </c:pt>
                <c:pt idx="149">
                  <c:v>55.986942966754498</c:v>
                </c:pt>
                <c:pt idx="150">
                  <c:v>68.5858939747541</c:v>
                </c:pt>
                <c:pt idx="151">
                  <c:v>64.120231987433499</c:v>
                </c:pt>
                <c:pt idx="152">
                  <c:v>62.066579838241402</c:v>
                </c:pt>
                <c:pt idx="153">
                  <c:v>38.2099764799759</c:v>
                </c:pt>
                <c:pt idx="154">
                  <c:v>43.378614547410002</c:v>
                </c:pt>
                <c:pt idx="155">
                  <c:v>48.341167101290402</c:v>
                </c:pt>
                <c:pt idx="156">
                  <c:v>40.008305594520202</c:v>
                </c:pt>
                <c:pt idx="157">
                  <c:v>43.104513676037897</c:v>
                </c:pt>
                <c:pt idx="158">
                  <c:v>58.591407897853898</c:v>
                </c:pt>
                <c:pt idx="159">
                  <c:v>57.239472366260102</c:v>
                </c:pt>
                <c:pt idx="160">
                  <c:v>66.417619158143197</c:v>
                </c:pt>
                <c:pt idx="161">
                  <c:v>41.839510105909604</c:v>
                </c:pt>
                <c:pt idx="162">
                  <c:v>57.705600040980499</c:v>
                </c:pt>
                <c:pt idx="163">
                  <c:v>71.845330696863002</c:v>
                </c:pt>
                <c:pt idx="164">
                  <c:v>69.687445028667597</c:v>
                </c:pt>
                <c:pt idx="165">
                  <c:v>57.628070525103603</c:v>
                </c:pt>
                <c:pt idx="166">
                  <c:v>53.7801555564334</c:v>
                </c:pt>
                <c:pt idx="167">
                  <c:v>34.021865571547401</c:v>
                </c:pt>
                <c:pt idx="168">
                  <c:v>56.269201505416198</c:v>
                </c:pt>
                <c:pt idx="169">
                  <c:v>36.615026128511403</c:v>
                </c:pt>
                <c:pt idx="170">
                  <c:v>44.374492462144701</c:v>
                </c:pt>
                <c:pt idx="171">
                  <c:v>54.861530760228099</c:v>
                </c:pt>
                <c:pt idx="172">
                  <c:v>46.5924667383848</c:v>
                </c:pt>
                <c:pt idx="173">
                  <c:v>44.863214228609699</c:v>
                </c:pt>
                <c:pt idx="174">
                  <c:v>69.294002741893394</c:v>
                </c:pt>
                <c:pt idx="175">
                  <c:v>48.330419402011003</c:v>
                </c:pt>
                <c:pt idx="176">
                  <c:v>37.201799069606103</c:v>
                </c:pt>
                <c:pt idx="177">
                  <c:v>63.062625034976399</c:v>
                </c:pt>
                <c:pt idx="178">
                  <c:v>46.196775303214899</c:v>
                </c:pt>
                <c:pt idx="179">
                  <c:v>54.595542182999097</c:v>
                </c:pt>
                <c:pt idx="180">
                  <c:v>49.2358465934851</c:v>
                </c:pt>
                <c:pt idx="181">
                  <c:v>36.282900669287102</c:v>
                </c:pt>
                <c:pt idx="182">
                  <c:v>62.725846417218897</c:v>
                </c:pt>
                <c:pt idx="183">
                  <c:v>25.286174962320001</c:v>
                </c:pt>
                <c:pt idx="184">
                  <c:v>48.119021013053498</c:v>
                </c:pt>
                <c:pt idx="185">
                  <c:v>41.305029796026403</c:v>
                </c:pt>
                <c:pt idx="186">
                  <c:v>51.222140684092999</c:v>
                </c:pt>
                <c:pt idx="187">
                  <c:v>63.082843542471203</c:v>
                </c:pt>
                <c:pt idx="188">
                  <c:v>54.110998416685099</c:v>
                </c:pt>
                <c:pt idx="189">
                  <c:v>54.358045881792201</c:v>
                </c:pt>
                <c:pt idx="190">
                  <c:v>59.896159216009401</c:v>
                </c:pt>
                <c:pt idx="191">
                  <c:v>49.364997188090001</c:v>
                </c:pt>
                <c:pt idx="192">
                  <c:v>82.533111474886397</c:v>
                </c:pt>
                <c:pt idx="193">
                  <c:v>42.6963995207186</c:v>
                </c:pt>
                <c:pt idx="194">
                  <c:v>46.9318982879632</c:v>
                </c:pt>
                <c:pt idx="195">
                  <c:v>42.747116778246799</c:v>
                </c:pt>
                <c:pt idx="196">
                  <c:v>55.968275870753601</c:v>
                </c:pt>
                <c:pt idx="197">
                  <c:v>51.357750183771103</c:v>
                </c:pt>
                <c:pt idx="198">
                  <c:v>50.940698079266902</c:v>
                </c:pt>
                <c:pt idx="199">
                  <c:v>61.2426488489942</c:v>
                </c:pt>
                <c:pt idx="200">
                  <c:v>25.739404860154099</c:v>
                </c:pt>
                <c:pt idx="201">
                  <c:v>60.9526189518593</c:v>
                </c:pt>
                <c:pt idx="202">
                  <c:v>50.786478976156197</c:v>
                </c:pt>
                <c:pt idx="203">
                  <c:v>42.945633911629898</c:v>
                </c:pt>
                <c:pt idx="204">
                  <c:v>48.424983749691101</c:v>
                </c:pt>
                <c:pt idx="205">
                  <c:v>27.0795983767667</c:v>
                </c:pt>
                <c:pt idx="206">
                  <c:v>66.945208395021297</c:v>
                </c:pt>
                <c:pt idx="207">
                  <c:v>32.030996054648199</c:v>
                </c:pt>
                <c:pt idx="208">
                  <c:v>62.1833689373765</c:v>
                </c:pt>
                <c:pt idx="209">
                  <c:v>53.555277533638801</c:v>
                </c:pt>
                <c:pt idx="210">
                  <c:v>61.025117851253697</c:v>
                </c:pt>
                <c:pt idx="211">
                  <c:v>53.663313012231399</c:v>
                </c:pt>
                <c:pt idx="212">
                  <c:v>63.266373805367003</c:v>
                </c:pt>
                <c:pt idx="213">
                  <c:v>43.355905393436402</c:v>
                </c:pt>
                <c:pt idx="214">
                  <c:v>51.513445023945202</c:v>
                </c:pt>
                <c:pt idx="215">
                  <c:v>49.025746960379401</c:v>
                </c:pt>
                <c:pt idx="216">
                  <c:v>35.975434560650001</c:v>
                </c:pt>
                <c:pt idx="217">
                  <c:v>32.4970642059738</c:v>
                </c:pt>
                <c:pt idx="218">
                  <c:v>41.959738029905999</c:v>
                </c:pt>
                <c:pt idx="219">
                  <c:v>51.2277874025201</c:v>
                </c:pt>
                <c:pt idx="220">
                  <c:v>32.874929237867001</c:v>
                </c:pt>
                <c:pt idx="221">
                  <c:v>48.623699333613899</c:v>
                </c:pt>
                <c:pt idx="222">
                  <c:v>53.533519025555499</c:v>
                </c:pt>
                <c:pt idx="223">
                  <c:v>44.449269643087497</c:v>
                </c:pt>
                <c:pt idx="224">
                  <c:v>50.849719417562603</c:v>
                </c:pt>
                <c:pt idx="225">
                  <c:v>58.928301624837601</c:v>
                </c:pt>
                <c:pt idx="226">
                  <c:v>39.294943278619499</c:v>
                </c:pt>
                <c:pt idx="227">
                  <c:v>33.929453335607903</c:v>
                </c:pt>
                <c:pt idx="228">
                  <c:v>47.438050852109498</c:v>
                </c:pt>
                <c:pt idx="229">
                  <c:v>55.321545316568702</c:v>
                </c:pt>
                <c:pt idx="230">
                  <c:v>62.260278560113598</c:v>
                </c:pt>
                <c:pt idx="231">
                  <c:v>37.062101176065603</c:v>
                </c:pt>
                <c:pt idx="232">
                  <c:v>41.359821991464798</c:v>
                </c:pt>
                <c:pt idx="233">
                  <c:v>51.830368230334201</c:v>
                </c:pt>
                <c:pt idx="234">
                  <c:v>60.367057698531099</c:v>
                </c:pt>
                <c:pt idx="235">
                  <c:v>30.783667680638601</c:v>
                </c:pt>
                <c:pt idx="236">
                  <c:v>36.231173253873898</c:v>
                </c:pt>
                <c:pt idx="237">
                  <c:v>46.512719917005697</c:v>
                </c:pt>
                <c:pt idx="238">
                  <c:v>57.549866119129703</c:v>
                </c:pt>
                <c:pt idx="239">
                  <c:v>32.4983583597784</c:v>
                </c:pt>
                <c:pt idx="240">
                  <c:v>43.859049306681797</c:v>
                </c:pt>
                <c:pt idx="241">
                  <c:v>46.362084104648403</c:v>
                </c:pt>
                <c:pt idx="242">
                  <c:v>50.970601809431798</c:v>
                </c:pt>
                <c:pt idx="243">
                  <c:v>54.993363155662898</c:v>
                </c:pt>
                <c:pt idx="244">
                  <c:v>36.445739115191301</c:v>
                </c:pt>
                <c:pt idx="245">
                  <c:v>52.527213569949502</c:v>
                </c:pt>
                <c:pt idx="246">
                  <c:v>47.504516517108797</c:v>
                </c:pt>
                <c:pt idx="247">
                  <c:v>19.642799027984001</c:v>
                </c:pt>
                <c:pt idx="248">
                  <c:v>55.527124698879703</c:v>
                </c:pt>
                <c:pt idx="249">
                  <c:v>45.400957699525499</c:v>
                </c:pt>
                <c:pt idx="250">
                  <c:v>43.650952962151202</c:v>
                </c:pt>
                <c:pt idx="251">
                  <c:v>41.741460252751999</c:v>
                </c:pt>
                <c:pt idx="252">
                  <c:v>45.835141100735697</c:v>
                </c:pt>
                <c:pt idx="253">
                  <c:v>57.623130586868598</c:v>
                </c:pt>
                <c:pt idx="254">
                  <c:v>80.227205535190393</c:v>
                </c:pt>
                <c:pt idx="255">
                  <c:v>32.2910221023376</c:v>
                </c:pt>
                <c:pt idx="256">
                  <c:v>49.144646510577097</c:v>
                </c:pt>
                <c:pt idx="257">
                  <c:v>53.382074849850603</c:v>
                </c:pt>
                <c:pt idx="258">
                  <c:v>65.567685423797101</c:v>
                </c:pt>
                <c:pt idx="259">
                  <c:v>46.020502168840899</c:v>
                </c:pt>
                <c:pt idx="260">
                  <c:v>54.7613336219788</c:v>
                </c:pt>
                <c:pt idx="261">
                  <c:v>36.6812974237479</c:v>
                </c:pt>
                <c:pt idx="262">
                  <c:v>42.3206720500337</c:v>
                </c:pt>
                <c:pt idx="263">
                  <c:v>43.925047381836599</c:v>
                </c:pt>
                <c:pt idx="264">
                  <c:v>37.7859462132636</c:v>
                </c:pt>
                <c:pt idx="265">
                  <c:v>53.662456086035199</c:v>
                </c:pt>
                <c:pt idx="266">
                  <c:v>46.557322110846997</c:v>
                </c:pt>
                <c:pt idx="267">
                  <c:v>52.240147855931099</c:v>
                </c:pt>
                <c:pt idx="268">
                  <c:v>39.062826890898897</c:v>
                </c:pt>
                <c:pt idx="269">
                  <c:v>49.842999619024198</c:v>
                </c:pt>
                <c:pt idx="270">
                  <c:v>34.491414720439998</c:v>
                </c:pt>
                <c:pt idx="271">
                  <c:v>61.312921522282302</c:v>
                </c:pt>
                <c:pt idx="272">
                  <c:v>30.5539452250881</c:v>
                </c:pt>
                <c:pt idx="273">
                  <c:v>47.6389141568471</c:v>
                </c:pt>
                <c:pt idx="274">
                  <c:v>62.1950448361805</c:v>
                </c:pt>
                <c:pt idx="275">
                  <c:v>61.710498221314403</c:v>
                </c:pt>
                <c:pt idx="276">
                  <c:v>28.501742895187899</c:v>
                </c:pt>
                <c:pt idx="277">
                  <c:v>53.607976319671202</c:v>
                </c:pt>
                <c:pt idx="278">
                  <c:v>47.8683696575212</c:v>
                </c:pt>
                <c:pt idx="279">
                  <c:v>52.196696624883799</c:v>
                </c:pt>
                <c:pt idx="280">
                  <c:v>48.187934864054803</c:v>
                </c:pt>
                <c:pt idx="281">
                  <c:v>61.843450770241297</c:v>
                </c:pt>
                <c:pt idx="282">
                  <c:v>47.453440566848499</c:v>
                </c:pt>
                <c:pt idx="283">
                  <c:v>43.272571874250403</c:v>
                </c:pt>
                <c:pt idx="284">
                  <c:v>52.718433909246002</c:v>
                </c:pt>
                <c:pt idx="285">
                  <c:v>53.050669869240501</c:v>
                </c:pt>
                <c:pt idx="286">
                  <c:v>37.665440132271698</c:v>
                </c:pt>
                <c:pt idx="287">
                  <c:v>68.231226071423905</c:v>
                </c:pt>
                <c:pt idx="288">
                  <c:v>51.8371752561563</c:v>
                </c:pt>
                <c:pt idx="289">
                  <c:v>58.683164422586302</c:v>
                </c:pt>
                <c:pt idx="290">
                  <c:v>52.136219041930502</c:v>
                </c:pt>
                <c:pt idx="291">
                  <c:v>50.7542158979911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061-47CB-AA32-A1E69AAB8B6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1129648"/>
        <c:axId val="1242913664"/>
      </c:scatterChart>
      <c:valAx>
        <c:axId val="124112964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42913664"/>
        <c:crosses val="autoZero"/>
        <c:crossBetween val="midCat"/>
      </c:valAx>
      <c:valAx>
        <c:axId val="12429136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4112964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en-US" sz="2000" b="0" i="0" u="none" strike="noStrike" kern="1200" spc="70" baseline="0">
                <a:solidFill>
                  <a:prstClr val="black">
                    <a:lumMod val="50000"/>
                    <a:lumOff val="50000"/>
                  </a:prst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2000" b="1" i="0" u="none" strike="noStrike" kern="1200" spc="70" baseline="0" dirty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M-GY</a:t>
            </a:r>
          </a:p>
        </c:rich>
      </c:tx>
      <c:layout>
        <c:manualLayout>
          <c:xMode val="edge"/>
          <c:yMode val="edge"/>
          <c:x val="0.4018050482012358"/>
          <c:y val="3.703703703703703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en-US" sz="2000" b="0" i="0" u="none" strike="noStrike" kern="1200" spc="70" baseline="0">
              <a:solidFill>
                <a:prstClr val="black">
                  <a:lumMod val="50000"/>
                  <a:lumOff val="50000"/>
                </a:prst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292RILs'!$J$1</c:f>
              <c:strCache>
                <c:ptCount val="1"/>
                <c:pt idx="0">
                  <c:v>GY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10450021872265967"/>
                  <c:y val="-0.32140820939049286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 algn="ctr" rtl="0">
                      <a:defRPr lang="en-US" sz="1197" b="0" i="0" u="none" strike="noStrike" kern="1200" baseline="0">
                        <a:solidFill>
                          <a:prstClr val="black">
                            <a:lumMod val="50000"/>
                            <a:lumOff val="50000"/>
                          </a:prst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y = 0.6952x - 34.206</a:t>
                    </a:r>
                    <a:b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</a:b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R² = 0.3242</a:t>
                    </a: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 algn="ctr" rtl="0">
                    <a:defRPr lang="en-US" sz="1197" b="0" i="0" u="none" strike="noStrike" kern="1200" baseline="0">
                      <a:solidFill>
                        <a:prstClr val="black">
                          <a:lumMod val="50000"/>
                          <a:lumOff val="50000"/>
                        </a:prst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'292RILs'!$G$2:$G$293</c:f>
              <c:numCache>
                <c:formatCode>0.00</c:formatCode>
                <c:ptCount val="292"/>
                <c:pt idx="0">
                  <c:v>120.09413542681</c:v>
                </c:pt>
                <c:pt idx="1">
                  <c:v>117.92930755535799</c:v>
                </c:pt>
                <c:pt idx="2">
                  <c:v>106.490336380503</c:v>
                </c:pt>
                <c:pt idx="3">
                  <c:v>124.996701706812</c:v>
                </c:pt>
                <c:pt idx="4">
                  <c:v>105.456038254936</c:v>
                </c:pt>
                <c:pt idx="5">
                  <c:v>114.686044751963</c:v>
                </c:pt>
                <c:pt idx="6">
                  <c:v>121.92703713962</c:v>
                </c:pt>
                <c:pt idx="7">
                  <c:v>121.18417124355599</c:v>
                </c:pt>
                <c:pt idx="8">
                  <c:v>115.316930553707</c:v>
                </c:pt>
                <c:pt idx="9">
                  <c:v>115.27090925595699</c:v>
                </c:pt>
                <c:pt idx="10">
                  <c:v>111.840157137886</c:v>
                </c:pt>
                <c:pt idx="11">
                  <c:v>125.864555730931</c:v>
                </c:pt>
                <c:pt idx="12">
                  <c:v>120.337011890231</c:v>
                </c:pt>
                <c:pt idx="13">
                  <c:v>127.902320554398</c:v>
                </c:pt>
                <c:pt idx="14">
                  <c:v>125.32008122652</c:v>
                </c:pt>
                <c:pt idx="15">
                  <c:v>117.387975545355</c:v>
                </c:pt>
                <c:pt idx="16">
                  <c:v>113.402348095709</c:v>
                </c:pt>
                <c:pt idx="17">
                  <c:v>117.254771201964</c:v>
                </c:pt>
                <c:pt idx="18">
                  <c:v>119.96418367091</c:v>
                </c:pt>
                <c:pt idx="19">
                  <c:v>114.80686952917</c:v>
                </c:pt>
                <c:pt idx="20">
                  <c:v>119.682679545224</c:v>
                </c:pt>
                <c:pt idx="21">
                  <c:v>115.564350111903</c:v>
                </c:pt>
                <c:pt idx="22">
                  <c:v>121.28459198064699</c:v>
                </c:pt>
                <c:pt idx="23">
                  <c:v>108.441291142295</c:v>
                </c:pt>
                <c:pt idx="24">
                  <c:v>109.93337145861101</c:v>
                </c:pt>
                <c:pt idx="25">
                  <c:v>65.384738152944806</c:v>
                </c:pt>
                <c:pt idx="26">
                  <c:v>123.487566260213</c:v>
                </c:pt>
                <c:pt idx="27">
                  <c:v>124.14528146713</c:v>
                </c:pt>
                <c:pt idx="28">
                  <c:v>114.91995001583599</c:v>
                </c:pt>
                <c:pt idx="29">
                  <c:v>113.138808773997</c:v>
                </c:pt>
                <c:pt idx="30">
                  <c:v>114.00811674891099</c:v>
                </c:pt>
                <c:pt idx="31">
                  <c:v>114.857295829197</c:v>
                </c:pt>
                <c:pt idx="32">
                  <c:v>120.96359372085401</c:v>
                </c:pt>
                <c:pt idx="33">
                  <c:v>111.89253892897599</c:v>
                </c:pt>
                <c:pt idx="34">
                  <c:v>121.117237956403</c:v>
                </c:pt>
                <c:pt idx="35">
                  <c:v>119.704311563467</c:v>
                </c:pt>
                <c:pt idx="36">
                  <c:v>116.25627805467499</c:v>
                </c:pt>
                <c:pt idx="37">
                  <c:v>138.402875137519</c:v>
                </c:pt>
                <c:pt idx="38">
                  <c:v>127.498178464332</c:v>
                </c:pt>
                <c:pt idx="39">
                  <c:v>111.956685984388</c:v>
                </c:pt>
                <c:pt idx="40">
                  <c:v>130.17161885176799</c:v>
                </c:pt>
                <c:pt idx="41">
                  <c:v>127.423559161691</c:v>
                </c:pt>
                <c:pt idx="42">
                  <c:v>112.57948399832</c:v>
                </c:pt>
                <c:pt idx="43">
                  <c:v>116.72508215578</c:v>
                </c:pt>
                <c:pt idx="44">
                  <c:v>118.539484442998</c:v>
                </c:pt>
                <c:pt idx="45">
                  <c:v>122.00975552804501</c:v>
                </c:pt>
                <c:pt idx="46">
                  <c:v>117.857333186924</c:v>
                </c:pt>
                <c:pt idx="47">
                  <c:v>131.66191434001399</c:v>
                </c:pt>
                <c:pt idx="48">
                  <c:v>121.89988519892199</c:v>
                </c:pt>
                <c:pt idx="49">
                  <c:v>116.360134261439</c:v>
                </c:pt>
                <c:pt idx="50">
                  <c:v>112.837502364245</c:v>
                </c:pt>
                <c:pt idx="51">
                  <c:v>117.194763249373</c:v>
                </c:pt>
                <c:pt idx="52">
                  <c:v>122.03165456598001</c:v>
                </c:pt>
                <c:pt idx="53">
                  <c:v>116.55064435234701</c:v>
                </c:pt>
                <c:pt idx="54">
                  <c:v>112.892621336975</c:v>
                </c:pt>
                <c:pt idx="55">
                  <c:v>135.00215067339801</c:v>
                </c:pt>
                <c:pt idx="56">
                  <c:v>117.13578784478401</c:v>
                </c:pt>
                <c:pt idx="57">
                  <c:v>128.755348646567</c:v>
                </c:pt>
                <c:pt idx="58">
                  <c:v>126.11599691794299</c:v>
                </c:pt>
                <c:pt idx="59">
                  <c:v>101.32908520452401</c:v>
                </c:pt>
                <c:pt idx="60">
                  <c:v>134.67284423271099</c:v>
                </c:pt>
                <c:pt idx="61">
                  <c:v>115.96350763607499</c:v>
                </c:pt>
                <c:pt idx="62">
                  <c:v>111.927954551285</c:v>
                </c:pt>
                <c:pt idx="63">
                  <c:v>123.038078093351</c:v>
                </c:pt>
                <c:pt idx="64">
                  <c:v>113.121377836058</c:v>
                </c:pt>
                <c:pt idx="65">
                  <c:v>122.703677797585</c:v>
                </c:pt>
                <c:pt idx="66">
                  <c:v>108.647985497536</c:v>
                </c:pt>
                <c:pt idx="67">
                  <c:v>110.526961933823</c:v>
                </c:pt>
                <c:pt idx="68">
                  <c:v>122.47344663257201</c:v>
                </c:pt>
                <c:pt idx="69">
                  <c:v>112.74551145434</c:v>
                </c:pt>
                <c:pt idx="70">
                  <c:v>121.940416493881</c:v>
                </c:pt>
                <c:pt idx="71">
                  <c:v>126.203294068212</c:v>
                </c:pt>
                <c:pt idx="72">
                  <c:v>116.72100917917901</c:v>
                </c:pt>
                <c:pt idx="73">
                  <c:v>118.31027679281701</c:v>
                </c:pt>
                <c:pt idx="74">
                  <c:v>137.55299437042299</c:v>
                </c:pt>
                <c:pt idx="75">
                  <c:v>123.324370976472</c:v>
                </c:pt>
                <c:pt idx="76">
                  <c:v>111.916457105456</c:v>
                </c:pt>
                <c:pt idx="77">
                  <c:v>116.031342705071</c:v>
                </c:pt>
                <c:pt idx="78">
                  <c:v>138.350685838982</c:v>
                </c:pt>
                <c:pt idx="79">
                  <c:v>114.205278807545</c:v>
                </c:pt>
                <c:pt idx="80">
                  <c:v>101.53746701758899</c:v>
                </c:pt>
                <c:pt idx="81">
                  <c:v>120.413300055007</c:v>
                </c:pt>
                <c:pt idx="82">
                  <c:v>108.772205360762</c:v>
                </c:pt>
                <c:pt idx="83">
                  <c:v>123.926308461828</c:v>
                </c:pt>
                <c:pt idx="84">
                  <c:v>130.06856331528601</c:v>
                </c:pt>
                <c:pt idx="85">
                  <c:v>126.41441168040301</c:v>
                </c:pt>
                <c:pt idx="86">
                  <c:v>110.151409159133</c:v>
                </c:pt>
                <c:pt idx="87">
                  <c:v>135.37981848147601</c:v>
                </c:pt>
                <c:pt idx="88">
                  <c:v>126.851575350961</c:v>
                </c:pt>
                <c:pt idx="89">
                  <c:v>112.16507003619201</c:v>
                </c:pt>
                <c:pt idx="90">
                  <c:v>123.61801747673201</c:v>
                </c:pt>
                <c:pt idx="91">
                  <c:v>125.620177856726</c:v>
                </c:pt>
                <c:pt idx="92">
                  <c:v>129.38501016693999</c:v>
                </c:pt>
                <c:pt idx="93">
                  <c:v>119.03245256096901</c:v>
                </c:pt>
                <c:pt idx="94">
                  <c:v>123.99101591365999</c:v>
                </c:pt>
                <c:pt idx="95">
                  <c:v>122.873675294138</c:v>
                </c:pt>
                <c:pt idx="96">
                  <c:v>131.45557380244199</c:v>
                </c:pt>
                <c:pt idx="97">
                  <c:v>114.871205319114</c:v>
                </c:pt>
                <c:pt idx="98">
                  <c:v>117.56346061951</c:v>
                </c:pt>
                <c:pt idx="99">
                  <c:v>117.39562965216901</c:v>
                </c:pt>
                <c:pt idx="100">
                  <c:v>126.649942490768</c:v>
                </c:pt>
                <c:pt idx="101">
                  <c:v>112.783150410389</c:v>
                </c:pt>
                <c:pt idx="102">
                  <c:v>121.82658661051499</c:v>
                </c:pt>
                <c:pt idx="103">
                  <c:v>131.33311348782399</c:v>
                </c:pt>
                <c:pt idx="104">
                  <c:v>123.59490438761701</c:v>
                </c:pt>
                <c:pt idx="105">
                  <c:v>119.227368766288</c:v>
                </c:pt>
                <c:pt idx="106">
                  <c:v>135.232029742847</c:v>
                </c:pt>
                <c:pt idx="107">
                  <c:v>124.789784748774</c:v>
                </c:pt>
                <c:pt idx="108">
                  <c:v>112.904587038397</c:v>
                </c:pt>
                <c:pt idx="109">
                  <c:v>130.276186451651</c:v>
                </c:pt>
                <c:pt idx="110">
                  <c:v>116.485813991749</c:v>
                </c:pt>
                <c:pt idx="111">
                  <c:v>128.94237518215601</c:v>
                </c:pt>
                <c:pt idx="112">
                  <c:v>135.387477217107</c:v>
                </c:pt>
                <c:pt idx="113">
                  <c:v>121.012842320863</c:v>
                </c:pt>
                <c:pt idx="114">
                  <c:v>108.154553893474</c:v>
                </c:pt>
                <c:pt idx="115">
                  <c:v>127.64564393427</c:v>
                </c:pt>
                <c:pt idx="116">
                  <c:v>120.000271664056</c:v>
                </c:pt>
                <c:pt idx="117">
                  <c:v>122.323989064903</c:v>
                </c:pt>
                <c:pt idx="118">
                  <c:v>104.076327499927</c:v>
                </c:pt>
                <c:pt idx="119">
                  <c:v>119.858052155176</c:v>
                </c:pt>
                <c:pt idx="120">
                  <c:v>124.37443490362899</c:v>
                </c:pt>
                <c:pt idx="121">
                  <c:v>117.310888139155</c:v>
                </c:pt>
                <c:pt idx="122">
                  <c:v>110.663894183743</c:v>
                </c:pt>
                <c:pt idx="123">
                  <c:v>132.24998783389699</c:v>
                </c:pt>
                <c:pt idx="124">
                  <c:v>112.005973950431</c:v>
                </c:pt>
                <c:pt idx="125">
                  <c:v>127.226225261385</c:v>
                </c:pt>
                <c:pt idx="126">
                  <c:v>113.854773263552</c:v>
                </c:pt>
                <c:pt idx="127">
                  <c:v>119.99769565089299</c:v>
                </c:pt>
                <c:pt idx="128">
                  <c:v>124.541779601461</c:v>
                </c:pt>
                <c:pt idx="129">
                  <c:v>126.755270558389</c:v>
                </c:pt>
                <c:pt idx="130">
                  <c:v>131.080000376161</c:v>
                </c:pt>
                <c:pt idx="131">
                  <c:v>118.64211453848699</c:v>
                </c:pt>
                <c:pt idx="132">
                  <c:v>123.545962023065</c:v>
                </c:pt>
                <c:pt idx="133">
                  <c:v>122.13108538636099</c:v>
                </c:pt>
                <c:pt idx="134">
                  <c:v>132.37902283477399</c:v>
                </c:pt>
                <c:pt idx="135">
                  <c:v>123.061908496961</c:v>
                </c:pt>
                <c:pt idx="136">
                  <c:v>120.965704103193</c:v>
                </c:pt>
                <c:pt idx="137">
                  <c:v>117.419146640384</c:v>
                </c:pt>
                <c:pt idx="138">
                  <c:v>112.08424815139099</c:v>
                </c:pt>
                <c:pt idx="139">
                  <c:v>119.62460848853701</c:v>
                </c:pt>
                <c:pt idx="140">
                  <c:v>119.08775867478001</c:v>
                </c:pt>
                <c:pt idx="141">
                  <c:v>124.011776007775</c:v>
                </c:pt>
                <c:pt idx="142">
                  <c:v>119.426859670181</c:v>
                </c:pt>
                <c:pt idx="143">
                  <c:v>119.23513960826099</c:v>
                </c:pt>
                <c:pt idx="144">
                  <c:v>115.354052914451</c:v>
                </c:pt>
                <c:pt idx="145">
                  <c:v>123.011887172822</c:v>
                </c:pt>
                <c:pt idx="146">
                  <c:v>120.556531719413</c:v>
                </c:pt>
                <c:pt idx="147">
                  <c:v>123.226542872422</c:v>
                </c:pt>
                <c:pt idx="148">
                  <c:v>112.21771858198601</c:v>
                </c:pt>
                <c:pt idx="149">
                  <c:v>122.504339395991</c:v>
                </c:pt>
                <c:pt idx="150">
                  <c:v>130.09760615862501</c:v>
                </c:pt>
                <c:pt idx="151">
                  <c:v>136.09117626828899</c:v>
                </c:pt>
                <c:pt idx="152">
                  <c:v>117.18515429257801</c:v>
                </c:pt>
                <c:pt idx="153">
                  <c:v>107.95339270712201</c:v>
                </c:pt>
                <c:pt idx="154">
                  <c:v>118.274293230103</c:v>
                </c:pt>
                <c:pt idx="155">
                  <c:v>110.218731475764</c:v>
                </c:pt>
                <c:pt idx="156">
                  <c:v>122.656335375174</c:v>
                </c:pt>
                <c:pt idx="157">
                  <c:v>112.869072763171</c:v>
                </c:pt>
                <c:pt idx="158">
                  <c:v>121.937487795487</c:v>
                </c:pt>
                <c:pt idx="159">
                  <c:v>124.86669272086699</c:v>
                </c:pt>
                <c:pt idx="160">
                  <c:v>128.96294548529099</c:v>
                </c:pt>
                <c:pt idx="161">
                  <c:v>112.95205626633501</c:v>
                </c:pt>
                <c:pt idx="162">
                  <c:v>122.13592279565</c:v>
                </c:pt>
                <c:pt idx="163">
                  <c:v>128.346382859996</c:v>
                </c:pt>
                <c:pt idx="164">
                  <c:v>125.051234751667</c:v>
                </c:pt>
                <c:pt idx="165">
                  <c:v>132.36142597442901</c:v>
                </c:pt>
                <c:pt idx="166">
                  <c:v>128.11214673051199</c:v>
                </c:pt>
                <c:pt idx="167">
                  <c:v>118.186647453627</c:v>
                </c:pt>
                <c:pt idx="168">
                  <c:v>126.57054236157801</c:v>
                </c:pt>
                <c:pt idx="169">
                  <c:v>103.609900971551</c:v>
                </c:pt>
                <c:pt idx="170">
                  <c:v>114.081521575216</c:v>
                </c:pt>
                <c:pt idx="171">
                  <c:v>121.030139171502</c:v>
                </c:pt>
                <c:pt idx="172">
                  <c:v>111.98014493163799</c:v>
                </c:pt>
                <c:pt idx="173">
                  <c:v>119.123541123544</c:v>
                </c:pt>
                <c:pt idx="174">
                  <c:v>128.624584674364</c:v>
                </c:pt>
                <c:pt idx="175">
                  <c:v>119.278432145854</c:v>
                </c:pt>
                <c:pt idx="176">
                  <c:v>107.724046890441</c:v>
                </c:pt>
                <c:pt idx="177">
                  <c:v>129.594647164229</c:v>
                </c:pt>
                <c:pt idx="178">
                  <c:v>128.24230272966</c:v>
                </c:pt>
                <c:pt idx="179">
                  <c:v>121.999832765953</c:v>
                </c:pt>
                <c:pt idx="180">
                  <c:v>120.25627473828</c:v>
                </c:pt>
                <c:pt idx="181">
                  <c:v>113.48740679228</c:v>
                </c:pt>
                <c:pt idx="182">
                  <c:v>116.690449715117</c:v>
                </c:pt>
                <c:pt idx="183">
                  <c:v>109.373132345027</c:v>
                </c:pt>
                <c:pt idx="184">
                  <c:v>130.00657503135</c:v>
                </c:pt>
                <c:pt idx="185">
                  <c:v>121.56885704642499</c:v>
                </c:pt>
                <c:pt idx="186">
                  <c:v>122.83085187314001</c:v>
                </c:pt>
                <c:pt idx="187">
                  <c:v>126.124330658956</c:v>
                </c:pt>
                <c:pt idx="188">
                  <c:v>121.76086461045</c:v>
                </c:pt>
                <c:pt idx="189">
                  <c:v>114.643507886547</c:v>
                </c:pt>
                <c:pt idx="190">
                  <c:v>127.74894166369999</c:v>
                </c:pt>
                <c:pt idx="191">
                  <c:v>114.05316773960899</c:v>
                </c:pt>
                <c:pt idx="192">
                  <c:v>135.20642934844801</c:v>
                </c:pt>
                <c:pt idx="193">
                  <c:v>124.900423178019</c:v>
                </c:pt>
                <c:pt idx="194">
                  <c:v>125.602978405036</c:v>
                </c:pt>
                <c:pt idx="195">
                  <c:v>121.300123306299</c:v>
                </c:pt>
                <c:pt idx="196">
                  <c:v>116.836588266174</c:v>
                </c:pt>
                <c:pt idx="197">
                  <c:v>128.04434872642599</c:v>
                </c:pt>
                <c:pt idx="198">
                  <c:v>116.30257453118401</c:v>
                </c:pt>
                <c:pt idx="199">
                  <c:v>115.051217994401</c:v>
                </c:pt>
                <c:pt idx="200">
                  <c:v>105.15706538967601</c:v>
                </c:pt>
                <c:pt idx="201">
                  <c:v>122.839409229338</c:v>
                </c:pt>
                <c:pt idx="202">
                  <c:v>119.067511967089</c:v>
                </c:pt>
                <c:pt idx="203">
                  <c:v>130.61321579261801</c:v>
                </c:pt>
                <c:pt idx="204">
                  <c:v>104.702414237702</c:v>
                </c:pt>
                <c:pt idx="205">
                  <c:v>120.871994229028</c:v>
                </c:pt>
                <c:pt idx="206">
                  <c:v>134.30153900471899</c:v>
                </c:pt>
                <c:pt idx="207">
                  <c:v>119.28259987789301</c:v>
                </c:pt>
                <c:pt idx="208">
                  <c:v>123.84910429071201</c:v>
                </c:pt>
                <c:pt idx="209">
                  <c:v>129.47073241830401</c:v>
                </c:pt>
                <c:pt idx="210">
                  <c:v>130.20790063781399</c:v>
                </c:pt>
                <c:pt idx="211">
                  <c:v>123.560050304836</c:v>
                </c:pt>
                <c:pt idx="212">
                  <c:v>131.367686193059</c:v>
                </c:pt>
                <c:pt idx="213">
                  <c:v>111.27743193014599</c:v>
                </c:pt>
                <c:pt idx="214">
                  <c:v>127.736016560686</c:v>
                </c:pt>
                <c:pt idx="215">
                  <c:v>121.98332654191999</c:v>
                </c:pt>
                <c:pt idx="216">
                  <c:v>114.805173248144</c:v>
                </c:pt>
                <c:pt idx="217">
                  <c:v>104.532174589121</c:v>
                </c:pt>
                <c:pt idx="218">
                  <c:v>119.855212145057</c:v>
                </c:pt>
                <c:pt idx="219">
                  <c:v>117.900219170173</c:v>
                </c:pt>
                <c:pt idx="220">
                  <c:v>120.423148842432</c:v>
                </c:pt>
                <c:pt idx="221">
                  <c:v>120.29834171490999</c:v>
                </c:pt>
                <c:pt idx="222">
                  <c:v>111.22823754500899</c:v>
                </c:pt>
                <c:pt idx="223">
                  <c:v>121.030187649973</c:v>
                </c:pt>
                <c:pt idx="224">
                  <c:v>119.378753108688</c:v>
                </c:pt>
                <c:pt idx="225">
                  <c:v>124.587688308034</c:v>
                </c:pt>
                <c:pt idx="226">
                  <c:v>107.214714584395</c:v>
                </c:pt>
                <c:pt idx="227">
                  <c:v>123.607776868971</c:v>
                </c:pt>
                <c:pt idx="228">
                  <c:v>112.489313117469</c:v>
                </c:pt>
                <c:pt idx="229">
                  <c:v>135.06734823757401</c:v>
                </c:pt>
                <c:pt idx="230">
                  <c:v>116.928100762821</c:v>
                </c:pt>
                <c:pt idx="231">
                  <c:v>115.13926404660501</c:v>
                </c:pt>
                <c:pt idx="232">
                  <c:v>106.203999518952</c:v>
                </c:pt>
                <c:pt idx="233">
                  <c:v>114.11452638956899</c:v>
                </c:pt>
                <c:pt idx="234">
                  <c:v>129.41247196249799</c:v>
                </c:pt>
                <c:pt idx="235">
                  <c:v>132.09985777621</c:v>
                </c:pt>
                <c:pt idx="236">
                  <c:v>108.022325575653</c:v>
                </c:pt>
                <c:pt idx="237">
                  <c:v>121.621714842131</c:v>
                </c:pt>
                <c:pt idx="238">
                  <c:v>136.28356619263801</c:v>
                </c:pt>
                <c:pt idx="239">
                  <c:v>124.26753314486101</c:v>
                </c:pt>
                <c:pt idx="240">
                  <c:v>112.85342024651</c:v>
                </c:pt>
                <c:pt idx="241">
                  <c:v>126.86670882763801</c:v>
                </c:pt>
                <c:pt idx="242">
                  <c:v>110.91092763252701</c:v>
                </c:pt>
                <c:pt idx="243">
                  <c:v>124.638850459148</c:v>
                </c:pt>
                <c:pt idx="244">
                  <c:v>101.31438752272599</c:v>
                </c:pt>
                <c:pt idx="245">
                  <c:v>115.324491419403</c:v>
                </c:pt>
                <c:pt idx="246">
                  <c:v>109.584816204391</c:v>
                </c:pt>
                <c:pt idx="247">
                  <c:v>106.60143684297201</c:v>
                </c:pt>
                <c:pt idx="248">
                  <c:v>130.92958012401999</c:v>
                </c:pt>
                <c:pt idx="249">
                  <c:v>117.29682167726</c:v>
                </c:pt>
                <c:pt idx="250">
                  <c:v>103.66723455438201</c:v>
                </c:pt>
                <c:pt idx="251">
                  <c:v>105.00804346733899</c:v>
                </c:pt>
                <c:pt idx="252">
                  <c:v>116.00857070529401</c:v>
                </c:pt>
                <c:pt idx="253">
                  <c:v>114.683340053696</c:v>
                </c:pt>
                <c:pt idx="254">
                  <c:v>142.413443188309</c:v>
                </c:pt>
                <c:pt idx="255">
                  <c:v>111.985885843208</c:v>
                </c:pt>
                <c:pt idx="256">
                  <c:v>117.664683495613</c:v>
                </c:pt>
                <c:pt idx="257">
                  <c:v>109.27744564266401</c:v>
                </c:pt>
                <c:pt idx="258">
                  <c:v>123.716580981793</c:v>
                </c:pt>
                <c:pt idx="259">
                  <c:v>109.44969824722899</c:v>
                </c:pt>
                <c:pt idx="260">
                  <c:v>128.80874151520501</c:v>
                </c:pt>
                <c:pt idx="261">
                  <c:v>105.557199105452</c:v>
                </c:pt>
                <c:pt idx="262">
                  <c:v>104.504735679438</c:v>
                </c:pt>
                <c:pt idx="263">
                  <c:v>119.863968779185</c:v>
                </c:pt>
                <c:pt idx="264">
                  <c:v>120.99114287792899</c:v>
                </c:pt>
                <c:pt idx="265">
                  <c:v>120.78251661011601</c:v>
                </c:pt>
                <c:pt idx="266">
                  <c:v>122.458844126234</c:v>
                </c:pt>
                <c:pt idx="267">
                  <c:v>116.679535967741</c:v>
                </c:pt>
                <c:pt idx="268">
                  <c:v>116.59480661001</c:v>
                </c:pt>
                <c:pt idx="269">
                  <c:v>113.525505478073</c:v>
                </c:pt>
                <c:pt idx="270">
                  <c:v>107.00925575181</c:v>
                </c:pt>
                <c:pt idx="271">
                  <c:v>123.954284626847</c:v>
                </c:pt>
                <c:pt idx="272">
                  <c:v>110.848562927001</c:v>
                </c:pt>
                <c:pt idx="273">
                  <c:v>135.28349699920699</c:v>
                </c:pt>
                <c:pt idx="274">
                  <c:v>133.55771940202499</c:v>
                </c:pt>
                <c:pt idx="275">
                  <c:v>118.838271497547</c:v>
                </c:pt>
                <c:pt idx="276">
                  <c:v>119.553746263571</c:v>
                </c:pt>
                <c:pt idx="277">
                  <c:v>117.05797260755099</c:v>
                </c:pt>
                <c:pt idx="278">
                  <c:v>133.14528194212599</c:v>
                </c:pt>
                <c:pt idx="279">
                  <c:v>111.44301302685101</c:v>
                </c:pt>
                <c:pt idx="280">
                  <c:v>119.84240315062</c:v>
                </c:pt>
                <c:pt idx="281">
                  <c:v>128.15184349875199</c:v>
                </c:pt>
                <c:pt idx="282">
                  <c:v>123.794923535557</c:v>
                </c:pt>
                <c:pt idx="283">
                  <c:v>102.86211193344499</c:v>
                </c:pt>
                <c:pt idx="284">
                  <c:v>109.848720395901</c:v>
                </c:pt>
                <c:pt idx="285">
                  <c:v>132.86123299233401</c:v>
                </c:pt>
                <c:pt idx="286">
                  <c:v>100.103519311871</c:v>
                </c:pt>
                <c:pt idx="287">
                  <c:v>121.118461664682</c:v>
                </c:pt>
                <c:pt idx="288">
                  <c:v>101.516840675513</c:v>
                </c:pt>
                <c:pt idx="289">
                  <c:v>132.23157623076099</c:v>
                </c:pt>
                <c:pt idx="290">
                  <c:v>126.692952079713</c:v>
                </c:pt>
                <c:pt idx="291">
                  <c:v>126.00960783399</c:v>
                </c:pt>
              </c:numCache>
            </c:numRef>
          </c:xVal>
          <c:yVal>
            <c:numRef>
              <c:f>'292RILs'!$J$2:$J$293</c:f>
              <c:numCache>
                <c:formatCode>0.00</c:formatCode>
                <c:ptCount val="292"/>
                <c:pt idx="0">
                  <c:v>51.957344674538902</c:v>
                </c:pt>
                <c:pt idx="1">
                  <c:v>42.771643100609801</c:v>
                </c:pt>
                <c:pt idx="2">
                  <c:v>36.275734582754403</c:v>
                </c:pt>
                <c:pt idx="3">
                  <c:v>62.301912168801003</c:v>
                </c:pt>
                <c:pt idx="4">
                  <c:v>43.706431614574903</c:v>
                </c:pt>
                <c:pt idx="5">
                  <c:v>56.135867366873804</c:v>
                </c:pt>
                <c:pt idx="6">
                  <c:v>51.2944565960887</c:v>
                </c:pt>
                <c:pt idx="7">
                  <c:v>53.970787103864303</c:v>
                </c:pt>
                <c:pt idx="8">
                  <c:v>40.604188915017602</c:v>
                </c:pt>
                <c:pt idx="9">
                  <c:v>40.041307834199202</c:v>
                </c:pt>
                <c:pt idx="10">
                  <c:v>43.513287681726197</c:v>
                </c:pt>
                <c:pt idx="11">
                  <c:v>52.320438525230102</c:v>
                </c:pt>
                <c:pt idx="12">
                  <c:v>44.0640446264728</c:v>
                </c:pt>
                <c:pt idx="13">
                  <c:v>44.081247203647102</c:v>
                </c:pt>
                <c:pt idx="14">
                  <c:v>52.288865921826599</c:v>
                </c:pt>
                <c:pt idx="15">
                  <c:v>46.315033124096303</c:v>
                </c:pt>
                <c:pt idx="16">
                  <c:v>39.750668300323902</c:v>
                </c:pt>
                <c:pt idx="17">
                  <c:v>53.598909553703002</c:v>
                </c:pt>
                <c:pt idx="18">
                  <c:v>52.850468621291199</c:v>
                </c:pt>
                <c:pt idx="19">
                  <c:v>53.824491255124002</c:v>
                </c:pt>
                <c:pt idx="20">
                  <c:v>46.009881115306499</c:v>
                </c:pt>
                <c:pt idx="21">
                  <c:v>36.518496356028898</c:v>
                </c:pt>
                <c:pt idx="22">
                  <c:v>41.294593337536803</c:v>
                </c:pt>
                <c:pt idx="23">
                  <c:v>45.958022477564199</c:v>
                </c:pt>
                <c:pt idx="24">
                  <c:v>47.925405991737797</c:v>
                </c:pt>
                <c:pt idx="25">
                  <c:v>11.005013147725499</c:v>
                </c:pt>
                <c:pt idx="26">
                  <c:v>43.149014657858302</c:v>
                </c:pt>
                <c:pt idx="27">
                  <c:v>53.469521150627997</c:v>
                </c:pt>
                <c:pt idx="28">
                  <c:v>40.944698749079997</c:v>
                </c:pt>
                <c:pt idx="29">
                  <c:v>32.014345066134403</c:v>
                </c:pt>
                <c:pt idx="30">
                  <c:v>51.698314560610299</c:v>
                </c:pt>
                <c:pt idx="31">
                  <c:v>49.5472115631514</c:v>
                </c:pt>
                <c:pt idx="32">
                  <c:v>45.452687935141299</c:v>
                </c:pt>
                <c:pt idx="33">
                  <c:v>56.477835898016998</c:v>
                </c:pt>
                <c:pt idx="34">
                  <c:v>57.646610273687102</c:v>
                </c:pt>
                <c:pt idx="35">
                  <c:v>35.198572115527199</c:v>
                </c:pt>
                <c:pt idx="36">
                  <c:v>54.745406828150102</c:v>
                </c:pt>
                <c:pt idx="37">
                  <c:v>58.886155693562301</c:v>
                </c:pt>
                <c:pt idx="38">
                  <c:v>57.813059728038503</c:v>
                </c:pt>
                <c:pt idx="39">
                  <c:v>45.3360657903945</c:v>
                </c:pt>
                <c:pt idx="40">
                  <c:v>49.148935289332698</c:v>
                </c:pt>
                <c:pt idx="41">
                  <c:v>55.830019836239799</c:v>
                </c:pt>
                <c:pt idx="42">
                  <c:v>35.488658441692998</c:v>
                </c:pt>
                <c:pt idx="43">
                  <c:v>22.9230942592167</c:v>
                </c:pt>
                <c:pt idx="44">
                  <c:v>50.987414970437598</c:v>
                </c:pt>
                <c:pt idx="45">
                  <c:v>37.639477014459899</c:v>
                </c:pt>
                <c:pt idx="46">
                  <c:v>26.260706683640802</c:v>
                </c:pt>
                <c:pt idx="47">
                  <c:v>65.342128094534004</c:v>
                </c:pt>
                <c:pt idx="48">
                  <c:v>57.132777307313802</c:v>
                </c:pt>
                <c:pt idx="49">
                  <c:v>52.942317860753299</c:v>
                </c:pt>
                <c:pt idx="50">
                  <c:v>36.192499055746303</c:v>
                </c:pt>
                <c:pt idx="51">
                  <c:v>35.808306822742701</c:v>
                </c:pt>
                <c:pt idx="52">
                  <c:v>65.940997210174103</c:v>
                </c:pt>
                <c:pt idx="53">
                  <c:v>55.479718011180601</c:v>
                </c:pt>
                <c:pt idx="54">
                  <c:v>52.476360151777001</c:v>
                </c:pt>
                <c:pt idx="55">
                  <c:v>60.067806928850999</c:v>
                </c:pt>
                <c:pt idx="56">
                  <c:v>48.187534194490098</c:v>
                </c:pt>
                <c:pt idx="57">
                  <c:v>55.1249011884182</c:v>
                </c:pt>
                <c:pt idx="58">
                  <c:v>55.985237010011502</c:v>
                </c:pt>
                <c:pt idx="59">
                  <c:v>27.087416721333302</c:v>
                </c:pt>
                <c:pt idx="60">
                  <c:v>68.706426638715897</c:v>
                </c:pt>
                <c:pt idx="61">
                  <c:v>46.287502298341401</c:v>
                </c:pt>
                <c:pt idx="62">
                  <c:v>45.557343681110197</c:v>
                </c:pt>
                <c:pt idx="63">
                  <c:v>26.2363858130403</c:v>
                </c:pt>
                <c:pt idx="64">
                  <c:v>55.0889600719618</c:v>
                </c:pt>
                <c:pt idx="65">
                  <c:v>52.524908477023502</c:v>
                </c:pt>
                <c:pt idx="66">
                  <c:v>37.279506690300302</c:v>
                </c:pt>
                <c:pt idx="67">
                  <c:v>37.280760875793298</c:v>
                </c:pt>
                <c:pt idx="68">
                  <c:v>36.513203740657502</c:v>
                </c:pt>
                <c:pt idx="69">
                  <c:v>51.499183753849202</c:v>
                </c:pt>
                <c:pt idx="70">
                  <c:v>29.989878195759399</c:v>
                </c:pt>
                <c:pt idx="71">
                  <c:v>30.264070948353002</c:v>
                </c:pt>
                <c:pt idx="72">
                  <c:v>44.420751026515298</c:v>
                </c:pt>
                <c:pt idx="73">
                  <c:v>41.204080758129301</c:v>
                </c:pt>
                <c:pt idx="74">
                  <c:v>91.606073652148197</c:v>
                </c:pt>
                <c:pt idx="75">
                  <c:v>51.4538919554142</c:v>
                </c:pt>
                <c:pt idx="76">
                  <c:v>52.257724782601699</c:v>
                </c:pt>
                <c:pt idx="77">
                  <c:v>41.883586558693402</c:v>
                </c:pt>
                <c:pt idx="78">
                  <c:v>55.985770233278103</c:v>
                </c:pt>
                <c:pt idx="79">
                  <c:v>34.834295964417201</c:v>
                </c:pt>
                <c:pt idx="80">
                  <c:v>36.450295257813103</c:v>
                </c:pt>
                <c:pt idx="81">
                  <c:v>60.367729123519702</c:v>
                </c:pt>
                <c:pt idx="82">
                  <c:v>32.833699196186501</c:v>
                </c:pt>
                <c:pt idx="83">
                  <c:v>55.1766964575895</c:v>
                </c:pt>
                <c:pt idx="84">
                  <c:v>60.788045673866797</c:v>
                </c:pt>
                <c:pt idx="85">
                  <c:v>44.021895952107599</c:v>
                </c:pt>
                <c:pt idx="86">
                  <c:v>39.662430744794896</c:v>
                </c:pt>
                <c:pt idx="87">
                  <c:v>42.157074676474203</c:v>
                </c:pt>
                <c:pt idx="88">
                  <c:v>43.820711719690799</c:v>
                </c:pt>
                <c:pt idx="89">
                  <c:v>33.451728178817397</c:v>
                </c:pt>
                <c:pt idx="90">
                  <c:v>57.561746528463701</c:v>
                </c:pt>
                <c:pt idx="91">
                  <c:v>51.712057837297202</c:v>
                </c:pt>
                <c:pt idx="92">
                  <c:v>43.956505956896898</c:v>
                </c:pt>
                <c:pt idx="93">
                  <c:v>51.491973636038999</c:v>
                </c:pt>
                <c:pt idx="94">
                  <c:v>51.1557460392157</c:v>
                </c:pt>
                <c:pt idx="95">
                  <c:v>41.3552172189655</c:v>
                </c:pt>
                <c:pt idx="96">
                  <c:v>55.837959642689398</c:v>
                </c:pt>
                <c:pt idx="97">
                  <c:v>53.100681114625203</c:v>
                </c:pt>
                <c:pt idx="98">
                  <c:v>48.851892450463502</c:v>
                </c:pt>
                <c:pt idx="99">
                  <c:v>47.014493453573699</c:v>
                </c:pt>
                <c:pt idx="100">
                  <c:v>57.709021870382799</c:v>
                </c:pt>
                <c:pt idx="101">
                  <c:v>50.382026362019197</c:v>
                </c:pt>
                <c:pt idx="102">
                  <c:v>54.301830040616103</c:v>
                </c:pt>
                <c:pt idx="103">
                  <c:v>53.3092043057109</c:v>
                </c:pt>
                <c:pt idx="104">
                  <c:v>57.380538514855701</c:v>
                </c:pt>
                <c:pt idx="105">
                  <c:v>50.653768749940497</c:v>
                </c:pt>
                <c:pt idx="106">
                  <c:v>58.1498290470239</c:v>
                </c:pt>
                <c:pt idx="107">
                  <c:v>55.144211539154099</c:v>
                </c:pt>
                <c:pt idx="108">
                  <c:v>47.268708965696398</c:v>
                </c:pt>
                <c:pt idx="109">
                  <c:v>60.554003979487398</c:v>
                </c:pt>
                <c:pt idx="110">
                  <c:v>58.029094726566001</c:v>
                </c:pt>
                <c:pt idx="111">
                  <c:v>46.511996841510602</c:v>
                </c:pt>
                <c:pt idx="112">
                  <c:v>53.983375533290101</c:v>
                </c:pt>
                <c:pt idx="113">
                  <c:v>55.984390680700997</c:v>
                </c:pt>
                <c:pt idx="114">
                  <c:v>38.2669073819592</c:v>
                </c:pt>
                <c:pt idx="115">
                  <c:v>62.872046583534299</c:v>
                </c:pt>
                <c:pt idx="116">
                  <c:v>47.833191000408902</c:v>
                </c:pt>
                <c:pt idx="117">
                  <c:v>35.479141377455498</c:v>
                </c:pt>
                <c:pt idx="118">
                  <c:v>38.5450316088642</c:v>
                </c:pt>
                <c:pt idx="119">
                  <c:v>36.593646739771501</c:v>
                </c:pt>
                <c:pt idx="120">
                  <c:v>50.675617729720898</c:v>
                </c:pt>
                <c:pt idx="121">
                  <c:v>47.875000223918597</c:v>
                </c:pt>
                <c:pt idx="122">
                  <c:v>46.497694145880601</c:v>
                </c:pt>
                <c:pt idx="123">
                  <c:v>67.381201316268104</c:v>
                </c:pt>
                <c:pt idx="124">
                  <c:v>50.203723995422997</c:v>
                </c:pt>
                <c:pt idx="125">
                  <c:v>50.182298367662099</c:v>
                </c:pt>
                <c:pt idx="126">
                  <c:v>51.734990809434898</c:v>
                </c:pt>
                <c:pt idx="127">
                  <c:v>59.143708578343798</c:v>
                </c:pt>
                <c:pt idx="128">
                  <c:v>68.750486625857206</c:v>
                </c:pt>
                <c:pt idx="129">
                  <c:v>59.730723265990797</c:v>
                </c:pt>
                <c:pt idx="130">
                  <c:v>64.000037661753694</c:v>
                </c:pt>
                <c:pt idx="131">
                  <c:v>52.9300700683389</c:v>
                </c:pt>
                <c:pt idx="132">
                  <c:v>54.107976589964501</c:v>
                </c:pt>
                <c:pt idx="133">
                  <c:v>43.3712740744242</c:v>
                </c:pt>
                <c:pt idx="134">
                  <c:v>62.252320503296303</c:v>
                </c:pt>
                <c:pt idx="135">
                  <c:v>59.062773152919497</c:v>
                </c:pt>
                <c:pt idx="136">
                  <c:v>41.451976885765703</c:v>
                </c:pt>
                <c:pt idx="137">
                  <c:v>52.280663841156503</c:v>
                </c:pt>
                <c:pt idx="138">
                  <c:v>38.817761873689697</c:v>
                </c:pt>
                <c:pt idx="139">
                  <c:v>49.953092689133101</c:v>
                </c:pt>
                <c:pt idx="140">
                  <c:v>50.7901054259708</c:v>
                </c:pt>
                <c:pt idx="141">
                  <c:v>46.897362993995799</c:v>
                </c:pt>
                <c:pt idx="142">
                  <c:v>38.013117875310698</c:v>
                </c:pt>
                <c:pt idx="143">
                  <c:v>52.1830017744957</c:v>
                </c:pt>
                <c:pt idx="144">
                  <c:v>52.597014964985704</c:v>
                </c:pt>
                <c:pt idx="145">
                  <c:v>51.228540371538401</c:v>
                </c:pt>
                <c:pt idx="146">
                  <c:v>59.6015498963041</c:v>
                </c:pt>
                <c:pt idx="147">
                  <c:v>51.294137732436198</c:v>
                </c:pt>
                <c:pt idx="148">
                  <c:v>42.745771414567301</c:v>
                </c:pt>
                <c:pt idx="149">
                  <c:v>55.986942966754498</c:v>
                </c:pt>
                <c:pt idx="150">
                  <c:v>68.5858939747541</c:v>
                </c:pt>
                <c:pt idx="151">
                  <c:v>64.120231987433499</c:v>
                </c:pt>
                <c:pt idx="152">
                  <c:v>62.066579838241402</c:v>
                </c:pt>
                <c:pt idx="153">
                  <c:v>38.2099764799759</c:v>
                </c:pt>
                <c:pt idx="154">
                  <c:v>43.378614547410002</c:v>
                </c:pt>
                <c:pt idx="155">
                  <c:v>48.341167101290402</c:v>
                </c:pt>
                <c:pt idx="156">
                  <c:v>40.008305594520202</c:v>
                </c:pt>
                <c:pt idx="157">
                  <c:v>43.104513676037897</c:v>
                </c:pt>
                <c:pt idx="158">
                  <c:v>58.591407897853898</c:v>
                </c:pt>
                <c:pt idx="159">
                  <c:v>57.239472366260102</c:v>
                </c:pt>
                <c:pt idx="160">
                  <c:v>66.417619158143197</c:v>
                </c:pt>
                <c:pt idx="161">
                  <c:v>41.839510105909604</c:v>
                </c:pt>
                <c:pt idx="162">
                  <c:v>57.705600040980499</c:v>
                </c:pt>
                <c:pt idx="163">
                  <c:v>71.845330696863002</c:v>
                </c:pt>
                <c:pt idx="164">
                  <c:v>69.687445028667597</c:v>
                </c:pt>
                <c:pt idx="165">
                  <c:v>57.628070525103603</c:v>
                </c:pt>
                <c:pt idx="166">
                  <c:v>53.7801555564334</c:v>
                </c:pt>
                <c:pt idx="167">
                  <c:v>34.021865571547401</c:v>
                </c:pt>
                <c:pt idx="168">
                  <c:v>56.269201505416198</c:v>
                </c:pt>
                <c:pt idx="169">
                  <c:v>36.615026128511403</c:v>
                </c:pt>
                <c:pt idx="170">
                  <c:v>44.374492462144701</c:v>
                </c:pt>
                <c:pt idx="171">
                  <c:v>54.861530760228099</c:v>
                </c:pt>
                <c:pt idx="172">
                  <c:v>46.5924667383848</c:v>
                </c:pt>
                <c:pt idx="173">
                  <c:v>44.863214228609699</c:v>
                </c:pt>
                <c:pt idx="174">
                  <c:v>69.294002741893394</c:v>
                </c:pt>
                <c:pt idx="175">
                  <c:v>48.330419402011003</c:v>
                </c:pt>
                <c:pt idx="176">
                  <c:v>37.201799069606103</c:v>
                </c:pt>
                <c:pt idx="177">
                  <c:v>63.062625034976399</c:v>
                </c:pt>
                <c:pt idx="178">
                  <c:v>46.196775303214899</c:v>
                </c:pt>
                <c:pt idx="179">
                  <c:v>54.595542182999097</c:v>
                </c:pt>
                <c:pt idx="180">
                  <c:v>49.2358465934851</c:v>
                </c:pt>
                <c:pt idx="181">
                  <c:v>36.282900669287102</c:v>
                </c:pt>
                <c:pt idx="182">
                  <c:v>62.725846417218897</c:v>
                </c:pt>
                <c:pt idx="183">
                  <c:v>25.286174962320001</c:v>
                </c:pt>
                <c:pt idx="184">
                  <c:v>48.119021013053498</c:v>
                </c:pt>
                <c:pt idx="185">
                  <c:v>41.305029796026403</c:v>
                </c:pt>
                <c:pt idx="186">
                  <c:v>51.222140684092999</c:v>
                </c:pt>
                <c:pt idx="187">
                  <c:v>63.082843542471203</c:v>
                </c:pt>
                <c:pt idx="188">
                  <c:v>54.110998416685099</c:v>
                </c:pt>
                <c:pt idx="189">
                  <c:v>54.358045881792201</c:v>
                </c:pt>
                <c:pt idx="190">
                  <c:v>59.896159216009401</c:v>
                </c:pt>
                <c:pt idx="191">
                  <c:v>49.364997188090001</c:v>
                </c:pt>
                <c:pt idx="192">
                  <c:v>82.533111474886397</c:v>
                </c:pt>
                <c:pt idx="193">
                  <c:v>42.6963995207186</c:v>
                </c:pt>
                <c:pt idx="194">
                  <c:v>46.9318982879632</c:v>
                </c:pt>
                <c:pt idx="195">
                  <c:v>42.747116778246799</c:v>
                </c:pt>
                <c:pt idx="196">
                  <c:v>55.968275870753601</c:v>
                </c:pt>
                <c:pt idx="197">
                  <c:v>51.357750183771103</c:v>
                </c:pt>
                <c:pt idx="198">
                  <c:v>50.940698079266902</c:v>
                </c:pt>
                <c:pt idx="199">
                  <c:v>61.2426488489942</c:v>
                </c:pt>
                <c:pt idx="200">
                  <c:v>25.739404860154099</c:v>
                </c:pt>
                <c:pt idx="201">
                  <c:v>60.9526189518593</c:v>
                </c:pt>
                <c:pt idx="202">
                  <c:v>50.786478976156197</c:v>
                </c:pt>
                <c:pt idx="203">
                  <c:v>42.945633911629898</c:v>
                </c:pt>
                <c:pt idx="204">
                  <c:v>48.424983749691101</c:v>
                </c:pt>
                <c:pt idx="205">
                  <c:v>27.0795983767667</c:v>
                </c:pt>
                <c:pt idx="206">
                  <c:v>66.945208395021297</c:v>
                </c:pt>
                <c:pt idx="207">
                  <c:v>32.030996054648199</c:v>
                </c:pt>
                <c:pt idx="208">
                  <c:v>62.1833689373765</c:v>
                </c:pt>
                <c:pt idx="209">
                  <c:v>53.555277533638801</c:v>
                </c:pt>
                <c:pt idx="210">
                  <c:v>61.025117851253697</c:v>
                </c:pt>
                <c:pt idx="211">
                  <c:v>53.663313012231399</c:v>
                </c:pt>
                <c:pt idx="212">
                  <c:v>63.266373805367003</c:v>
                </c:pt>
                <c:pt idx="213">
                  <c:v>43.355905393436402</c:v>
                </c:pt>
                <c:pt idx="214">
                  <c:v>51.513445023945202</c:v>
                </c:pt>
                <c:pt idx="215">
                  <c:v>49.025746960379401</c:v>
                </c:pt>
                <c:pt idx="216">
                  <c:v>35.975434560650001</c:v>
                </c:pt>
                <c:pt idx="217">
                  <c:v>32.4970642059738</c:v>
                </c:pt>
                <c:pt idx="218">
                  <c:v>41.959738029905999</c:v>
                </c:pt>
                <c:pt idx="219">
                  <c:v>51.2277874025201</c:v>
                </c:pt>
                <c:pt idx="220">
                  <c:v>32.874929237867001</c:v>
                </c:pt>
                <c:pt idx="221">
                  <c:v>48.623699333613899</c:v>
                </c:pt>
                <c:pt idx="222">
                  <c:v>53.533519025555499</c:v>
                </c:pt>
                <c:pt idx="223">
                  <c:v>44.449269643087497</c:v>
                </c:pt>
                <c:pt idx="224">
                  <c:v>50.849719417562603</c:v>
                </c:pt>
                <c:pt idx="225">
                  <c:v>58.928301624837601</c:v>
                </c:pt>
                <c:pt idx="226">
                  <c:v>39.294943278619499</c:v>
                </c:pt>
                <c:pt idx="227">
                  <c:v>33.929453335607903</c:v>
                </c:pt>
                <c:pt idx="228">
                  <c:v>47.438050852109498</c:v>
                </c:pt>
                <c:pt idx="229">
                  <c:v>55.321545316568702</c:v>
                </c:pt>
                <c:pt idx="230">
                  <c:v>62.260278560113598</c:v>
                </c:pt>
                <c:pt idx="231">
                  <c:v>37.062101176065603</c:v>
                </c:pt>
                <c:pt idx="232">
                  <c:v>41.359821991464798</c:v>
                </c:pt>
                <c:pt idx="233">
                  <c:v>51.830368230334201</c:v>
                </c:pt>
                <c:pt idx="234">
                  <c:v>60.367057698531099</c:v>
                </c:pt>
                <c:pt idx="235">
                  <c:v>30.783667680638601</c:v>
                </c:pt>
                <c:pt idx="236">
                  <c:v>36.231173253873898</c:v>
                </c:pt>
                <c:pt idx="237">
                  <c:v>46.512719917005697</c:v>
                </c:pt>
                <c:pt idx="238">
                  <c:v>57.549866119129703</c:v>
                </c:pt>
                <c:pt idx="239">
                  <c:v>32.4983583597784</c:v>
                </c:pt>
                <c:pt idx="240">
                  <c:v>43.859049306681797</c:v>
                </c:pt>
                <c:pt idx="241">
                  <c:v>46.362084104648403</c:v>
                </c:pt>
                <c:pt idx="242">
                  <c:v>50.970601809431798</c:v>
                </c:pt>
                <c:pt idx="243">
                  <c:v>54.993363155662898</c:v>
                </c:pt>
                <c:pt idx="244">
                  <c:v>36.445739115191301</c:v>
                </c:pt>
                <c:pt idx="245">
                  <c:v>52.527213569949502</c:v>
                </c:pt>
                <c:pt idx="246">
                  <c:v>47.504516517108797</c:v>
                </c:pt>
                <c:pt idx="247">
                  <c:v>19.642799027984001</c:v>
                </c:pt>
                <c:pt idx="248">
                  <c:v>55.527124698879703</c:v>
                </c:pt>
                <c:pt idx="249">
                  <c:v>45.400957699525499</c:v>
                </c:pt>
                <c:pt idx="250">
                  <c:v>43.650952962151202</c:v>
                </c:pt>
                <c:pt idx="251">
                  <c:v>41.741460252751999</c:v>
                </c:pt>
                <c:pt idx="252">
                  <c:v>45.835141100735697</c:v>
                </c:pt>
                <c:pt idx="253">
                  <c:v>57.623130586868598</c:v>
                </c:pt>
                <c:pt idx="254">
                  <c:v>80.227205535190393</c:v>
                </c:pt>
                <c:pt idx="255">
                  <c:v>32.2910221023376</c:v>
                </c:pt>
                <c:pt idx="256">
                  <c:v>49.144646510577097</c:v>
                </c:pt>
                <c:pt idx="257">
                  <c:v>53.382074849850603</c:v>
                </c:pt>
                <c:pt idx="258">
                  <c:v>65.567685423797101</c:v>
                </c:pt>
                <c:pt idx="259">
                  <c:v>46.020502168840899</c:v>
                </c:pt>
                <c:pt idx="260">
                  <c:v>54.7613336219788</c:v>
                </c:pt>
                <c:pt idx="261">
                  <c:v>36.6812974237479</c:v>
                </c:pt>
                <c:pt idx="262">
                  <c:v>42.3206720500337</c:v>
                </c:pt>
                <c:pt idx="263">
                  <c:v>43.925047381836599</c:v>
                </c:pt>
                <c:pt idx="264">
                  <c:v>37.7859462132636</c:v>
                </c:pt>
                <c:pt idx="265">
                  <c:v>53.662456086035199</c:v>
                </c:pt>
                <c:pt idx="266">
                  <c:v>46.557322110846997</c:v>
                </c:pt>
                <c:pt idx="267">
                  <c:v>52.240147855931099</c:v>
                </c:pt>
                <c:pt idx="268">
                  <c:v>39.062826890898897</c:v>
                </c:pt>
                <c:pt idx="269">
                  <c:v>49.842999619024198</c:v>
                </c:pt>
                <c:pt idx="270">
                  <c:v>34.491414720439998</c:v>
                </c:pt>
                <c:pt idx="271">
                  <c:v>61.312921522282302</c:v>
                </c:pt>
                <c:pt idx="272">
                  <c:v>30.5539452250881</c:v>
                </c:pt>
                <c:pt idx="273">
                  <c:v>47.6389141568471</c:v>
                </c:pt>
                <c:pt idx="274">
                  <c:v>62.1950448361805</c:v>
                </c:pt>
                <c:pt idx="275">
                  <c:v>61.710498221314403</c:v>
                </c:pt>
                <c:pt idx="276">
                  <c:v>28.501742895187899</c:v>
                </c:pt>
                <c:pt idx="277">
                  <c:v>53.607976319671202</c:v>
                </c:pt>
                <c:pt idx="278">
                  <c:v>47.8683696575212</c:v>
                </c:pt>
                <c:pt idx="279">
                  <c:v>52.196696624883799</c:v>
                </c:pt>
                <c:pt idx="280">
                  <c:v>48.187934864054803</c:v>
                </c:pt>
                <c:pt idx="281">
                  <c:v>61.843450770241297</c:v>
                </c:pt>
                <c:pt idx="282">
                  <c:v>47.453440566848499</c:v>
                </c:pt>
                <c:pt idx="283">
                  <c:v>43.272571874250403</c:v>
                </c:pt>
                <c:pt idx="284">
                  <c:v>52.718433909246002</c:v>
                </c:pt>
                <c:pt idx="285">
                  <c:v>53.050669869240501</c:v>
                </c:pt>
                <c:pt idx="286">
                  <c:v>37.665440132271698</c:v>
                </c:pt>
                <c:pt idx="287">
                  <c:v>68.231226071423905</c:v>
                </c:pt>
                <c:pt idx="288">
                  <c:v>51.8371752561563</c:v>
                </c:pt>
                <c:pt idx="289">
                  <c:v>58.683164422586302</c:v>
                </c:pt>
                <c:pt idx="290">
                  <c:v>52.136219041930502</c:v>
                </c:pt>
                <c:pt idx="291">
                  <c:v>50.7542158979911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64E-42E6-B1A8-C226077450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1129648"/>
        <c:axId val="1242913664"/>
      </c:scatterChart>
      <c:valAx>
        <c:axId val="124112964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42913664"/>
        <c:crosses val="autoZero"/>
        <c:crossBetween val="midCat"/>
      </c:valAx>
      <c:valAx>
        <c:axId val="12429136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4112964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en-US" sz="2000" b="0" i="0" u="none" strike="noStrike" kern="1200" spc="70" baseline="0">
                <a:solidFill>
                  <a:prstClr val="black">
                    <a:lumMod val="50000"/>
                    <a:lumOff val="50000"/>
                  </a:prst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2000" b="1" i="0" u="none" strike="noStrike" kern="1200" spc="70" baseline="0" dirty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I-GY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en-US" sz="2000" b="0" i="0" u="none" strike="noStrike" kern="1200" spc="70" baseline="0">
              <a:solidFill>
                <a:prstClr val="black">
                  <a:lumMod val="50000"/>
                  <a:lumOff val="50000"/>
                </a:prst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292RILs'!$J$1</c:f>
              <c:strCache>
                <c:ptCount val="1"/>
                <c:pt idx="0">
                  <c:v>GY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9.8444881889763775E-2"/>
                  <c:y val="-0.28257108486439197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 algn="ctr" rtl="0">
                      <a:defRPr lang="en-US" sz="1197" b="0" i="0" u="none" strike="noStrike" kern="1200" baseline="0">
                        <a:solidFill>
                          <a:prstClr val="black">
                            <a:lumMod val="50000"/>
                            <a:lumOff val="50000"/>
                          </a:prst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y = 1.0541x + 5.8711</a:t>
                    </a:r>
                    <a:b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</a:b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R² = 0.7032</a:t>
                    </a: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 algn="ctr" rtl="0">
                    <a:defRPr lang="en-US" sz="1197" b="0" i="0" u="none" strike="noStrike" kern="1200" baseline="0">
                      <a:solidFill>
                        <a:prstClr val="black">
                          <a:lumMod val="50000"/>
                          <a:lumOff val="50000"/>
                        </a:prst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'292RILs'!$H$2:$H$293</c:f>
              <c:numCache>
                <c:formatCode>0.00</c:formatCode>
                <c:ptCount val="292"/>
                <c:pt idx="0">
                  <c:v>42.929153770261898</c:v>
                </c:pt>
                <c:pt idx="1">
                  <c:v>35.032480371734898</c:v>
                </c:pt>
                <c:pt idx="2">
                  <c:v>35.6868952382505</c:v>
                </c:pt>
                <c:pt idx="3">
                  <c:v>49.1225612783809</c:v>
                </c:pt>
                <c:pt idx="4">
                  <c:v>45.100711021409197</c:v>
                </c:pt>
                <c:pt idx="5">
                  <c:v>51.949921748794203</c:v>
                </c:pt>
                <c:pt idx="6">
                  <c:v>42.133425072281298</c:v>
                </c:pt>
                <c:pt idx="7">
                  <c:v>43.684352123752198</c:v>
                </c:pt>
                <c:pt idx="8">
                  <c:v>35.363640889780697</c:v>
                </c:pt>
                <c:pt idx="9">
                  <c:v>35.079908273570702</c:v>
                </c:pt>
                <c:pt idx="10">
                  <c:v>41.300531614759599</c:v>
                </c:pt>
                <c:pt idx="11">
                  <c:v>39.633819613712497</c:v>
                </c:pt>
                <c:pt idx="12">
                  <c:v>35.986370107745401</c:v>
                </c:pt>
                <c:pt idx="13">
                  <c:v>32.369215497962401</c:v>
                </c:pt>
                <c:pt idx="14">
                  <c:v>40.077841697258599</c:v>
                </c:pt>
                <c:pt idx="15">
                  <c:v>39.795179613526003</c:v>
                </c:pt>
                <c:pt idx="16">
                  <c:v>36.495512575960099</c:v>
                </c:pt>
                <c:pt idx="17">
                  <c:v>46.5689922737659</c:v>
                </c:pt>
                <c:pt idx="18">
                  <c:v>43.841961982546401</c:v>
                </c:pt>
                <c:pt idx="19">
                  <c:v>49.270707716653803</c:v>
                </c:pt>
                <c:pt idx="20">
                  <c:v>37.953048199456198</c:v>
                </c:pt>
                <c:pt idx="21">
                  <c:v>30.4291242144641</c:v>
                </c:pt>
                <c:pt idx="22">
                  <c:v>33.509957072368202</c:v>
                </c:pt>
                <c:pt idx="23">
                  <c:v>45.761255002124599</c:v>
                </c:pt>
                <c:pt idx="24">
                  <c:v>47.594419140130903</c:v>
                </c:pt>
                <c:pt idx="25">
                  <c:v>13.4135194908723</c:v>
                </c:pt>
                <c:pt idx="26">
                  <c:v>34.232992307146397</c:v>
                </c:pt>
                <c:pt idx="27">
                  <c:v>42.343951130502496</c:v>
                </c:pt>
                <c:pt idx="28">
                  <c:v>35.809346535160699</c:v>
                </c:pt>
                <c:pt idx="29">
                  <c:v>28.253487657475699</c:v>
                </c:pt>
                <c:pt idx="30">
                  <c:v>47.3603805677403</c:v>
                </c:pt>
                <c:pt idx="31">
                  <c:v>44.692663668197397</c:v>
                </c:pt>
                <c:pt idx="32">
                  <c:v>36.627617399209299</c:v>
                </c:pt>
                <c:pt idx="33">
                  <c:v>53.870613713902003</c:v>
                </c:pt>
                <c:pt idx="34">
                  <c:v>48.845974607250199</c:v>
                </c:pt>
                <c:pt idx="35">
                  <c:v>27.9587442447915</c:v>
                </c:pt>
                <c:pt idx="36">
                  <c:v>49.035298666412999</c:v>
                </c:pt>
                <c:pt idx="37">
                  <c:v>39.049618659814001</c:v>
                </c:pt>
                <c:pt idx="38">
                  <c:v>44.3218778246463</c:v>
                </c:pt>
                <c:pt idx="39">
                  <c:v>44.462196556938302</c:v>
                </c:pt>
                <c:pt idx="40">
                  <c:v>35.660671673168601</c:v>
                </c:pt>
                <c:pt idx="41">
                  <c:v>41.967744047901903</c:v>
                </c:pt>
                <c:pt idx="42">
                  <c:v>32.018697697872902</c:v>
                </c:pt>
                <c:pt idx="43">
                  <c:v>18.593845942779399</c:v>
                </c:pt>
                <c:pt idx="44">
                  <c:v>44.735893780384501</c:v>
                </c:pt>
                <c:pt idx="45">
                  <c:v>29.970289605989699</c:v>
                </c:pt>
                <c:pt idx="46">
                  <c:v>17.463443593073499</c:v>
                </c:pt>
                <c:pt idx="47">
                  <c:v>46.9485871173761</c:v>
                </c:pt>
                <c:pt idx="48">
                  <c:v>47.134849921591702</c:v>
                </c:pt>
                <c:pt idx="49">
                  <c:v>47.271550968753303</c:v>
                </c:pt>
                <c:pt idx="50">
                  <c:v>31.805491851741301</c:v>
                </c:pt>
                <c:pt idx="51">
                  <c:v>28.944705869401801</c:v>
                </c:pt>
                <c:pt idx="52">
                  <c:v>57.008307412080399</c:v>
                </c:pt>
                <c:pt idx="53">
                  <c:v>50.310661420574803</c:v>
                </c:pt>
                <c:pt idx="54">
                  <c:v>49.464571421182299</c:v>
                </c:pt>
                <c:pt idx="55">
                  <c:v>41.813597090142899</c:v>
                </c:pt>
                <c:pt idx="56">
                  <c:v>41.235649868774701</c:v>
                </c:pt>
                <c:pt idx="57">
                  <c:v>41.149829216101502</c:v>
                </c:pt>
                <c:pt idx="58">
                  <c:v>44.788172708300401</c:v>
                </c:pt>
                <c:pt idx="59">
                  <c:v>27.443369855023601</c:v>
                </c:pt>
                <c:pt idx="60">
                  <c:v>50.530685660242298</c:v>
                </c:pt>
                <c:pt idx="61">
                  <c:v>40.274842772211201</c:v>
                </c:pt>
                <c:pt idx="62">
                  <c:v>43.137231620678797</c:v>
                </c:pt>
                <c:pt idx="63">
                  <c:v>18.241224458103201</c:v>
                </c:pt>
                <c:pt idx="64">
                  <c:v>52.018868137267901</c:v>
                </c:pt>
                <c:pt idx="65">
                  <c:v>42.115621440606098</c:v>
                </c:pt>
                <c:pt idx="66">
                  <c:v>35.896562040515199</c:v>
                </c:pt>
                <c:pt idx="67">
                  <c:v>34.399656921600503</c:v>
                </c:pt>
                <c:pt idx="68">
                  <c:v>28.026075174015201</c:v>
                </c:pt>
                <c:pt idx="69">
                  <c:v>48.177094363047601</c:v>
                </c:pt>
                <c:pt idx="70">
                  <c:v>21.4127899904665</c:v>
                </c:pt>
                <c:pt idx="71">
                  <c:v>21.6590835200385</c:v>
                </c:pt>
                <c:pt idx="72">
                  <c:v>38.137061567396998</c:v>
                </c:pt>
                <c:pt idx="73">
                  <c:v>34.270965751092803</c:v>
                </c:pt>
                <c:pt idx="74">
                  <c:v>63.447974050183198</c:v>
                </c:pt>
                <c:pt idx="75">
                  <c:v>40.260257792384699</c:v>
                </c:pt>
                <c:pt idx="76">
                  <c:v>50.537872487901403</c:v>
                </c:pt>
                <c:pt idx="77">
                  <c:v>36.025790728931298</c:v>
                </c:pt>
                <c:pt idx="78">
                  <c:v>36.529255744540301</c:v>
                </c:pt>
                <c:pt idx="79">
                  <c:v>29.3793788029644</c:v>
                </c:pt>
                <c:pt idx="80">
                  <c:v>43.131518132180098</c:v>
                </c:pt>
                <c:pt idx="81">
                  <c:v>50.274938802518903</c:v>
                </c:pt>
                <c:pt idx="82">
                  <c:v>31.4846899445097</c:v>
                </c:pt>
                <c:pt idx="83">
                  <c:v>43.744712174235097</c:v>
                </c:pt>
                <c:pt idx="84">
                  <c:v>45.082097505118398</c:v>
                </c:pt>
                <c:pt idx="85">
                  <c:v>33.911690621877199</c:v>
                </c:pt>
                <c:pt idx="86">
                  <c:v>38.089049438185803</c:v>
                </c:pt>
                <c:pt idx="87">
                  <c:v>28.484088788240999</c:v>
                </c:pt>
                <c:pt idx="88">
                  <c:v>31.2626877176072</c:v>
                </c:pt>
                <c:pt idx="89">
                  <c:v>29.325474720702001</c:v>
                </c:pt>
                <c:pt idx="90">
                  <c:v>46.698062665471497</c:v>
                </c:pt>
                <c:pt idx="91">
                  <c:v>39.021483110174401</c:v>
                </c:pt>
                <c:pt idx="92">
                  <c:v>32.294555789777498</c:v>
                </c:pt>
                <c:pt idx="93">
                  <c:v>42.8936832697472</c:v>
                </c:pt>
                <c:pt idx="94">
                  <c:v>40.539837294007299</c:v>
                </c:pt>
                <c:pt idx="95">
                  <c:v>33.115013077257203</c:v>
                </c:pt>
                <c:pt idx="96">
                  <c:v>39.604213449924401</c:v>
                </c:pt>
                <c:pt idx="97">
                  <c:v>48.698783449767099</c:v>
                </c:pt>
                <c:pt idx="98">
                  <c:v>42.767006132847001</c:v>
                </c:pt>
                <c:pt idx="99">
                  <c:v>40.045652666885097</c:v>
                </c:pt>
                <c:pt idx="100">
                  <c:v>46.047342894539803</c:v>
                </c:pt>
                <c:pt idx="101">
                  <c:v>47.770034833461999</c:v>
                </c:pt>
                <c:pt idx="102">
                  <c:v>44.626438254923599</c:v>
                </c:pt>
                <c:pt idx="103">
                  <c:v>37.475730219774199</c:v>
                </c:pt>
                <c:pt idx="104">
                  <c:v>45.802270465247901</c:v>
                </c:pt>
                <c:pt idx="105">
                  <c:v>42.232417300655101</c:v>
                </c:pt>
                <c:pt idx="106">
                  <c:v>40.952981799817202</c:v>
                </c:pt>
                <c:pt idx="107">
                  <c:v>45.5345955846797</c:v>
                </c:pt>
                <c:pt idx="108">
                  <c:v>45.921434032665303</c:v>
                </c:pt>
                <c:pt idx="109">
                  <c:v>44.750894401742698</c:v>
                </c:pt>
                <c:pt idx="110">
                  <c:v>51.373075603898997</c:v>
                </c:pt>
                <c:pt idx="111">
                  <c:v>34.022648563636501</c:v>
                </c:pt>
                <c:pt idx="112">
                  <c:v>36.9904994305546</c:v>
                </c:pt>
                <c:pt idx="113">
                  <c:v>46.342331670251902</c:v>
                </c:pt>
                <c:pt idx="114">
                  <c:v>36.833158956216899</c:v>
                </c:pt>
                <c:pt idx="115">
                  <c:v>48.263045513761</c:v>
                </c:pt>
                <c:pt idx="116">
                  <c:v>40.716818658564002</c:v>
                </c:pt>
                <c:pt idx="117">
                  <c:v>27.038390168368402</c:v>
                </c:pt>
                <c:pt idx="118">
                  <c:v>43.076394594743597</c:v>
                </c:pt>
                <c:pt idx="119">
                  <c:v>28.711257565918402</c:v>
                </c:pt>
                <c:pt idx="120">
                  <c:v>38.979977913947899</c:v>
                </c:pt>
                <c:pt idx="121">
                  <c:v>41.484768401118302</c:v>
                </c:pt>
                <c:pt idx="122">
                  <c:v>44.521709898735097</c:v>
                </c:pt>
                <c:pt idx="123">
                  <c:v>49.3085132463844</c:v>
                </c:pt>
                <c:pt idx="124">
                  <c:v>48.3950961777972</c:v>
                </c:pt>
                <c:pt idx="125">
                  <c:v>36.992219771366102</c:v>
                </c:pt>
                <c:pt idx="126">
                  <c:v>47.472475297527801</c:v>
                </c:pt>
                <c:pt idx="127">
                  <c:v>51.044394264843</c:v>
                </c:pt>
                <c:pt idx="128">
                  <c:v>54.486870062766599</c:v>
                </c:pt>
                <c:pt idx="129">
                  <c:v>46.648725677102298</c:v>
                </c:pt>
                <c:pt idx="130">
                  <c:v>45.6284821464224</c:v>
                </c:pt>
                <c:pt idx="131">
                  <c:v>46.130440038623099</c:v>
                </c:pt>
                <c:pt idx="132">
                  <c:v>42.897603192932003</c:v>
                </c:pt>
                <c:pt idx="133">
                  <c:v>34.021526620276099</c:v>
                </c:pt>
                <c:pt idx="134">
                  <c:v>43.620050640722503</c:v>
                </c:pt>
                <c:pt idx="135">
                  <c:v>47.522454911928897</c:v>
                </c:pt>
                <c:pt idx="136">
                  <c:v>32.533594788178299</c:v>
                </c:pt>
                <c:pt idx="137">
                  <c:v>45.935904252892698</c:v>
                </c:pt>
                <c:pt idx="138">
                  <c:v>35.7622811347522</c:v>
                </c:pt>
                <c:pt idx="139">
                  <c:v>42.990006079284001</c:v>
                </c:pt>
                <c:pt idx="140">
                  <c:v>43.136874511387802</c:v>
                </c:pt>
                <c:pt idx="141">
                  <c:v>37.244020526262801</c:v>
                </c:pt>
                <c:pt idx="142">
                  <c:v>32.474496401157701</c:v>
                </c:pt>
                <c:pt idx="143">
                  <c:v>44.0367190187159</c:v>
                </c:pt>
                <c:pt idx="144">
                  <c:v>47.583439742121101</c:v>
                </c:pt>
                <c:pt idx="145">
                  <c:v>41.024654273156798</c:v>
                </c:pt>
                <c:pt idx="146">
                  <c:v>50.649889606858103</c:v>
                </c:pt>
                <c:pt idx="147">
                  <c:v>41.059321483636097</c:v>
                </c:pt>
                <c:pt idx="148">
                  <c:v>39.720354549439698</c:v>
                </c:pt>
                <c:pt idx="149">
                  <c:v>47.334065420460597</c:v>
                </c:pt>
                <c:pt idx="150">
                  <c:v>50.694528881203901</c:v>
                </c:pt>
                <c:pt idx="151">
                  <c:v>43.428494151048199</c:v>
                </c:pt>
                <c:pt idx="152">
                  <c:v>56.286102301066698</c:v>
                </c:pt>
                <c:pt idx="153">
                  <c:v>40.084786522410703</c:v>
                </c:pt>
                <c:pt idx="154">
                  <c:v>36.632512958970203</c:v>
                </c:pt>
                <c:pt idx="155">
                  <c:v>47.6977776203518</c:v>
                </c:pt>
                <c:pt idx="156">
                  <c:v>31.756647061179901</c:v>
                </c:pt>
                <c:pt idx="157">
                  <c:v>39.649793547369804</c:v>
                </c:pt>
                <c:pt idx="158">
                  <c:v>48.905443278309498</c:v>
                </c:pt>
                <c:pt idx="159">
                  <c:v>45.535186632051897</c:v>
                </c:pt>
                <c:pt idx="160">
                  <c:v>50.809673534137403</c:v>
                </c:pt>
                <c:pt idx="161">
                  <c:v>38.069034079729001</c:v>
                </c:pt>
                <c:pt idx="162">
                  <c:v>47.261340233632602</c:v>
                </c:pt>
                <c:pt idx="163">
                  <c:v>56.322286890818603</c:v>
                </c:pt>
                <c:pt idx="164">
                  <c:v>56.537890464412101</c:v>
                </c:pt>
                <c:pt idx="165">
                  <c:v>40.521458917024503</c:v>
                </c:pt>
                <c:pt idx="166">
                  <c:v>39.47799507853</c:v>
                </c:pt>
                <c:pt idx="167">
                  <c:v>26.788481677621601</c:v>
                </c:pt>
                <c:pt idx="168">
                  <c:v>42.745572865728903</c:v>
                </c:pt>
                <c:pt idx="169">
                  <c:v>42.939189207566599</c:v>
                </c:pt>
                <c:pt idx="170">
                  <c:v>39.831931222573402</c:v>
                </c:pt>
                <c:pt idx="171">
                  <c:v>45.064356579170898</c:v>
                </c:pt>
                <c:pt idx="172">
                  <c:v>44.401197695234799</c:v>
                </c:pt>
                <c:pt idx="173">
                  <c:v>36.3751346177567</c:v>
                </c:pt>
                <c:pt idx="174">
                  <c:v>52.881857453720997</c:v>
                </c:pt>
                <c:pt idx="175">
                  <c:v>40.618246457173797</c:v>
                </c:pt>
                <c:pt idx="176">
                  <c:v>35.9594465765297</c:v>
                </c:pt>
                <c:pt idx="177">
                  <c:v>47.239506202448801</c:v>
                </c:pt>
                <c:pt idx="178">
                  <c:v>35.087594285170802</c:v>
                </c:pt>
                <c:pt idx="179">
                  <c:v>44.165282813666501</c:v>
                </c:pt>
                <c:pt idx="180">
                  <c:v>41.050839732526903</c:v>
                </c:pt>
                <c:pt idx="181">
                  <c:v>32.963231005983303</c:v>
                </c:pt>
                <c:pt idx="182">
                  <c:v>50.515889148091702</c:v>
                </c:pt>
                <c:pt idx="183">
                  <c:v>22.369665604478101</c:v>
                </c:pt>
                <c:pt idx="184">
                  <c:v>35.094477121253398</c:v>
                </c:pt>
                <c:pt idx="185">
                  <c:v>32.773728716767899</c:v>
                </c:pt>
                <c:pt idx="186">
                  <c:v>42.322142378663997</c:v>
                </c:pt>
                <c:pt idx="187">
                  <c:v>49.716993551622501</c:v>
                </c:pt>
                <c:pt idx="188">
                  <c:v>43.826506945717</c:v>
                </c:pt>
                <c:pt idx="189">
                  <c:v>49.775121229363698</c:v>
                </c:pt>
                <c:pt idx="190">
                  <c:v>46.600843487247801</c:v>
                </c:pt>
                <c:pt idx="191">
                  <c:v>44.305271653386697</c:v>
                </c:pt>
                <c:pt idx="192">
                  <c:v>58.332212387880197</c:v>
                </c:pt>
                <c:pt idx="193">
                  <c:v>37.047744101496797</c:v>
                </c:pt>
                <c:pt idx="194">
                  <c:v>35.746774664324597</c:v>
                </c:pt>
                <c:pt idx="195">
                  <c:v>33.446625988282797</c:v>
                </c:pt>
                <c:pt idx="196">
                  <c:v>49.457029466218103</c:v>
                </c:pt>
                <c:pt idx="197">
                  <c:v>37.595399791928799</c:v>
                </c:pt>
                <c:pt idx="198">
                  <c:v>45.395523637402199</c:v>
                </c:pt>
                <c:pt idx="199">
                  <c:v>56.477701655092602</c:v>
                </c:pt>
                <c:pt idx="200">
                  <c:v>24.5331200066625</c:v>
                </c:pt>
                <c:pt idx="201">
                  <c:v>49.3963693105242</c:v>
                </c:pt>
                <c:pt idx="202">
                  <c:v>42.936895901894097</c:v>
                </c:pt>
                <c:pt idx="203">
                  <c:v>30.096283717002901</c:v>
                </c:pt>
                <c:pt idx="204">
                  <c:v>51.272373315927602</c:v>
                </c:pt>
                <c:pt idx="205">
                  <c:v>19.865426555186399</c:v>
                </c:pt>
                <c:pt idx="206">
                  <c:v>46.516791779727399</c:v>
                </c:pt>
                <c:pt idx="207">
                  <c:v>22.411132269209599</c:v>
                </c:pt>
                <c:pt idx="208">
                  <c:v>50.207959475667003</c:v>
                </c:pt>
                <c:pt idx="209">
                  <c:v>38.385255899659398</c:v>
                </c:pt>
                <c:pt idx="210">
                  <c:v>44.442990535361901</c:v>
                </c:pt>
                <c:pt idx="211">
                  <c:v>42.352676335789198</c:v>
                </c:pt>
                <c:pt idx="212">
                  <c:v>45.845847694068297</c:v>
                </c:pt>
                <c:pt idx="213">
                  <c:v>38.052107007329703</c:v>
                </c:pt>
                <c:pt idx="214">
                  <c:v>37.564308805131297</c:v>
                </c:pt>
                <c:pt idx="215">
                  <c:v>40.578567593264701</c:v>
                </c:pt>
                <c:pt idx="216">
                  <c:v>30.340376536961202</c:v>
                </c:pt>
                <c:pt idx="217">
                  <c:v>33.063084210046497</c:v>
                </c:pt>
                <c:pt idx="218">
                  <c:v>34.239998186117703</c:v>
                </c:pt>
                <c:pt idx="219">
                  <c:v>43.799633026033398</c:v>
                </c:pt>
                <c:pt idx="220">
                  <c:v>23.499276336354701</c:v>
                </c:pt>
                <c:pt idx="221">
                  <c:v>39.989955876745299</c:v>
                </c:pt>
                <c:pt idx="222">
                  <c:v>53.328393856563601</c:v>
                </c:pt>
                <c:pt idx="223">
                  <c:v>37.548169714284199</c:v>
                </c:pt>
                <c:pt idx="224">
                  <c:v>42.567361417595301</c:v>
                </c:pt>
                <c:pt idx="225">
                  <c:v>46.298922019987103</c:v>
                </c:pt>
                <c:pt idx="226">
                  <c:v>40.084007166644497</c:v>
                </c:pt>
                <c:pt idx="227">
                  <c:v>25.1857917250579</c:v>
                </c:pt>
                <c:pt idx="228">
                  <c:v>45.847363392649697</c:v>
                </c:pt>
                <c:pt idx="229">
                  <c:v>37.383098446853801</c:v>
                </c:pt>
                <c:pt idx="230">
                  <c:v>56.507307124790202</c:v>
                </c:pt>
                <c:pt idx="231">
                  <c:v>31.3586697585419</c:v>
                </c:pt>
                <c:pt idx="232">
                  <c:v>42.907890945877199</c:v>
                </c:pt>
                <c:pt idx="233">
                  <c:v>47.493915492263298</c:v>
                </c:pt>
                <c:pt idx="234">
                  <c:v>43.941640957747303</c:v>
                </c:pt>
                <c:pt idx="235">
                  <c:v>20.554986407637301</c:v>
                </c:pt>
                <c:pt idx="236">
                  <c:v>35.928101409126</c:v>
                </c:pt>
                <c:pt idx="237">
                  <c:v>37.893091141590098</c:v>
                </c:pt>
                <c:pt idx="238">
                  <c:v>38.686610769739097</c:v>
                </c:pt>
                <c:pt idx="239">
                  <c:v>24.236356385042502</c:v>
                </c:pt>
                <c:pt idx="240">
                  <c:v>41.018707197299001</c:v>
                </c:pt>
                <c:pt idx="241">
                  <c:v>34.333298153969501</c:v>
                </c:pt>
                <c:pt idx="242">
                  <c:v>48.985759295133903</c:v>
                </c:pt>
                <c:pt idx="243">
                  <c:v>43.797102892774902</c:v>
                </c:pt>
                <c:pt idx="244">
                  <c:v>41.672808385096801</c:v>
                </c:pt>
                <c:pt idx="245">
                  <c:v>49.647149885469901</c:v>
                </c:pt>
                <c:pt idx="246">
                  <c:v>46.402312170604603</c:v>
                </c:pt>
                <c:pt idx="247">
                  <c:v>12.7723990410878</c:v>
                </c:pt>
                <c:pt idx="248">
                  <c:v>43.3804256707622</c:v>
                </c:pt>
                <c:pt idx="249">
                  <c:v>37.777328940127298</c:v>
                </c:pt>
                <c:pt idx="250">
                  <c:v>48.497504849264097</c:v>
                </c:pt>
                <c:pt idx="251">
                  <c:v>44.732048332181897</c:v>
                </c:pt>
                <c:pt idx="252">
                  <c:v>42.411785063399002</c:v>
                </c:pt>
                <c:pt idx="253">
                  <c:v>53.262431549576696</c:v>
                </c:pt>
                <c:pt idx="254">
                  <c:v>52.105045727100801</c:v>
                </c:pt>
                <c:pt idx="255">
                  <c:v>27.137770159477</c:v>
                </c:pt>
                <c:pt idx="256">
                  <c:v>41.783417262607799</c:v>
                </c:pt>
                <c:pt idx="257">
                  <c:v>54.719460045345798</c:v>
                </c:pt>
                <c:pt idx="258">
                  <c:v>53.581384144201998</c:v>
                </c:pt>
                <c:pt idx="259">
                  <c:v>44.6067553749346</c:v>
                </c:pt>
                <c:pt idx="260">
                  <c:v>40.996569162340997</c:v>
                </c:pt>
                <c:pt idx="261">
                  <c:v>38.486285727289598</c:v>
                </c:pt>
                <c:pt idx="262">
                  <c:v>44.464281420180299</c:v>
                </c:pt>
                <c:pt idx="263">
                  <c:v>35.907718132213901</c:v>
                </c:pt>
                <c:pt idx="264">
                  <c:v>29.019644516900101</c:v>
                </c:pt>
                <c:pt idx="265">
                  <c:v>44.183723724388898</c:v>
                </c:pt>
                <c:pt idx="266">
                  <c:v>38.334904674896897</c:v>
                </c:pt>
                <c:pt idx="267">
                  <c:v>46.165509508896598</c:v>
                </c:pt>
                <c:pt idx="268">
                  <c:v>35.690449333470099</c:v>
                </c:pt>
                <c:pt idx="269">
                  <c:v>46.3249804570492</c:v>
                </c:pt>
                <c:pt idx="270">
                  <c:v>33.9560379101409</c:v>
                </c:pt>
                <c:pt idx="271">
                  <c:v>49.545776911544699</c:v>
                </c:pt>
                <c:pt idx="272">
                  <c:v>26.4420076281287</c:v>
                </c:pt>
                <c:pt idx="273">
                  <c:v>30.2167799143634</c:v>
                </c:pt>
                <c:pt idx="274">
                  <c:v>43.592750703921801</c:v>
                </c:pt>
                <c:pt idx="275">
                  <c:v>53.4758603247164</c:v>
                </c:pt>
                <c:pt idx="276">
                  <c:v>22.3291792094759</c:v>
                </c:pt>
                <c:pt idx="277">
                  <c:v>47.913339735762698</c:v>
                </c:pt>
                <c:pt idx="278">
                  <c:v>32.523862908257101</c:v>
                </c:pt>
                <c:pt idx="279">
                  <c:v>49.826631621428199</c:v>
                </c:pt>
                <c:pt idx="280">
                  <c:v>39.632259867137002</c:v>
                </c:pt>
                <c:pt idx="281">
                  <c:v>46.908841813640301</c:v>
                </c:pt>
                <c:pt idx="282">
                  <c:v>37.950618277758799</c:v>
                </c:pt>
                <c:pt idx="283">
                  <c:v>47.869321955591701</c:v>
                </c:pt>
                <c:pt idx="284">
                  <c:v>53.723128329695903</c:v>
                </c:pt>
                <c:pt idx="285">
                  <c:v>37.587808284270501</c:v>
                </c:pt>
                <c:pt idx="286">
                  <c:v>43.755192021213396</c:v>
                </c:pt>
                <c:pt idx="287">
                  <c:v>57.630049965241803</c:v>
                </c:pt>
                <c:pt idx="288">
                  <c:v>59.207370039188497</c:v>
                </c:pt>
                <c:pt idx="289">
                  <c:v>42.474669020738702</c:v>
                </c:pt>
                <c:pt idx="290">
                  <c:v>39.7095703342791</c:v>
                </c:pt>
                <c:pt idx="291">
                  <c:v>39.270721463663101</c:v>
                </c:pt>
              </c:numCache>
            </c:numRef>
          </c:xVal>
          <c:yVal>
            <c:numRef>
              <c:f>'292RILs'!$J$2:$J$293</c:f>
              <c:numCache>
                <c:formatCode>0.00</c:formatCode>
                <c:ptCount val="292"/>
                <c:pt idx="0">
                  <c:v>51.957344674538902</c:v>
                </c:pt>
                <c:pt idx="1">
                  <c:v>42.771643100609801</c:v>
                </c:pt>
                <c:pt idx="2">
                  <c:v>36.275734582754403</c:v>
                </c:pt>
                <c:pt idx="3">
                  <c:v>62.301912168801003</c:v>
                </c:pt>
                <c:pt idx="4">
                  <c:v>43.706431614574903</c:v>
                </c:pt>
                <c:pt idx="5">
                  <c:v>56.135867366873804</c:v>
                </c:pt>
                <c:pt idx="6">
                  <c:v>51.2944565960887</c:v>
                </c:pt>
                <c:pt idx="7">
                  <c:v>53.970787103864303</c:v>
                </c:pt>
                <c:pt idx="8">
                  <c:v>40.604188915017602</c:v>
                </c:pt>
                <c:pt idx="9">
                  <c:v>40.041307834199202</c:v>
                </c:pt>
                <c:pt idx="10">
                  <c:v>43.513287681726197</c:v>
                </c:pt>
                <c:pt idx="11">
                  <c:v>52.320438525230102</c:v>
                </c:pt>
                <c:pt idx="12">
                  <c:v>44.0640446264728</c:v>
                </c:pt>
                <c:pt idx="13">
                  <c:v>44.081247203647102</c:v>
                </c:pt>
                <c:pt idx="14">
                  <c:v>52.288865921826599</c:v>
                </c:pt>
                <c:pt idx="15">
                  <c:v>46.315033124096303</c:v>
                </c:pt>
                <c:pt idx="16">
                  <c:v>39.750668300323902</c:v>
                </c:pt>
                <c:pt idx="17">
                  <c:v>53.598909553703002</c:v>
                </c:pt>
                <c:pt idx="18">
                  <c:v>52.850468621291199</c:v>
                </c:pt>
                <c:pt idx="19">
                  <c:v>53.824491255124002</c:v>
                </c:pt>
                <c:pt idx="20">
                  <c:v>46.009881115306499</c:v>
                </c:pt>
                <c:pt idx="21">
                  <c:v>36.518496356028898</c:v>
                </c:pt>
                <c:pt idx="22">
                  <c:v>41.294593337536803</c:v>
                </c:pt>
                <c:pt idx="23">
                  <c:v>45.958022477564199</c:v>
                </c:pt>
                <c:pt idx="24">
                  <c:v>47.925405991737797</c:v>
                </c:pt>
                <c:pt idx="25">
                  <c:v>11.005013147725499</c:v>
                </c:pt>
                <c:pt idx="26">
                  <c:v>43.149014657858302</c:v>
                </c:pt>
                <c:pt idx="27">
                  <c:v>53.469521150627997</c:v>
                </c:pt>
                <c:pt idx="28">
                  <c:v>40.944698749079997</c:v>
                </c:pt>
                <c:pt idx="29">
                  <c:v>32.014345066134403</c:v>
                </c:pt>
                <c:pt idx="30">
                  <c:v>51.698314560610299</c:v>
                </c:pt>
                <c:pt idx="31">
                  <c:v>49.5472115631514</c:v>
                </c:pt>
                <c:pt idx="32">
                  <c:v>45.452687935141299</c:v>
                </c:pt>
                <c:pt idx="33">
                  <c:v>56.477835898016998</c:v>
                </c:pt>
                <c:pt idx="34">
                  <c:v>57.646610273687102</c:v>
                </c:pt>
                <c:pt idx="35">
                  <c:v>35.198572115527199</c:v>
                </c:pt>
                <c:pt idx="36">
                  <c:v>54.745406828150102</c:v>
                </c:pt>
                <c:pt idx="37">
                  <c:v>58.886155693562301</c:v>
                </c:pt>
                <c:pt idx="38">
                  <c:v>57.813059728038503</c:v>
                </c:pt>
                <c:pt idx="39">
                  <c:v>45.3360657903945</c:v>
                </c:pt>
                <c:pt idx="40">
                  <c:v>49.148935289332698</c:v>
                </c:pt>
                <c:pt idx="41">
                  <c:v>55.830019836239799</c:v>
                </c:pt>
                <c:pt idx="42">
                  <c:v>35.488658441692998</c:v>
                </c:pt>
                <c:pt idx="43">
                  <c:v>22.9230942592167</c:v>
                </c:pt>
                <c:pt idx="44">
                  <c:v>50.987414970437598</c:v>
                </c:pt>
                <c:pt idx="45">
                  <c:v>37.639477014459899</c:v>
                </c:pt>
                <c:pt idx="46">
                  <c:v>26.260706683640802</c:v>
                </c:pt>
                <c:pt idx="47">
                  <c:v>65.342128094534004</c:v>
                </c:pt>
                <c:pt idx="48">
                  <c:v>57.132777307313802</c:v>
                </c:pt>
                <c:pt idx="49">
                  <c:v>52.942317860753299</c:v>
                </c:pt>
                <c:pt idx="50">
                  <c:v>36.192499055746303</c:v>
                </c:pt>
                <c:pt idx="51">
                  <c:v>35.808306822742701</c:v>
                </c:pt>
                <c:pt idx="52">
                  <c:v>65.940997210174103</c:v>
                </c:pt>
                <c:pt idx="53">
                  <c:v>55.479718011180601</c:v>
                </c:pt>
                <c:pt idx="54">
                  <c:v>52.476360151777001</c:v>
                </c:pt>
                <c:pt idx="55">
                  <c:v>60.067806928850999</c:v>
                </c:pt>
                <c:pt idx="56">
                  <c:v>48.187534194490098</c:v>
                </c:pt>
                <c:pt idx="57">
                  <c:v>55.1249011884182</c:v>
                </c:pt>
                <c:pt idx="58">
                  <c:v>55.985237010011502</c:v>
                </c:pt>
                <c:pt idx="59">
                  <c:v>27.087416721333302</c:v>
                </c:pt>
                <c:pt idx="60">
                  <c:v>68.706426638715897</c:v>
                </c:pt>
                <c:pt idx="61">
                  <c:v>46.287502298341401</c:v>
                </c:pt>
                <c:pt idx="62">
                  <c:v>45.557343681110197</c:v>
                </c:pt>
                <c:pt idx="63">
                  <c:v>26.2363858130403</c:v>
                </c:pt>
                <c:pt idx="64">
                  <c:v>55.0889600719618</c:v>
                </c:pt>
                <c:pt idx="65">
                  <c:v>52.524908477023502</c:v>
                </c:pt>
                <c:pt idx="66">
                  <c:v>37.279506690300302</c:v>
                </c:pt>
                <c:pt idx="67">
                  <c:v>37.280760875793298</c:v>
                </c:pt>
                <c:pt idx="68">
                  <c:v>36.513203740657502</c:v>
                </c:pt>
                <c:pt idx="69">
                  <c:v>51.499183753849202</c:v>
                </c:pt>
                <c:pt idx="70">
                  <c:v>29.989878195759399</c:v>
                </c:pt>
                <c:pt idx="71">
                  <c:v>30.264070948353002</c:v>
                </c:pt>
                <c:pt idx="72">
                  <c:v>44.420751026515298</c:v>
                </c:pt>
                <c:pt idx="73">
                  <c:v>41.204080758129301</c:v>
                </c:pt>
                <c:pt idx="74">
                  <c:v>91.606073652148197</c:v>
                </c:pt>
                <c:pt idx="75">
                  <c:v>51.4538919554142</c:v>
                </c:pt>
                <c:pt idx="76">
                  <c:v>52.257724782601699</c:v>
                </c:pt>
                <c:pt idx="77">
                  <c:v>41.883586558693402</c:v>
                </c:pt>
                <c:pt idx="78">
                  <c:v>55.985770233278103</c:v>
                </c:pt>
                <c:pt idx="79">
                  <c:v>34.834295964417201</c:v>
                </c:pt>
                <c:pt idx="80">
                  <c:v>36.450295257813103</c:v>
                </c:pt>
                <c:pt idx="81">
                  <c:v>60.367729123519702</c:v>
                </c:pt>
                <c:pt idx="82">
                  <c:v>32.833699196186501</c:v>
                </c:pt>
                <c:pt idx="83">
                  <c:v>55.1766964575895</c:v>
                </c:pt>
                <c:pt idx="84">
                  <c:v>60.788045673866797</c:v>
                </c:pt>
                <c:pt idx="85">
                  <c:v>44.021895952107599</c:v>
                </c:pt>
                <c:pt idx="86">
                  <c:v>39.662430744794896</c:v>
                </c:pt>
                <c:pt idx="87">
                  <c:v>42.157074676474203</c:v>
                </c:pt>
                <c:pt idx="88">
                  <c:v>43.820711719690799</c:v>
                </c:pt>
                <c:pt idx="89">
                  <c:v>33.451728178817397</c:v>
                </c:pt>
                <c:pt idx="90">
                  <c:v>57.561746528463701</c:v>
                </c:pt>
                <c:pt idx="91">
                  <c:v>51.712057837297202</c:v>
                </c:pt>
                <c:pt idx="92">
                  <c:v>43.956505956896898</c:v>
                </c:pt>
                <c:pt idx="93">
                  <c:v>51.491973636038999</c:v>
                </c:pt>
                <c:pt idx="94">
                  <c:v>51.1557460392157</c:v>
                </c:pt>
                <c:pt idx="95">
                  <c:v>41.3552172189655</c:v>
                </c:pt>
                <c:pt idx="96">
                  <c:v>55.837959642689398</c:v>
                </c:pt>
                <c:pt idx="97">
                  <c:v>53.100681114625203</c:v>
                </c:pt>
                <c:pt idx="98">
                  <c:v>48.851892450463502</c:v>
                </c:pt>
                <c:pt idx="99">
                  <c:v>47.014493453573699</c:v>
                </c:pt>
                <c:pt idx="100">
                  <c:v>57.709021870382799</c:v>
                </c:pt>
                <c:pt idx="101">
                  <c:v>50.382026362019197</c:v>
                </c:pt>
                <c:pt idx="102">
                  <c:v>54.301830040616103</c:v>
                </c:pt>
                <c:pt idx="103">
                  <c:v>53.3092043057109</c:v>
                </c:pt>
                <c:pt idx="104">
                  <c:v>57.380538514855701</c:v>
                </c:pt>
                <c:pt idx="105">
                  <c:v>50.653768749940497</c:v>
                </c:pt>
                <c:pt idx="106">
                  <c:v>58.1498290470239</c:v>
                </c:pt>
                <c:pt idx="107">
                  <c:v>55.144211539154099</c:v>
                </c:pt>
                <c:pt idx="108">
                  <c:v>47.268708965696398</c:v>
                </c:pt>
                <c:pt idx="109">
                  <c:v>60.554003979487398</c:v>
                </c:pt>
                <c:pt idx="110">
                  <c:v>58.029094726566001</c:v>
                </c:pt>
                <c:pt idx="111">
                  <c:v>46.511996841510602</c:v>
                </c:pt>
                <c:pt idx="112">
                  <c:v>53.983375533290101</c:v>
                </c:pt>
                <c:pt idx="113">
                  <c:v>55.984390680700997</c:v>
                </c:pt>
                <c:pt idx="114">
                  <c:v>38.2669073819592</c:v>
                </c:pt>
                <c:pt idx="115">
                  <c:v>62.872046583534299</c:v>
                </c:pt>
                <c:pt idx="116">
                  <c:v>47.833191000408902</c:v>
                </c:pt>
                <c:pt idx="117">
                  <c:v>35.479141377455498</c:v>
                </c:pt>
                <c:pt idx="118">
                  <c:v>38.5450316088642</c:v>
                </c:pt>
                <c:pt idx="119">
                  <c:v>36.593646739771501</c:v>
                </c:pt>
                <c:pt idx="120">
                  <c:v>50.675617729720898</c:v>
                </c:pt>
                <c:pt idx="121">
                  <c:v>47.875000223918597</c:v>
                </c:pt>
                <c:pt idx="122">
                  <c:v>46.497694145880601</c:v>
                </c:pt>
                <c:pt idx="123">
                  <c:v>67.381201316268104</c:v>
                </c:pt>
                <c:pt idx="124">
                  <c:v>50.203723995422997</c:v>
                </c:pt>
                <c:pt idx="125">
                  <c:v>50.182298367662099</c:v>
                </c:pt>
                <c:pt idx="126">
                  <c:v>51.734990809434898</c:v>
                </c:pt>
                <c:pt idx="127">
                  <c:v>59.143708578343798</c:v>
                </c:pt>
                <c:pt idx="128">
                  <c:v>68.750486625857206</c:v>
                </c:pt>
                <c:pt idx="129">
                  <c:v>59.730723265990797</c:v>
                </c:pt>
                <c:pt idx="130">
                  <c:v>64.000037661753694</c:v>
                </c:pt>
                <c:pt idx="131">
                  <c:v>52.9300700683389</c:v>
                </c:pt>
                <c:pt idx="132">
                  <c:v>54.107976589964501</c:v>
                </c:pt>
                <c:pt idx="133">
                  <c:v>43.3712740744242</c:v>
                </c:pt>
                <c:pt idx="134">
                  <c:v>62.252320503296303</c:v>
                </c:pt>
                <c:pt idx="135">
                  <c:v>59.062773152919497</c:v>
                </c:pt>
                <c:pt idx="136">
                  <c:v>41.451976885765703</c:v>
                </c:pt>
                <c:pt idx="137">
                  <c:v>52.280663841156503</c:v>
                </c:pt>
                <c:pt idx="138">
                  <c:v>38.817761873689697</c:v>
                </c:pt>
                <c:pt idx="139">
                  <c:v>49.953092689133101</c:v>
                </c:pt>
                <c:pt idx="140">
                  <c:v>50.7901054259708</c:v>
                </c:pt>
                <c:pt idx="141">
                  <c:v>46.897362993995799</c:v>
                </c:pt>
                <c:pt idx="142">
                  <c:v>38.013117875310698</c:v>
                </c:pt>
                <c:pt idx="143">
                  <c:v>52.1830017744957</c:v>
                </c:pt>
                <c:pt idx="144">
                  <c:v>52.597014964985704</c:v>
                </c:pt>
                <c:pt idx="145">
                  <c:v>51.228540371538401</c:v>
                </c:pt>
                <c:pt idx="146">
                  <c:v>59.6015498963041</c:v>
                </c:pt>
                <c:pt idx="147">
                  <c:v>51.294137732436198</c:v>
                </c:pt>
                <c:pt idx="148">
                  <c:v>42.745771414567301</c:v>
                </c:pt>
                <c:pt idx="149">
                  <c:v>55.986942966754498</c:v>
                </c:pt>
                <c:pt idx="150">
                  <c:v>68.5858939747541</c:v>
                </c:pt>
                <c:pt idx="151">
                  <c:v>64.120231987433499</c:v>
                </c:pt>
                <c:pt idx="152">
                  <c:v>62.066579838241402</c:v>
                </c:pt>
                <c:pt idx="153">
                  <c:v>38.2099764799759</c:v>
                </c:pt>
                <c:pt idx="154">
                  <c:v>43.378614547410002</c:v>
                </c:pt>
                <c:pt idx="155">
                  <c:v>48.341167101290402</c:v>
                </c:pt>
                <c:pt idx="156">
                  <c:v>40.008305594520202</c:v>
                </c:pt>
                <c:pt idx="157">
                  <c:v>43.104513676037897</c:v>
                </c:pt>
                <c:pt idx="158">
                  <c:v>58.591407897853898</c:v>
                </c:pt>
                <c:pt idx="159">
                  <c:v>57.239472366260102</c:v>
                </c:pt>
                <c:pt idx="160">
                  <c:v>66.417619158143197</c:v>
                </c:pt>
                <c:pt idx="161">
                  <c:v>41.839510105909604</c:v>
                </c:pt>
                <c:pt idx="162">
                  <c:v>57.705600040980499</c:v>
                </c:pt>
                <c:pt idx="163">
                  <c:v>71.845330696863002</c:v>
                </c:pt>
                <c:pt idx="164">
                  <c:v>69.687445028667597</c:v>
                </c:pt>
                <c:pt idx="165">
                  <c:v>57.628070525103603</c:v>
                </c:pt>
                <c:pt idx="166">
                  <c:v>53.7801555564334</c:v>
                </c:pt>
                <c:pt idx="167">
                  <c:v>34.021865571547401</c:v>
                </c:pt>
                <c:pt idx="168">
                  <c:v>56.269201505416198</c:v>
                </c:pt>
                <c:pt idx="169">
                  <c:v>36.615026128511403</c:v>
                </c:pt>
                <c:pt idx="170">
                  <c:v>44.374492462144701</c:v>
                </c:pt>
                <c:pt idx="171">
                  <c:v>54.861530760228099</c:v>
                </c:pt>
                <c:pt idx="172">
                  <c:v>46.5924667383848</c:v>
                </c:pt>
                <c:pt idx="173">
                  <c:v>44.863214228609699</c:v>
                </c:pt>
                <c:pt idx="174">
                  <c:v>69.294002741893394</c:v>
                </c:pt>
                <c:pt idx="175">
                  <c:v>48.330419402011003</c:v>
                </c:pt>
                <c:pt idx="176">
                  <c:v>37.201799069606103</c:v>
                </c:pt>
                <c:pt idx="177">
                  <c:v>63.062625034976399</c:v>
                </c:pt>
                <c:pt idx="178">
                  <c:v>46.196775303214899</c:v>
                </c:pt>
                <c:pt idx="179">
                  <c:v>54.595542182999097</c:v>
                </c:pt>
                <c:pt idx="180">
                  <c:v>49.2358465934851</c:v>
                </c:pt>
                <c:pt idx="181">
                  <c:v>36.282900669287102</c:v>
                </c:pt>
                <c:pt idx="182">
                  <c:v>62.725846417218897</c:v>
                </c:pt>
                <c:pt idx="183">
                  <c:v>25.286174962320001</c:v>
                </c:pt>
                <c:pt idx="184">
                  <c:v>48.119021013053498</c:v>
                </c:pt>
                <c:pt idx="185">
                  <c:v>41.305029796026403</c:v>
                </c:pt>
                <c:pt idx="186">
                  <c:v>51.222140684092999</c:v>
                </c:pt>
                <c:pt idx="187">
                  <c:v>63.082843542471203</c:v>
                </c:pt>
                <c:pt idx="188">
                  <c:v>54.110998416685099</c:v>
                </c:pt>
                <c:pt idx="189">
                  <c:v>54.358045881792201</c:v>
                </c:pt>
                <c:pt idx="190">
                  <c:v>59.896159216009401</c:v>
                </c:pt>
                <c:pt idx="191">
                  <c:v>49.364997188090001</c:v>
                </c:pt>
                <c:pt idx="192">
                  <c:v>82.533111474886397</c:v>
                </c:pt>
                <c:pt idx="193">
                  <c:v>42.6963995207186</c:v>
                </c:pt>
                <c:pt idx="194">
                  <c:v>46.9318982879632</c:v>
                </c:pt>
                <c:pt idx="195">
                  <c:v>42.747116778246799</c:v>
                </c:pt>
                <c:pt idx="196">
                  <c:v>55.968275870753601</c:v>
                </c:pt>
                <c:pt idx="197">
                  <c:v>51.357750183771103</c:v>
                </c:pt>
                <c:pt idx="198">
                  <c:v>50.940698079266902</c:v>
                </c:pt>
                <c:pt idx="199">
                  <c:v>61.2426488489942</c:v>
                </c:pt>
                <c:pt idx="200">
                  <c:v>25.739404860154099</c:v>
                </c:pt>
                <c:pt idx="201">
                  <c:v>60.9526189518593</c:v>
                </c:pt>
                <c:pt idx="202">
                  <c:v>50.786478976156197</c:v>
                </c:pt>
                <c:pt idx="203">
                  <c:v>42.945633911629898</c:v>
                </c:pt>
                <c:pt idx="204">
                  <c:v>48.424983749691101</c:v>
                </c:pt>
                <c:pt idx="205">
                  <c:v>27.0795983767667</c:v>
                </c:pt>
                <c:pt idx="206">
                  <c:v>66.945208395021297</c:v>
                </c:pt>
                <c:pt idx="207">
                  <c:v>32.030996054648199</c:v>
                </c:pt>
                <c:pt idx="208">
                  <c:v>62.1833689373765</c:v>
                </c:pt>
                <c:pt idx="209">
                  <c:v>53.555277533638801</c:v>
                </c:pt>
                <c:pt idx="210">
                  <c:v>61.025117851253697</c:v>
                </c:pt>
                <c:pt idx="211">
                  <c:v>53.663313012231399</c:v>
                </c:pt>
                <c:pt idx="212">
                  <c:v>63.266373805367003</c:v>
                </c:pt>
                <c:pt idx="213">
                  <c:v>43.355905393436402</c:v>
                </c:pt>
                <c:pt idx="214">
                  <c:v>51.513445023945202</c:v>
                </c:pt>
                <c:pt idx="215">
                  <c:v>49.025746960379401</c:v>
                </c:pt>
                <c:pt idx="216">
                  <c:v>35.975434560650001</c:v>
                </c:pt>
                <c:pt idx="217">
                  <c:v>32.4970642059738</c:v>
                </c:pt>
                <c:pt idx="218">
                  <c:v>41.959738029905999</c:v>
                </c:pt>
                <c:pt idx="219">
                  <c:v>51.2277874025201</c:v>
                </c:pt>
                <c:pt idx="220">
                  <c:v>32.874929237867001</c:v>
                </c:pt>
                <c:pt idx="221">
                  <c:v>48.623699333613899</c:v>
                </c:pt>
                <c:pt idx="222">
                  <c:v>53.533519025555499</c:v>
                </c:pt>
                <c:pt idx="223">
                  <c:v>44.449269643087497</c:v>
                </c:pt>
                <c:pt idx="224">
                  <c:v>50.849719417562603</c:v>
                </c:pt>
                <c:pt idx="225">
                  <c:v>58.928301624837601</c:v>
                </c:pt>
                <c:pt idx="226">
                  <c:v>39.294943278619499</c:v>
                </c:pt>
                <c:pt idx="227">
                  <c:v>33.929453335607903</c:v>
                </c:pt>
                <c:pt idx="228">
                  <c:v>47.438050852109498</c:v>
                </c:pt>
                <c:pt idx="229">
                  <c:v>55.321545316568702</c:v>
                </c:pt>
                <c:pt idx="230">
                  <c:v>62.260278560113598</c:v>
                </c:pt>
                <c:pt idx="231">
                  <c:v>37.062101176065603</c:v>
                </c:pt>
                <c:pt idx="232">
                  <c:v>41.359821991464798</c:v>
                </c:pt>
                <c:pt idx="233">
                  <c:v>51.830368230334201</c:v>
                </c:pt>
                <c:pt idx="234">
                  <c:v>60.367057698531099</c:v>
                </c:pt>
                <c:pt idx="235">
                  <c:v>30.783667680638601</c:v>
                </c:pt>
                <c:pt idx="236">
                  <c:v>36.231173253873898</c:v>
                </c:pt>
                <c:pt idx="237">
                  <c:v>46.512719917005697</c:v>
                </c:pt>
                <c:pt idx="238">
                  <c:v>57.549866119129703</c:v>
                </c:pt>
                <c:pt idx="239">
                  <c:v>32.4983583597784</c:v>
                </c:pt>
                <c:pt idx="240">
                  <c:v>43.859049306681797</c:v>
                </c:pt>
                <c:pt idx="241">
                  <c:v>46.362084104648403</c:v>
                </c:pt>
                <c:pt idx="242">
                  <c:v>50.970601809431798</c:v>
                </c:pt>
                <c:pt idx="243">
                  <c:v>54.993363155662898</c:v>
                </c:pt>
                <c:pt idx="244">
                  <c:v>36.445739115191301</c:v>
                </c:pt>
                <c:pt idx="245">
                  <c:v>52.527213569949502</c:v>
                </c:pt>
                <c:pt idx="246">
                  <c:v>47.504516517108797</c:v>
                </c:pt>
                <c:pt idx="247">
                  <c:v>19.642799027984001</c:v>
                </c:pt>
                <c:pt idx="248">
                  <c:v>55.527124698879703</c:v>
                </c:pt>
                <c:pt idx="249">
                  <c:v>45.400957699525499</c:v>
                </c:pt>
                <c:pt idx="250">
                  <c:v>43.650952962151202</c:v>
                </c:pt>
                <c:pt idx="251">
                  <c:v>41.741460252751999</c:v>
                </c:pt>
                <c:pt idx="252">
                  <c:v>45.835141100735697</c:v>
                </c:pt>
                <c:pt idx="253">
                  <c:v>57.623130586868598</c:v>
                </c:pt>
                <c:pt idx="254">
                  <c:v>80.227205535190393</c:v>
                </c:pt>
                <c:pt idx="255">
                  <c:v>32.2910221023376</c:v>
                </c:pt>
                <c:pt idx="256">
                  <c:v>49.144646510577097</c:v>
                </c:pt>
                <c:pt idx="257">
                  <c:v>53.382074849850603</c:v>
                </c:pt>
                <c:pt idx="258">
                  <c:v>65.567685423797101</c:v>
                </c:pt>
                <c:pt idx="259">
                  <c:v>46.020502168840899</c:v>
                </c:pt>
                <c:pt idx="260">
                  <c:v>54.7613336219788</c:v>
                </c:pt>
                <c:pt idx="261">
                  <c:v>36.6812974237479</c:v>
                </c:pt>
                <c:pt idx="262">
                  <c:v>42.3206720500337</c:v>
                </c:pt>
                <c:pt idx="263">
                  <c:v>43.925047381836599</c:v>
                </c:pt>
                <c:pt idx="264">
                  <c:v>37.7859462132636</c:v>
                </c:pt>
                <c:pt idx="265">
                  <c:v>53.662456086035199</c:v>
                </c:pt>
                <c:pt idx="266">
                  <c:v>46.557322110846997</c:v>
                </c:pt>
                <c:pt idx="267">
                  <c:v>52.240147855931099</c:v>
                </c:pt>
                <c:pt idx="268">
                  <c:v>39.062826890898897</c:v>
                </c:pt>
                <c:pt idx="269">
                  <c:v>49.842999619024198</c:v>
                </c:pt>
                <c:pt idx="270">
                  <c:v>34.491414720439998</c:v>
                </c:pt>
                <c:pt idx="271">
                  <c:v>61.312921522282302</c:v>
                </c:pt>
                <c:pt idx="272">
                  <c:v>30.5539452250881</c:v>
                </c:pt>
                <c:pt idx="273">
                  <c:v>47.6389141568471</c:v>
                </c:pt>
                <c:pt idx="274">
                  <c:v>62.1950448361805</c:v>
                </c:pt>
                <c:pt idx="275">
                  <c:v>61.710498221314403</c:v>
                </c:pt>
                <c:pt idx="276">
                  <c:v>28.501742895187899</c:v>
                </c:pt>
                <c:pt idx="277">
                  <c:v>53.607976319671202</c:v>
                </c:pt>
                <c:pt idx="278">
                  <c:v>47.8683696575212</c:v>
                </c:pt>
                <c:pt idx="279">
                  <c:v>52.196696624883799</c:v>
                </c:pt>
                <c:pt idx="280">
                  <c:v>48.187934864054803</c:v>
                </c:pt>
                <c:pt idx="281">
                  <c:v>61.843450770241297</c:v>
                </c:pt>
                <c:pt idx="282">
                  <c:v>47.453440566848499</c:v>
                </c:pt>
                <c:pt idx="283">
                  <c:v>43.272571874250403</c:v>
                </c:pt>
                <c:pt idx="284">
                  <c:v>52.718433909246002</c:v>
                </c:pt>
                <c:pt idx="285">
                  <c:v>53.050669869240501</c:v>
                </c:pt>
                <c:pt idx="286">
                  <c:v>37.665440132271698</c:v>
                </c:pt>
                <c:pt idx="287">
                  <c:v>68.231226071423905</c:v>
                </c:pt>
                <c:pt idx="288">
                  <c:v>51.8371752561563</c:v>
                </c:pt>
                <c:pt idx="289">
                  <c:v>58.683164422586302</c:v>
                </c:pt>
                <c:pt idx="290">
                  <c:v>52.136219041930502</c:v>
                </c:pt>
                <c:pt idx="291">
                  <c:v>50.7542158979911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117-4195-86AA-47009F5072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1129648"/>
        <c:axId val="1242913664"/>
      </c:scatterChart>
      <c:valAx>
        <c:axId val="124112964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42913664"/>
        <c:crosses val="autoZero"/>
        <c:crossBetween val="midCat"/>
      </c:valAx>
      <c:valAx>
        <c:axId val="12429136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4112964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en-US" sz="2000" b="0" i="0" u="none" strike="noStrike" kern="1200" spc="70" baseline="0">
                <a:solidFill>
                  <a:prstClr val="black">
                    <a:lumMod val="50000"/>
                    <a:lumOff val="50000"/>
                  </a:prst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2000" b="1" i="0" u="none" strike="noStrike" kern="1200" spc="70" baseline="0" dirty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%PodSet-GY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en-US" sz="2000" b="0" i="0" u="none" strike="noStrike" kern="1200" spc="70" baseline="0">
              <a:solidFill>
                <a:prstClr val="black">
                  <a:lumMod val="50000"/>
                  <a:lumOff val="50000"/>
                </a:prst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292RILs'!$J$1</c:f>
              <c:strCache>
                <c:ptCount val="1"/>
                <c:pt idx="0">
                  <c:v>GY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13228864093343759"/>
                  <c:y val="-0.34859871682706328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 algn="ctr" rtl="0">
                      <a:defRPr lang="en-US" sz="1197" b="0" i="0" u="none" strike="noStrike" kern="1200" baseline="0">
                        <a:solidFill>
                          <a:prstClr val="black">
                            <a:lumMod val="50000"/>
                            <a:lumOff val="50000"/>
                          </a:prst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y = 0.6272x + 24.917</a:t>
                    </a:r>
                    <a:b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</a:br>
                    <a:r>
                      <a:rPr lang="en-US" sz="1197" b="1" i="0" u="none" strike="noStrike" kern="12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R² = 0.2586</a:t>
                    </a: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 algn="ctr" rtl="0">
                    <a:defRPr lang="en-US" sz="1197" b="0" i="0" u="none" strike="noStrike" kern="1200" baseline="0">
                      <a:solidFill>
                        <a:prstClr val="black">
                          <a:lumMod val="50000"/>
                          <a:lumOff val="50000"/>
                        </a:prst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'292RILs'!$I$2:$I$293</c:f>
              <c:numCache>
                <c:formatCode>0.00</c:formatCode>
                <c:ptCount val="292"/>
                <c:pt idx="0">
                  <c:v>36.482600000000005</c:v>
                </c:pt>
                <c:pt idx="1">
                  <c:v>40.106500000000004</c:v>
                </c:pt>
                <c:pt idx="2">
                  <c:v>35.777200000000001</c:v>
                </c:pt>
                <c:pt idx="3">
                  <c:v>54.180100000000003</c:v>
                </c:pt>
                <c:pt idx="4">
                  <c:v>51.550600000000003</c:v>
                </c:pt>
                <c:pt idx="5">
                  <c:v>46.252200000000002</c:v>
                </c:pt>
                <c:pt idx="6">
                  <c:v>44.690899999999999</c:v>
                </c:pt>
                <c:pt idx="7">
                  <c:v>45.823700000000002</c:v>
                </c:pt>
                <c:pt idx="8">
                  <c:v>25.070600000000002</c:v>
                </c:pt>
                <c:pt idx="9">
                  <c:v>36.789400000000001</c:v>
                </c:pt>
                <c:pt idx="10">
                  <c:v>30.1235</c:v>
                </c:pt>
                <c:pt idx="11">
                  <c:v>38.068899999999999</c:v>
                </c:pt>
                <c:pt idx="12">
                  <c:v>32.995000000000005</c:v>
                </c:pt>
                <c:pt idx="13">
                  <c:v>40.690899999999999</c:v>
                </c:pt>
                <c:pt idx="14">
                  <c:v>38.445</c:v>
                </c:pt>
                <c:pt idx="15">
                  <c:v>36.637900000000002</c:v>
                </c:pt>
                <c:pt idx="16">
                  <c:v>33.103700000000003</c:v>
                </c:pt>
                <c:pt idx="17">
                  <c:v>50.810600000000001</c:v>
                </c:pt>
                <c:pt idx="18">
                  <c:v>40.036100000000005</c:v>
                </c:pt>
                <c:pt idx="19">
                  <c:v>46.213100000000004</c:v>
                </c:pt>
                <c:pt idx="20">
                  <c:v>38.459499999999998</c:v>
                </c:pt>
                <c:pt idx="21">
                  <c:v>31.139700000000001</c:v>
                </c:pt>
                <c:pt idx="22">
                  <c:v>43.161999999999999</c:v>
                </c:pt>
                <c:pt idx="23">
                  <c:v>38.238550000000004</c:v>
                </c:pt>
                <c:pt idx="24">
                  <c:v>36.560500000000005</c:v>
                </c:pt>
                <c:pt idx="25">
                  <c:v>5.7897000000000034</c:v>
                </c:pt>
                <c:pt idx="26">
                  <c:v>43.294000000000004</c:v>
                </c:pt>
                <c:pt idx="27">
                  <c:v>34.926300000000005</c:v>
                </c:pt>
                <c:pt idx="28">
                  <c:v>42.927</c:v>
                </c:pt>
                <c:pt idx="29">
                  <c:v>29.749900000000004</c:v>
                </c:pt>
                <c:pt idx="30">
                  <c:v>38.492600000000003</c:v>
                </c:pt>
                <c:pt idx="31">
                  <c:v>45.0655</c:v>
                </c:pt>
                <c:pt idx="32">
                  <c:v>42.626200000000004</c:v>
                </c:pt>
                <c:pt idx="33">
                  <c:v>53.847900000000003</c:v>
                </c:pt>
                <c:pt idx="34">
                  <c:v>48.855400000000003</c:v>
                </c:pt>
                <c:pt idx="35">
                  <c:v>24.688100000000002</c:v>
                </c:pt>
                <c:pt idx="36">
                  <c:v>34.976300000000002</c:v>
                </c:pt>
                <c:pt idx="37">
                  <c:v>40.647500000000001</c:v>
                </c:pt>
                <c:pt idx="38">
                  <c:v>40.2119</c:v>
                </c:pt>
                <c:pt idx="39">
                  <c:v>60.717600000000004</c:v>
                </c:pt>
                <c:pt idx="40">
                  <c:v>49.828900000000004</c:v>
                </c:pt>
                <c:pt idx="41">
                  <c:v>47.318300000000001</c:v>
                </c:pt>
                <c:pt idx="42">
                  <c:v>34.040400000000005</c:v>
                </c:pt>
                <c:pt idx="43">
                  <c:v>25.878900000000002</c:v>
                </c:pt>
                <c:pt idx="44">
                  <c:v>38.421199999999999</c:v>
                </c:pt>
                <c:pt idx="45">
                  <c:v>27.664300000000004</c:v>
                </c:pt>
                <c:pt idx="46">
                  <c:v>20.7621</c:v>
                </c:pt>
                <c:pt idx="47">
                  <c:v>43.532499999999999</c:v>
                </c:pt>
                <c:pt idx="48">
                  <c:v>44.072400000000002</c:v>
                </c:pt>
                <c:pt idx="49">
                  <c:v>31.616800000000001</c:v>
                </c:pt>
                <c:pt idx="50">
                  <c:v>41.288600000000002</c:v>
                </c:pt>
                <c:pt idx="51">
                  <c:v>25.9285</c:v>
                </c:pt>
                <c:pt idx="52">
                  <c:v>43.858800000000002</c:v>
                </c:pt>
                <c:pt idx="53">
                  <c:v>46.290100000000002</c:v>
                </c:pt>
                <c:pt idx="54">
                  <c:v>47.714800000000004</c:v>
                </c:pt>
                <c:pt idx="55">
                  <c:v>44.849000000000004</c:v>
                </c:pt>
                <c:pt idx="56">
                  <c:v>50.086399999999998</c:v>
                </c:pt>
                <c:pt idx="57">
                  <c:v>39.059400000000004</c:v>
                </c:pt>
                <c:pt idx="58">
                  <c:v>38.129400000000004</c:v>
                </c:pt>
                <c:pt idx="59">
                  <c:v>21.4953</c:v>
                </c:pt>
                <c:pt idx="60">
                  <c:v>61.6477</c:v>
                </c:pt>
                <c:pt idx="61">
                  <c:v>30.389400000000002</c:v>
                </c:pt>
                <c:pt idx="62">
                  <c:v>24.5443</c:v>
                </c:pt>
                <c:pt idx="63">
                  <c:v>22.754100000000001</c:v>
                </c:pt>
                <c:pt idx="64">
                  <c:v>39.054500000000004</c:v>
                </c:pt>
                <c:pt idx="65">
                  <c:v>38.523800000000001</c:v>
                </c:pt>
                <c:pt idx="66">
                  <c:v>38.412600000000005</c:v>
                </c:pt>
                <c:pt idx="67">
                  <c:v>39.130500000000005</c:v>
                </c:pt>
                <c:pt idx="68">
                  <c:v>20.560300000000002</c:v>
                </c:pt>
                <c:pt idx="69">
                  <c:v>32.285400000000003</c:v>
                </c:pt>
                <c:pt idx="70">
                  <c:v>18.407300000000003</c:v>
                </c:pt>
                <c:pt idx="71">
                  <c:v>38.874099999999999</c:v>
                </c:pt>
                <c:pt idx="72">
                  <c:v>44.672699999999999</c:v>
                </c:pt>
                <c:pt idx="73">
                  <c:v>40.879100000000001</c:v>
                </c:pt>
                <c:pt idx="74">
                  <c:v>51.854600000000005</c:v>
                </c:pt>
                <c:pt idx="75">
                  <c:v>24.637300000000003</c:v>
                </c:pt>
                <c:pt idx="76">
                  <c:v>49.841800000000006</c:v>
                </c:pt>
                <c:pt idx="77">
                  <c:v>51.310200000000002</c:v>
                </c:pt>
                <c:pt idx="78">
                  <c:v>34.962700000000005</c:v>
                </c:pt>
                <c:pt idx="79">
                  <c:v>33.213900000000002</c:v>
                </c:pt>
                <c:pt idx="80">
                  <c:v>43.806100000000001</c:v>
                </c:pt>
                <c:pt idx="81">
                  <c:v>39.6233</c:v>
                </c:pt>
                <c:pt idx="82">
                  <c:v>28.633600000000001</c:v>
                </c:pt>
                <c:pt idx="83">
                  <c:v>40.554500000000004</c:v>
                </c:pt>
                <c:pt idx="84">
                  <c:v>31.986600000000003</c:v>
                </c:pt>
                <c:pt idx="85">
                  <c:v>25.928800000000003</c:v>
                </c:pt>
                <c:pt idx="86">
                  <c:v>24.611400000000003</c:v>
                </c:pt>
                <c:pt idx="87">
                  <c:v>24.238100000000003</c:v>
                </c:pt>
                <c:pt idx="88">
                  <c:v>29.074400000000004</c:v>
                </c:pt>
                <c:pt idx="89">
                  <c:v>33.757899999999999</c:v>
                </c:pt>
                <c:pt idx="90">
                  <c:v>41.948500000000003</c:v>
                </c:pt>
                <c:pt idx="91">
                  <c:v>43.253300000000003</c:v>
                </c:pt>
                <c:pt idx="92">
                  <c:v>27.175800000000002</c:v>
                </c:pt>
                <c:pt idx="93">
                  <c:v>29.643500000000003</c:v>
                </c:pt>
                <c:pt idx="94">
                  <c:v>31.178600000000003</c:v>
                </c:pt>
                <c:pt idx="95">
                  <c:v>22.145100000000003</c:v>
                </c:pt>
                <c:pt idx="96">
                  <c:v>29.3093</c:v>
                </c:pt>
                <c:pt idx="97">
                  <c:v>39.173200000000001</c:v>
                </c:pt>
                <c:pt idx="98">
                  <c:v>43.417700000000004</c:v>
                </c:pt>
                <c:pt idx="99">
                  <c:v>34.906100000000002</c:v>
                </c:pt>
                <c:pt idx="100">
                  <c:v>37.279299999999999</c:v>
                </c:pt>
                <c:pt idx="101">
                  <c:v>39.616800000000005</c:v>
                </c:pt>
                <c:pt idx="102">
                  <c:v>41.691900000000004</c:v>
                </c:pt>
                <c:pt idx="103">
                  <c:v>26.176300000000001</c:v>
                </c:pt>
                <c:pt idx="104">
                  <c:v>32.884700000000002</c:v>
                </c:pt>
                <c:pt idx="105">
                  <c:v>45.736200000000004</c:v>
                </c:pt>
                <c:pt idx="106">
                  <c:v>45.676500000000004</c:v>
                </c:pt>
                <c:pt idx="107">
                  <c:v>46.662000000000006</c:v>
                </c:pt>
                <c:pt idx="108">
                  <c:v>33.496900000000004</c:v>
                </c:pt>
                <c:pt idx="109">
                  <c:v>34.6554</c:v>
                </c:pt>
                <c:pt idx="110">
                  <c:v>54.437600000000003</c:v>
                </c:pt>
                <c:pt idx="111">
                  <c:v>26.428900000000002</c:v>
                </c:pt>
                <c:pt idx="112">
                  <c:v>21.683000000000003</c:v>
                </c:pt>
                <c:pt idx="113">
                  <c:v>51.626100000000001</c:v>
                </c:pt>
                <c:pt idx="114">
                  <c:v>33.932000000000002</c:v>
                </c:pt>
                <c:pt idx="115">
                  <c:v>48.916800000000002</c:v>
                </c:pt>
                <c:pt idx="116">
                  <c:v>40.193100000000001</c:v>
                </c:pt>
                <c:pt idx="117">
                  <c:v>29.1265</c:v>
                </c:pt>
                <c:pt idx="118">
                  <c:v>50.357800000000005</c:v>
                </c:pt>
                <c:pt idx="119">
                  <c:v>23.587400000000002</c:v>
                </c:pt>
                <c:pt idx="120">
                  <c:v>34.180199999999999</c:v>
                </c:pt>
                <c:pt idx="121">
                  <c:v>31.656800000000004</c:v>
                </c:pt>
                <c:pt idx="122">
                  <c:v>44.658900000000003</c:v>
                </c:pt>
                <c:pt idx="123">
                  <c:v>37.630800000000001</c:v>
                </c:pt>
                <c:pt idx="124">
                  <c:v>51.240099999999998</c:v>
                </c:pt>
                <c:pt idx="125">
                  <c:v>39.976700000000001</c:v>
                </c:pt>
                <c:pt idx="126">
                  <c:v>43.869700000000002</c:v>
                </c:pt>
                <c:pt idx="127">
                  <c:v>49.627900000000004</c:v>
                </c:pt>
                <c:pt idx="128">
                  <c:v>43.5244</c:v>
                </c:pt>
                <c:pt idx="129">
                  <c:v>48.86</c:v>
                </c:pt>
                <c:pt idx="130">
                  <c:v>41.489000000000004</c:v>
                </c:pt>
                <c:pt idx="131">
                  <c:v>41.6813</c:v>
                </c:pt>
                <c:pt idx="132">
                  <c:v>45.195900000000002</c:v>
                </c:pt>
                <c:pt idx="133">
                  <c:v>38.876899999999999</c:v>
                </c:pt>
                <c:pt idx="134">
                  <c:v>38.645499999999998</c:v>
                </c:pt>
                <c:pt idx="135">
                  <c:v>38.413400000000003</c:v>
                </c:pt>
                <c:pt idx="136">
                  <c:v>25.470300000000002</c:v>
                </c:pt>
                <c:pt idx="137">
                  <c:v>42.339500000000001</c:v>
                </c:pt>
                <c:pt idx="138">
                  <c:v>26.832700000000003</c:v>
                </c:pt>
                <c:pt idx="139">
                  <c:v>44.198999999999998</c:v>
                </c:pt>
                <c:pt idx="140">
                  <c:v>39.423300000000005</c:v>
                </c:pt>
                <c:pt idx="141">
                  <c:v>36.7012</c:v>
                </c:pt>
                <c:pt idx="142">
                  <c:v>23.793600000000001</c:v>
                </c:pt>
                <c:pt idx="143">
                  <c:v>42.418300000000002</c:v>
                </c:pt>
                <c:pt idx="144">
                  <c:v>46.543500000000002</c:v>
                </c:pt>
                <c:pt idx="145">
                  <c:v>32.932500000000005</c:v>
                </c:pt>
                <c:pt idx="146">
                  <c:v>44.450700000000005</c:v>
                </c:pt>
                <c:pt idx="147">
                  <c:v>26.985900000000001</c:v>
                </c:pt>
                <c:pt idx="148">
                  <c:v>37.950500000000005</c:v>
                </c:pt>
                <c:pt idx="149">
                  <c:v>41.879800000000003</c:v>
                </c:pt>
                <c:pt idx="150">
                  <c:v>35.546500000000002</c:v>
                </c:pt>
                <c:pt idx="151">
                  <c:v>49.348600000000005</c:v>
                </c:pt>
                <c:pt idx="152">
                  <c:v>42.083300000000001</c:v>
                </c:pt>
                <c:pt idx="153">
                  <c:v>34.076599999999999</c:v>
                </c:pt>
                <c:pt idx="154">
                  <c:v>35.159400000000005</c:v>
                </c:pt>
                <c:pt idx="155">
                  <c:v>36.573</c:v>
                </c:pt>
                <c:pt idx="156">
                  <c:v>22.036900000000003</c:v>
                </c:pt>
                <c:pt idx="157">
                  <c:v>47.354399999999998</c:v>
                </c:pt>
                <c:pt idx="158">
                  <c:v>41.329100000000004</c:v>
                </c:pt>
                <c:pt idx="159">
                  <c:v>38.8003</c:v>
                </c:pt>
                <c:pt idx="160">
                  <c:v>44.183300000000003</c:v>
                </c:pt>
                <c:pt idx="161">
                  <c:v>39.633500000000005</c:v>
                </c:pt>
                <c:pt idx="162">
                  <c:v>32.700000000000003</c:v>
                </c:pt>
                <c:pt idx="163">
                  <c:v>48.474900000000005</c:v>
                </c:pt>
                <c:pt idx="164">
                  <c:v>49.021500000000003</c:v>
                </c:pt>
                <c:pt idx="165">
                  <c:v>28.094300000000004</c:v>
                </c:pt>
                <c:pt idx="166">
                  <c:v>33.966200000000001</c:v>
                </c:pt>
                <c:pt idx="167">
                  <c:v>28.363100000000003</c:v>
                </c:pt>
                <c:pt idx="168">
                  <c:v>39.812200000000004</c:v>
                </c:pt>
                <c:pt idx="169">
                  <c:v>41.958500000000001</c:v>
                </c:pt>
                <c:pt idx="170">
                  <c:v>36.123200000000004</c:v>
                </c:pt>
                <c:pt idx="171">
                  <c:v>50.1815</c:v>
                </c:pt>
                <c:pt idx="172">
                  <c:v>36.3748</c:v>
                </c:pt>
                <c:pt idx="173">
                  <c:v>32.804700000000004</c:v>
                </c:pt>
                <c:pt idx="174">
                  <c:v>34.2455</c:v>
                </c:pt>
                <c:pt idx="175">
                  <c:v>42.206500000000005</c:v>
                </c:pt>
                <c:pt idx="176">
                  <c:v>35.8917</c:v>
                </c:pt>
                <c:pt idx="177">
                  <c:v>56.851300000000002</c:v>
                </c:pt>
                <c:pt idx="178">
                  <c:v>29.263800000000003</c:v>
                </c:pt>
                <c:pt idx="179">
                  <c:v>41.596600000000002</c:v>
                </c:pt>
                <c:pt idx="180">
                  <c:v>30.320100000000004</c:v>
                </c:pt>
                <c:pt idx="181">
                  <c:v>38.064</c:v>
                </c:pt>
                <c:pt idx="182">
                  <c:v>53.454800000000006</c:v>
                </c:pt>
                <c:pt idx="183">
                  <c:v>24.366900000000001</c:v>
                </c:pt>
                <c:pt idx="184">
                  <c:v>38.831299999999999</c:v>
                </c:pt>
                <c:pt idx="185">
                  <c:v>41.937100000000001</c:v>
                </c:pt>
                <c:pt idx="186">
                  <c:v>38.260010000000001</c:v>
                </c:pt>
                <c:pt idx="187">
                  <c:v>40.658700000000003</c:v>
                </c:pt>
                <c:pt idx="188">
                  <c:v>47.2226</c:v>
                </c:pt>
                <c:pt idx="189">
                  <c:v>44.568200000000004</c:v>
                </c:pt>
                <c:pt idx="190">
                  <c:v>39.258800000000001</c:v>
                </c:pt>
                <c:pt idx="191">
                  <c:v>40.069800000000001</c:v>
                </c:pt>
                <c:pt idx="192">
                  <c:v>37.656300000000002</c:v>
                </c:pt>
                <c:pt idx="193">
                  <c:v>46.134500000000003</c:v>
                </c:pt>
                <c:pt idx="194">
                  <c:v>29.848500000000001</c:v>
                </c:pt>
                <c:pt idx="195">
                  <c:v>37.744199999999999</c:v>
                </c:pt>
                <c:pt idx="196">
                  <c:v>52.8367</c:v>
                </c:pt>
                <c:pt idx="197">
                  <c:v>18.845100000000002</c:v>
                </c:pt>
                <c:pt idx="198">
                  <c:v>32.162500000000001</c:v>
                </c:pt>
                <c:pt idx="199">
                  <c:v>47.188500000000005</c:v>
                </c:pt>
                <c:pt idx="200">
                  <c:v>33.921100000000003</c:v>
                </c:pt>
                <c:pt idx="201">
                  <c:v>36.124200000000002</c:v>
                </c:pt>
                <c:pt idx="202">
                  <c:v>31.616500000000002</c:v>
                </c:pt>
                <c:pt idx="203">
                  <c:v>29.242200000000004</c:v>
                </c:pt>
                <c:pt idx="204">
                  <c:v>34.550200000000004</c:v>
                </c:pt>
                <c:pt idx="205">
                  <c:v>24.234700000000004</c:v>
                </c:pt>
                <c:pt idx="206">
                  <c:v>42.011500000000005</c:v>
                </c:pt>
                <c:pt idx="207">
                  <c:v>29.339700000000001</c:v>
                </c:pt>
                <c:pt idx="208">
                  <c:v>45.945599999999999</c:v>
                </c:pt>
                <c:pt idx="209">
                  <c:v>35.436800000000005</c:v>
                </c:pt>
                <c:pt idx="210">
                  <c:v>41.744300000000003</c:v>
                </c:pt>
                <c:pt idx="211">
                  <c:v>39.941000000000003</c:v>
                </c:pt>
                <c:pt idx="212">
                  <c:v>44.188600000000001</c:v>
                </c:pt>
                <c:pt idx="213">
                  <c:v>37.288699999999999</c:v>
                </c:pt>
                <c:pt idx="214">
                  <c:v>40.950500000000005</c:v>
                </c:pt>
                <c:pt idx="215">
                  <c:v>32.646900000000002</c:v>
                </c:pt>
                <c:pt idx="216">
                  <c:v>40.420100000000005</c:v>
                </c:pt>
                <c:pt idx="217">
                  <c:v>34.735500000000002</c:v>
                </c:pt>
                <c:pt idx="218">
                  <c:v>19.802300000000002</c:v>
                </c:pt>
                <c:pt idx="219">
                  <c:v>49.657299999999999</c:v>
                </c:pt>
                <c:pt idx="220">
                  <c:v>33.423100000000005</c:v>
                </c:pt>
                <c:pt idx="221">
                  <c:v>30.2348</c:v>
                </c:pt>
                <c:pt idx="222">
                  <c:v>48.9208</c:v>
                </c:pt>
                <c:pt idx="223">
                  <c:v>31.043900000000001</c:v>
                </c:pt>
                <c:pt idx="224">
                  <c:v>38.494399999999999</c:v>
                </c:pt>
                <c:pt idx="225">
                  <c:v>41.937899999999999</c:v>
                </c:pt>
                <c:pt idx="226">
                  <c:v>33.417500000000004</c:v>
                </c:pt>
                <c:pt idx="227">
                  <c:v>31.572900000000001</c:v>
                </c:pt>
                <c:pt idx="228">
                  <c:v>54.447900000000004</c:v>
                </c:pt>
                <c:pt idx="229">
                  <c:v>48.221400000000003</c:v>
                </c:pt>
                <c:pt idx="230">
                  <c:v>45.2258</c:v>
                </c:pt>
                <c:pt idx="231">
                  <c:v>25.661900000000003</c:v>
                </c:pt>
                <c:pt idx="232">
                  <c:v>47.0946</c:v>
                </c:pt>
                <c:pt idx="233">
                  <c:v>25.662700000000001</c:v>
                </c:pt>
                <c:pt idx="234">
                  <c:v>39.701500000000003</c:v>
                </c:pt>
                <c:pt idx="235">
                  <c:v>28.370100000000001</c:v>
                </c:pt>
                <c:pt idx="236">
                  <c:v>34.243500000000004</c:v>
                </c:pt>
                <c:pt idx="237">
                  <c:v>27.663000000000004</c:v>
                </c:pt>
                <c:pt idx="238">
                  <c:v>44.3264</c:v>
                </c:pt>
                <c:pt idx="239">
                  <c:v>36.877800000000001</c:v>
                </c:pt>
                <c:pt idx="240">
                  <c:v>33.044600000000003</c:v>
                </c:pt>
                <c:pt idx="241">
                  <c:v>35.023400000000002</c:v>
                </c:pt>
                <c:pt idx="242">
                  <c:v>44.761499999999998</c:v>
                </c:pt>
                <c:pt idx="243">
                  <c:v>43.780100000000004</c:v>
                </c:pt>
                <c:pt idx="244">
                  <c:v>59.171300000000002</c:v>
                </c:pt>
                <c:pt idx="245">
                  <c:v>36.441700000000004</c:v>
                </c:pt>
                <c:pt idx="246">
                  <c:v>40.953099999999999</c:v>
                </c:pt>
                <c:pt idx="247">
                  <c:v>17.574300000000001</c:v>
                </c:pt>
                <c:pt idx="248">
                  <c:v>45.208800000000004</c:v>
                </c:pt>
                <c:pt idx="249">
                  <c:v>32.945399999999999</c:v>
                </c:pt>
                <c:pt idx="250">
                  <c:v>47.9236</c:v>
                </c:pt>
                <c:pt idx="251">
                  <c:v>42.6053</c:v>
                </c:pt>
                <c:pt idx="252">
                  <c:v>39.944299999999998</c:v>
                </c:pt>
                <c:pt idx="253">
                  <c:v>47.139200000000002</c:v>
                </c:pt>
                <c:pt idx="254">
                  <c:v>50.486400000000003</c:v>
                </c:pt>
                <c:pt idx="255">
                  <c:v>30.193300000000001</c:v>
                </c:pt>
                <c:pt idx="256">
                  <c:v>33.230400000000003</c:v>
                </c:pt>
                <c:pt idx="257">
                  <c:v>50.101800000000004</c:v>
                </c:pt>
                <c:pt idx="258">
                  <c:v>47.022800000000004</c:v>
                </c:pt>
                <c:pt idx="259">
                  <c:v>38.290279000000005</c:v>
                </c:pt>
                <c:pt idx="260">
                  <c:v>34.505300000000005</c:v>
                </c:pt>
                <c:pt idx="261">
                  <c:v>44.072500000000005</c:v>
                </c:pt>
                <c:pt idx="262">
                  <c:v>43.5214</c:v>
                </c:pt>
                <c:pt idx="263">
                  <c:v>34.472700000000003</c:v>
                </c:pt>
                <c:pt idx="264">
                  <c:v>38.032200000000003</c:v>
                </c:pt>
                <c:pt idx="265">
                  <c:v>54.278800000000004</c:v>
                </c:pt>
                <c:pt idx="266">
                  <c:v>30.238400000000002</c:v>
                </c:pt>
                <c:pt idx="267">
                  <c:v>42.143000000000001</c:v>
                </c:pt>
                <c:pt idx="268">
                  <c:v>43.736200000000004</c:v>
                </c:pt>
                <c:pt idx="269">
                  <c:v>37.068800000000003</c:v>
                </c:pt>
                <c:pt idx="270">
                  <c:v>35.467100000000002</c:v>
                </c:pt>
                <c:pt idx="271">
                  <c:v>44.572800000000001</c:v>
                </c:pt>
                <c:pt idx="272">
                  <c:v>24.983900000000002</c:v>
                </c:pt>
                <c:pt idx="273">
                  <c:v>29.799400000000002</c:v>
                </c:pt>
                <c:pt idx="274">
                  <c:v>37.537600000000005</c:v>
                </c:pt>
                <c:pt idx="275">
                  <c:v>43.3947</c:v>
                </c:pt>
                <c:pt idx="276">
                  <c:v>47.1584</c:v>
                </c:pt>
                <c:pt idx="277">
                  <c:v>48.591900000000003</c:v>
                </c:pt>
                <c:pt idx="278">
                  <c:v>34.556699999999999</c:v>
                </c:pt>
                <c:pt idx="279">
                  <c:v>50.728099999999998</c:v>
                </c:pt>
                <c:pt idx="280">
                  <c:v>43.817700000000002</c:v>
                </c:pt>
                <c:pt idx="281">
                  <c:v>53.709500000000006</c:v>
                </c:pt>
                <c:pt idx="282">
                  <c:v>44.857100000000003</c:v>
                </c:pt>
                <c:pt idx="283">
                  <c:v>36.085500000000003</c:v>
                </c:pt>
                <c:pt idx="284">
                  <c:v>36.408999999999999</c:v>
                </c:pt>
                <c:pt idx="285">
                  <c:v>27.82</c:v>
                </c:pt>
                <c:pt idx="286">
                  <c:v>39.871900000000004</c:v>
                </c:pt>
                <c:pt idx="287">
                  <c:v>51.187100000000001</c:v>
                </c:pt>
                <c:pt idx="288">
                  <c:v>54.479700000000001</c:v>
                </c:pt>
                <c:pt idx="289">
                  <c:v>32.896799999999999</c:v>
                </c:pt>
                <c:pt idx="290">
                  <c:v>34.010100000000001</c:v>
                </c:pt>
                <c:pt idx="291">
                  <c:v>40.950900000000004</c:v>
                </c:pt>
              </c:numCache>
            </c:numRef>
          </c:xVal>
          <c:yVal>
            <c:numRef>
              <c:f>'292RILs'!$J$2:$J$293</c:f>
              <c:numCache>
                <c:formatCode>0.00</c:formatCode>
                <c:ptCount val="292"/>
                <c:pt idx="0">
                  <c:v>51.957344674538902</c:v>
                </c:pt>
                <c:pt idx="1">
                  <c:v>42.771643100609801</c:v>
                </c:pt>
                <c:pt idx="2">
                  <c:v>36.275734582754403</c:v>
                </c:pt>
                <c:pt idx="3">
                  <c:v>62.301912168801003</c:v>
                </c:pt>
                <c:pt idx="4">
                  <c:v>43.706431614574903</c:v>
                </c:pt>
                <c:pt idx="5">
                  <c:v>56.135867366873804</c:v>
                </c:pt>
                <c:pt idx="6">
                  <c:v>51.2944565960887</c:v>
                </c:pt>
                <c:pt idx="7">
                  <c:v>53.970787103864303</c:v>
                </c:pt>
                <c:pt idx="8">
                  <c:v>40.604188915017602</c:v>
                </c:pt>
                <c:pt idx="9">
                  <c:v>40.041307834199202</c:v>
                </c:pt>
                <c:pt idx="10">
                  <c:v>43.513287681726197</c:v>
                </c:pt>
                <c:pt idx="11">
                  <c:v>52.320438525230102</c:v>
                </c:pt>
                <c:pt idx="12">
                  <c:v>44.0640446264728</c:v>
                </c:pt>
                <c:pt idx="13">
                  <c:v>44.081247203647102</c:v>
                </c:pt>
                <c:pt idx="14">
                  <c:v>52.288865921826599</c:v>
                </c:pt>
                <c:pt idx="15">
                  <c:v>46.315033124096303</c:v>
                </c:pt>
                <c:pt idx="16">
                  <c:v>39.750668300323902</c:v>
                </c:pt>
                <c:pt idx="17">
                  <c:v>53.598909553703002</c:v>
                </c:pt>
                <c:pt idx="18">
                  <c:v>52.850468621291199</c:v>
                </c:pt>
                <c:pt idx="19">
                  <c:v>53.824491255124002</c:v>
                </c:pt>
                <c:pt idx="20">
                  <c:v>46.009881115306499</c:v>
                </c:pt>
                <c:pt idx="21">
                  <c:v>36.518496356028898</c:v>
                </c:pt>
                <c:pt idx="22">
                  <c:v>41.294593337536803</c:v>
                </c:pt>
                <c:pt idx="23">
                  <c:v>45.958022477564199</c:v>
                </c:pt>
                <c:pt idx="24">
                  <c:v>47.925405991737797</c:v>
                </c:pt>
                <c:pt idx="25">
                  <c:v>11.005013147725499</c:v>
                </c:pt>
                <c:pt idx="26">
                  <c:v>43.149014657858302</c:v>
                </c:pt>
                <c:pt idx="27">
                  <c:v>53.469521150627997</c:v>
                </c:pt>
                <c:pt idx="28">
                  <c:v>40.944698749079997</c:v>
                </c:pt>
                <c:pt idx="29">
                  <c:v>32.014345066134403</c:v>
                </c:pt>
                <c:pt idx="30">
                  <c:v>51.698314560610299</c:v>
                </c:pt>
                <c:pt idx="31">
                  <c:v>49.5472115631514</c:v>
                </c:pt>
                <c:pt idx="32">
                  <c:v>45.452687935141299</c:v>
                </c:pt>
                <c:pt idx="33">
                  <c:v>56.477835898016998</c:v>
                </c:pt>
                <c:pt idx="34">
                  <c:v>57.646610273687102</c:v>
                </c:pt>
                <c:pt idx="35">
                  <c:v>35.198572115527199</c:v>
                </c:pt>
                <c:pt idx="36">
                  <c:v>54.745406828150102</c:v>
                </c:pt>
                <c:pt idx="37">
                  <c:v>58.886155693562301</c:v>
                </c:pt>
                <c:pt idx="38">
                  <c:v>57.813059728038503</c:v>
                </c:pt>
                <c:pt idx="39">
                  <c:v>45.3360657903945</c:v>
                </c:pt>
                <c:pt idx="40">
                  <c:v>49.148935289332698</c:v>
                </c:pt>
                <c:pt idx="41">
                  <c:v>55.830019836239799</c:v>
                </c:pt>
                <c:pt idx="42">
                  <c:v>35.488658441692998</c:v>
                </c:pt>
                <c:pt idx="43">
                  <c:v>22.9230942592167</c:v>
                </c:pt>
                <c:pt idx="44">
                  <c:v>50.987414970437598</c:v>
                </c:pt>
                <c:pt idx="45">
                  <c:v>37.639477014459899</c:v>
                </c:pt>
                <c:pt idx="46">
                  <c:v>26.260706683640802</c:v>
                </c:pt>
                <c:pt idx="47">
                  <c:v>65.342128094534004</c:v>
                </c:pt>
                <c:pt idx="48">
                  <c:v>57.132777307313802</c:v>
                </c:pt>
                <c:pt idx="49">
                  <c:v>52.942317860753299</c:v>
                </c:pt>
                <c:pt idx="50">
                  <c:v>36.192499055746303</c:v>
                </c:pt>
                <c:pt idx="51">
                  <c:v>35.808306822742701</c:v>
                </c:pt>
                <c:pt idx="52">
                  <c:v>65.940997210174103</c:v>
                </c:pt>
                <c:pt idx="53">
                  <c:v>55.479718011180601</c:v>
                </c:pt>
                <c:pt idx="54">
                  <c:v>52.476360151777001</c:v>
                </c:pt>
                <c:pt idx="55">
                  <c:v>60.067806928850999</c:v>
                </c:pt>
                <c:pt idx="56">
                  <c:v>48.187534194490098</c:v>
                </c:pt>
                <c:pt idx="57">
                  <c:v>55.1249011884182</c:v>
                </c:pt>
                <c:pt idx="58">
                  <c:v>55.985237010011502</c:v>
                </c:pt>
                <c:pt idx="59">
                  <c:v>27.087416721333302</c:v>
                </c:pt>
                <c:pt idx="60">
                  <c:v>68.706426638715897</c:v>
                </c:pt>
                <c:pt idx="61">
                  <c:v>46.287502298341401</c:v>
                </c:pt>
                <c:pt idx="62">
                  <c:v>45.557343681110197</c:v>
                </c:pt>
                <c:pt idx="63">
                  <c:v>26.2363858130403</c:v>
                </c:pt>
                <c:pt idx="64">
                  <c:v>55.0889600719618</c:v>
                </c:pt>
                <c:pt idx="65">
                  <c:v>52.524908477023502</c:v>
                </c:pt>
                <c:pt idx="66">
                  <c:v>37.279506690300302</c:v>
                </c:pt>
                <c:pt idx="67">
                  <c:v>37.280760875793298</c:v>
                </c:pt>
                <c:pt idx="68">
                  <c:v>36.513203740657502</c:v>
                </c:pt>
                <c:pt idx="69">
                  <c:v>51.499183753849202</c:v>
                </c:pt>
                <c:pt idx="70">
                  <c:v>29.989878195759399</c:v>
                </c:pt>
                <c:pt idx="71">
                  <c:v>30.264070948353002</c:v>
                </c:pt>
                <c:pt idx="72">
                  <c:v>44.420751026515298</c:v>
                </c:pt>
                <c:pt idx="73">
                  <c:v>41.204080758129301</c:v>
                </c:pt>
                <c:pt idx="74">
                  <c:v>91.606073652148197</c:v>
                </c:pt>
                <c:pt idx="75">
                  <c:v>51.4538919554142</c:v>
                </c:pt>
                <c:pt idx="76">
                  <c:v>52.257724782601699</c:v>
                </c:pt>
                <c:pt idx="77">
                  <c:v>41.883586558693402</c:v>
                </c:pt>
                <c:pt idx="78">
                  <c:v>55.985770233278103</c:v>
                </c:pt>
                <c:pt idx="79">
                  <c:v>34.834295964417201</c:v>
                </c:pt>
                <c:pt idx="80">
                  <c:v>36.450295257813103</c:v>
                </c:pt>
                <c:pt idx="81">
                  <c:v>60.367729123519702</c:v>
                </c:pt>
                <c:pt idx="82">
                  <c:v>32.833699196186501</c:v>
                </c:pt>
                <c:pt idx="83">
                  <c:v>55.1766964575895</c:v>
                </c:pt>
                <c:pt idx="84">
                  <c:v>60.788045673866797</c:v>
                </c:pt>
                <c:pt idx="85">
                  <c:v>44.021895952107599</c:v>
                </c:pt>
                <c:pt idx="86">
                  <c:v>39.662430744794896</c:v>
                </c:pt>
                <c:pt idx="87">
                  <c:v>42.157074676474203</c:v>
                </c:pt>
                <c:pt idx="88">
                  <c:v>43.820711719690799</c:v>
                </c:pt>
                <c:pt idx="89">
                  <c:v>33.451728178817397</c:v>
                </c:pt>
                <c:pt idx="90">
                  <c:v>57.561746528463701</c:v>
                </c:pt>
                <c:pt idx="91">
                  <c:v>51.712057837297202</c:v>
                </c:pt>
                <c:pt idx="92">
                  <c:v>43.956505956896898</c:v>
                </c:pt>
                <c:pt idx="93">
                  <c:v>51.491973636038999</c:v>
                </c:pt>
                <c:pt idx="94">
                  <c:v>51.1557460392157</c:v>
                </c:pt>
                <c:pt idx="95">
                  <c:v>41.3552172189655</c:v>
                </c:pt>
                <c:pt idx="96">
                  <c:v>55.837959642689398</c:v>
                </c:pt>
                <c:pt idx="97">
                  <c:v>53.100681114625203</c:v>
                </c:pt>
                <c:pt idx="98">
                  <c:v>48.851892450463502</c:v>
                </c:pt>
                <c:pt idx="99">
                  <c:v>47.014493453573699</c:v>
                </c:pt>
                <c:pt idx="100">
                  <c:v>57.709021870382799</c:v>
                </c:pt>
                <c:pt idx="101">
                  <c:v>50.382026362019197</c:v>
                </c:pt>
                <c:pt idx="102">
                  <c:v>54.301830040616103</c:v>
                </c:pt>
                <c:pt idx="103">
                  <c:v>53.3092043057109</c:v>
                </c:pt>
                <c:pt idx="104">
                  <c:v>57.380538514855701</c:v>
                </c:pt>
                <c:pt idx="105">
                  <c:v>50.653768749940497</c:v>
                </c:pt>
                <c:pt idx="106">
                  <c:v>58.1498290470239</c:v>
                </c:pt>
                <c:pt idx="107">
                  <c:v>55.144211539154099</c:v>
                </c:pt>
                <c:pt idx="108">
                  <c:v>47.268708965696398</c:v>
                </c:pt>
                <c:pt idx="109">
                  <c:v>60.554003979487398</c:v>
                </c:pt>
                <c:pt idx="110">
                  <c:v>58.029094726566001</c:v>
                </c:pt>
                <c:pt idx="111">
                  <c:v>46.511996841510602</c:v>
                </c:pt>
                <c:pt idx="112">
                  <c:v>53.983375533290101</c:v>
                </c:pt>
                <c:pt idx="113">
                  <c:v>55.984390680700997</c:v>
                </c:pt>
                <c:pt idx="114">
                  <c:v>38.2669073819592</c:v>
                </c:pt>
                <c:pt idx="115">
                  <c:v>62.872046583534299</c:v>
                </c:pt>
                <c:pt idx="116">
                  <c:v>47.833191000408902</c:v>
                </c:pt>
                <c:pt idx="117">
                  <c:v>35.479141377455498</c:v>
                </c:pt>
                <c:pt idx="118">
                  <c:v>38.5450316088642</c:v>
                </c:pt>
                <c:pt idx="119">
                  <c:v>36.593646739771501</c:v>
                </c:pt>
                <c:pt idx="120">
                  <c:v>50.675617729720898</c:v>
                </c:pt>
                <c:pt idx="121">
                  <c:v>47.875000223918597</c:v>
                </c:pt>
                <c:pt idx="122">
                  <c:v>46.497694145880601</c:v>
                </c:pt>
                <c:pt idx="123">
                  <c:v>67.381201316268104</c:v>
                </c:pt>
                <c:pt idx="124">
                  <c:v>50.203723995422997</c:v>
                </c:pt>
                <c:pt idx="125">
                  <c:v>50.182298367662099</c:v>
                </c:pt>
                <c:pt idx="126">
                  <c:v>51.734990809434898</c:v>
                </c:pt>
                <c:pt idx="127">
                  <c:v>59.143708578343798</c:v>
                </c:pt>
                <c:pt idx="128">
                  <c:v>68.750486625857206</c:v>
                </c:pt>
                <c:pt idx="129">
                  <c:v>59.730723265990797</c:v>
                </c:pt>
                <c:pt idx="130">
                  <c:v>64.000037661753694</c:v>
                </c:pt>
                <c:pt idx="131">
                  <c:v>52.9300700683389</c:v>
                </c:pt>
                <c:pt idx="132">
                  <c:v>54.107976589964501</c:v>
                </c:pt>
                <c:pt idx="133">
                  <c:v>43.3712740744242</c:v>
                </c:pt>
                <c:pt idx="134">
                  <c:v>62.252320503296303</c:v>
                </c:pt>
                <c:pt idx="135">
                  <c:v>59.062773152919497</c:v>
                </c:pt>
                <c:pt idx="136">
                  <c:v>41.451976885765703</c:v>
                </c:pt>
                <c:pt idx="137">
                  <c:v>52.280663841156503</c:v>
                </c:pt>
                <c:pt idx="138">
                  <c:v>38.817761873689697</c:v>
                </c:pt>
                <c:pt idx="139">
                  <c:v>49.953092689133101</c:v>
                </c:pt>
                <c:pt idx="140">
                  <c:v>50.7901054259708</c:v>
                </c:pt>
                <c:pt idx="141">
                  <c:v>46.897362993995799</c:v>
                </c:pt>
                <c:pt idx="142">
                  <c:v>38.013117875310698</c:v>
                </c:pt>
                <c:pt idx="143">
                  <c:v>52.1830017744957</c:v>
                </c:pt>
                <c:pt idx="144">
                  <c:v>52.597014964985704</c:v>
                </c:pt>
                <c:pt idx="145">
                  <c:v>51.228540371538401</c:v>
                </c:pt>
                <c:pt idx="146">
                  <c:v>59.6015498963041</c:v>
                </c:pt>
                <c:pt idx="147">
                  <c:v>51.294137732436198</c:v>
                </c:pt>
                <c:pt idx="148">
                  <c:v>42.745771414567301</c:v>
                </c:pt>
                <c:pt idx="149">
                  <c:v>55.986942966754498</c:v>
                </c:pt>
                <c:pt idx="150">
                  <c:v>68.5858939747541</c:v>
                </c:pt>
                <c:pt idx="151">
                  <c:v>64.120231987433499</c:v>
                </c:pt>
                <c:pt idx="152">
                  <c:v>62.066579838241402</c:v>
                </c:pt>
                <c:pt idx="153">
                  <c:v>38.2099764799759</c:v>
                </c:pt>
                <c:pt idx="154">
                  <c:v>43.378614547410002</c:v>
                </c:pt>
                <c:pt idx="155">
                  <c:v>48.341167101290402</c:v>
                </c:pt>
                <c:pt idx="156">
                  <c:v>40.008305594520202</c:v>
                </c:pt>
                <c:pt idx="157">
                  <c:v>43.104513676037897</c:v>
                </c:pt>
                <c:pt idx="158">
                  <c:v>58.591407897853898</c:v>
                </c:pt>
                <c:pt idx="159">
                  <c:v>57.239472366260102</c:v>
                </c:pt>
                <c:pt idx="160">
                  <c:v>66.417619158143197</c:v>
                </c:pt>
                <c:pt idx="161">
                  <c:v>41.839510105909604</c:v>
                </c:pt>
                <c:pt idx="162">
                  <c:v>57.705600040980499</c:v>
                </c:pt>
                <c:pt idx="163">
                  <c:v>71.845330696863002</c:v>
                </c:pt>
                <c:pt idx="164">
                  <c:v>69.687445028667597</c:v>
                </c:pt>
                <c:pt idx="165">
                  <c:v>57.628070525103603</c:v>
                </c:pt>
                <c:pt idx="166">
                  <c:v>53.7801555564334</c:v>
                </c:pt>
                <c:pt idx="167">
                  <c:v>34.021865571547401</c:v>
                </c:pt>
                <c:pt idx="168">
                  <c:v>56.269201505416198</c:v>
                </c:pt>
                <c:pt idx="169">
                  <c:v>36.615026128511403</c:v>
                </c:pt>
                <c:pt idx="170">
                  <c:v>44.374492462144701</c:v>
                </c:pt>
                <c:pt idx="171">
                  <c:v>54.861530760228099</c:v>
                </c:pt>
                <c:pt idx="172">
                  <c:v>46.5924667383848</c:v>
                </c:pt>
                <c:pt idx="173">
                  <c:v>44.863214228609699</c:v>
                </c:pt>
                <c:pt idx="174">
                  <c:v>69.294002741893394</c:v>
                </c:pt>
                <c:pt idx="175">
                  <c:v>48.330419402011003</c:v>
                </c:pt>
                <c:pt idx="176">
                  <c:v>37.201799069606103</c:v>
                </c:pt>
                <c:pt idx="177">
                  <c:v>63.062625034976399</c:v>
                </c:pt>
                <c:pt idx="178">
                  <c:v>46.196775303214899</c:v>
                </c:pt>
                <c:pt idx="179">
                  <c:v>54.595542182999097</c:v>
                </c:pt>
                <c:pt idx="180">
                  <c:v>49.2358465934851</c:v>
                </c:pt>
                <c:pt idx="181">
                  <c:v>36.282900669287102</c:v>
                </c:pt>
                <c:pt idx="182">
                  <c:v>62.725846417218897</c:v>
                </c:pt>
                <c:pt idx="183">
                  <c:v>25.286174962320001</c:v>
                </c:pt>
                <c:pt idx="184">
                  <c:v>48.119021013053498</c:v>
                </c:pt>
                <c:pt idx="185">
                  <c:v>41.305029796026403</c:v>
                </c:pt>
                <c:pt idx="186">
                  <c:v>51.222140684092999</c:v>
                </c:pt>
                <c:pt idx="187">
                  <c:v>63.082843542471203</c:v>
                </c:pt>
                <c:pt idx="188">
                  <c:v>54.110998416685099</c:v>
                </c:pt>
                <c:pt idx="189">
                  <c:v>54.358045881792201</c:v>
                </c:pt>
                <c:pt idx="190">
                  <c:v>59.896159216009401</c:v>
                </c:pt>
                <c:pt idx="191">
                  <c:v>49.364997188090001</c:v>
                </c:pt>
                <c:pt idx="192">
                  <c:v>82.533111474886397</c:v>
                </c:pt>
                <c:pt idx="193">
                  <c:v>42.6963995207186</c:v>
                </c:pt>
                <c:pt idx="194">
                  <c:v>46.9318982879632</c:v>
                </c:pt>
                <c:pt idx="195">
                  <c:v>42.747116778246799</c:v>
                </c:pt>
                <c:pt idx="196">
                  <c:v>55.968275870753601</c:v>
                </c:pt>
                <c:pt idx="197">
                  <c:v>51.357750183771103</c:v>
                </c:pt>
                <c:pt idx="198">
                  <c:v>50.940698079266902</c:v>
                </c:pt>
                <c:pt idx="199">
                  <c:v>61.2426488489942</c:v>
                </c:pt>
                <c:pt idx="200">
                  <c:v>25.739404860154099</c:v>
                </c:pt>
                <c:pt idx="201">
                  <c:v>60.9526189518593</c:v>
                </c:pt>
                <c:pt idx="202">
                  <c:v>50.786478976156197</c:v>
                </c:pt>
                <c:pt idx="203">
                  <c:v>42.945633911629898</c:v>
                </c:pt>
                <c:pt idx="204">
                  <c:v>48.424983749691101</c:v>
                </c:pt>
                <c:pt idx="205">
                  <c:v>27.0795983767667</c:v>
                </c:pt>
                <c:pt idx="206">
                  <c:v>66.945208395021297</c:v>
                </c:pt>
                <c:pt idx="207">
                  <c:v>32.030996054648199</c:v>
                </c:pt>
                <c:pt idx="208">
                  <c:v>62.1833689373765</c:v>
                </c:pt>
                <c:pt idx="209">
                  <c:v>53.555277533638801</c:v>
                </c:pt>
                <c:pt idx="210">
                  <c:v>61.025117851253697</c:v>
                </c:pt>
                <c:pt idx="211">
                  <c:v>53.663313012231399</c:v>
                </c:pt>
                <c:pt idx="212">
                  <c:v>63.266373805367003</c:v>
                </c:pt>
                <c:pt idx="213">
                  <c:v>43.355905393436402</c:v>
                </c:pt>
                <c:pt idx="214">
                  <c:v>51.513445023945202</c:v>
                </c:pt>
                <c:pt idx="215">
                  <c:v>49.025746960379401</c:v>
                </c:pt>
                <c:pt idx="216">
                  <c:v>35.975434560650001</c:v>
                </c:pt>
                <c:pt idx="217">
                  <c:v>32.4970642059738</c:v>
                </c:pt>
                <c:pt idx="218">
                  <c:v>41.959738029905999</c:v>
                </c:pt>
                <c:pt idx="219">
                  <c:v>51.2277874025201</c:v>
                </c:pt>
                <c:pt idx="220">
                  <c:v>32.874929237867001</c:v>
                </c:pt>
                <c:pt idx="221">
                  <c:v>48.623699333613899</c:v>
                </c:pt>
                <c:pt idx="222">
                  <c:v>53.533519025555499</c:v>
                </c:pt>
                <c:pt idx="223">
                  <c:v>44.449269643087497</c:v>
                </c:pt>
                <c:pt idx="224">
                  <c:v>50.849719417562603</c:v>
                </c:pt>
                <c:pt idx="225">
                  <c:v>58.928301624837601</c:v>
                </c:pt>
                <c:pt idx="226">
                  <c:v>39.294943278619499</c:v>
                </c:pt>
                <c:pt idx="227">
                  <c:v>33.929453335607903</c:v>
                </c:pt>
                <c:pt idx="228">
                  <c:v>47.438050852109498</c:v>
                </c:pt>
                <c:pt idx="229">
                  <c:v>55.321545316568702</c:v>
                </c:pt>
                <c:pt idx="230">
                  <c:v>62.260278560113598</c:v>
                </c:pt>
                <c:pt idx="231">
                  <c:v>37.062101176065603</c:v>
                </c:pt>
                <c:pt idx="232">
                  <c:v>41.359821991464798</c:v>
                </c:pt>
                <c:pt idx="233">
                  <c:v>51.830368230334201</c:v>
                </c:pt>
                <c:pt idx="234">
                  <c:v>60.367057698531099</c:v>
                </c:pt>
                <c:pt idx="235">
                  <c:v>30.783667680638601</c:v>
                </c:pt>
                <c:pt idx="236">
                  <c:v>36.231173253873898</c:v>
                </c:pt>
                <c:pt idx="237">
                  <c:v>46.512719917005697</c:v>
                </c:pt>
                <c:pt idx="238">
                  <c:v>57.549866119129703</c:v>
                </c:pt>
                <c:pt idx="239">
                  <c:v>32.4983583597784</c:v>
                </c:pt>
                <c:pt idx="240">
                  <c:v>43.859049306681797</c:v>
                </c:pt>
                <c:pt idx="241">
                  <c:v>46.362084104648403</c:v>
                </c:pt>
                <c:pt idx="242">
                  <c:v>50.970601809431798</c:v>
                </c:pt>
                <c:pt idx="243">
                  <c:v>54.993363155662898</c:v>
                </c:pt>
                <c:pt idx="244">
                  <c:v>36.445739115191301</c:v>
                </c:pt>
                <c:pt idx="245">
                  <c:v>52.527213569949502</c:v>
                </c:pt>
                <c:pt idx="246">
                  <c:v>47.504516517108797</c:v>
                </c:pt>
                <c:pt idx="247">
                  <c:v>19.642799027984001</c:v>
                </c:pt>
                <c:pt idx="248">
                  <c:v>55.527124698879703</c:v>
                </c:pt>
                <c:pt idx="249">
                  <c:v>45.400957699525499</c:v>
                </c:pt>
                <c:pt idx="250">
                  <c:v>43.650952962151202</c:v>
                </c:pt>
                <c:pt idx="251">
                  <c:v>41.741460252751999</c:v>
                </c:pt>
                <c:pt idx="252">
                  <c:v>45.835141100735697</c:v>
                </c:pt>
                <c:pt idx="253">
                  <c:v>57.623130586868598</c:v>
                </c:pt>
                <c:pt idx="254">
                  <c:v>80.227205535190393</c:v>
                </c:pt>
                <c:pt idx="255">
                  <c:v>32.2910221023376</c:v>
                </c:pt>
                <c:pt idx="256">
                  <c:v>49.144646510577097</c:v>
                </c:pt>
                <c:pt idx="257">
                  <c:v>53.382074849850603</c:v>
                </c:pt>
                <c:pt idx="258">
                  <c:v>65.567685423797101</c:v>
                </c:pt>
                <c:pt idx="259">
                  <c:v>46.020502168840899</c:v>
                </c:pt>
                <c:pt idx="260">
                  <c:v>54.7613336219788</c:v>
                </c:pt>
                <c:pt idx="261">
                  <c:v>36.6812974237479</c:v>
                </c:pt>
                <c:pt idx="262">
                  <c:v>42.3206720500337</c:v>
                </c:pt>
                <c:pt idx="263">
                  <c:v>43.925047381836599</c:v>
                </c:pt>
                <c:pt idx="264">
                  <c:v>37.7859462132636</c:v>
                </c:pt>
                <c:pt idx="265">
                  <c:v>53.662456086035199</c:v>
                </c:pt>
                <c:pt idx="266">
                  <c:v>46.557322110846997</c:v>
                </c:pt>
                <c:pt idx="267">
                  <c:v>52.240147855931099</c:v>
                </c:pt>
                <c:pt idx="268">
                  <c:v>39.062826890898897</c:v>
                </c:pt>
                <c:pt idx="269">
                  <c:v>49.842999619024198</c:v>
                </c:pt>
                <c:pt idx="270">
                  <c:v>34.491414720439998</c:v>
                </c:pt>
                <c:pt idx="271">
                  <c:v>61.312921522282302</c:v>
                </c:pt>
                <c:pt idx="272">
                  <c:v>30.5539452250881</c:v>
                </c:pt>
                <c:pt idx="273">
                  <c:v>47.6389141568471</c:v>
                </c:pt>
                <c:pt idx="274">
                  <c:v>62.1950448361805</c:v>
                </c:pt>
                <c:pt idx="275">
                  <c:v>61.710498221314403</c:v>
                </c:pt>
                <c:pt idx="276">
                  <c:v>28.501742895187899</c:v>
                </c:pt>
                <c:pt idx="277">
                  <c:v>53.607976319671202</c:v>
                </c:pt>
                <c:pt idx="278">
                  <c:v>47.8683696575212</c:v>
                </c:pt>
                <c:pt idx="279">
                  <c:v>52.196696624883799</c:v>
                </c:pt>
                <c:pt idx="280">
                  <c:v>48.187934864054803</c:v>
                </c:pt>
                <c:pt idx="281">
                  <c:v>61.843450770241297</c:v>
                </c:pt>
                <c:pt idx="282">
                  <c:v>47.453440566848499</c:v>
                </c:pt>
                <c:pt idx="283">
                  <c:v>43.272571874250403</c:v>
                </c:pt>
                <c:pt idx="284">
                  <c:v>52.718433909246002</c:v>
                </c:pt>
                <c:pt idx="285">
                  <c:v>53.050669869240501</c:v>
                </c:pt>
                <c:pt idx="286">
                  <c:v>37.665440132271698</c:v>
                </c:pt>
                <c:pt idx="287">
                  <c:v>68.231226071423905</c:v>
                </c:pt>
                <c:pt idx="288">
                  <c:v>51.8371752561563</c:v>
                </c:pt>
                <c:pt idx="289">
                  <c:v>58.683164422586302</c:v>
                </c:pt>
                <c:pt idx="290">
                  <c:v>52.136219041930502</c:v>
                </c:pt>
                <c:pt idx="291">
                  <c:v>50.7542158979911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9DF-470E-97DB-709ED546C3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1129648"/>
        <c:axId val="1242913664"/>
      </c:scatterChart>
      <c:valAx>
        <c:axId val="124112964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42913664"/>
        <c:crosses val="autoZero"/>
        <c:crossBetween val="midCat"/>
      </c:valAx>
      <c:valAx>
        <c:axId val="12429136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4112964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3700C-F776-49A4-B4B3-4BB51D5AC8BC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61A41-35D4-454B-97BD-796F4B7D15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0010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3700C-F776-49A4-B4B3-4BB51D5AC8BC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61A41-35D4-454B-97BD-796F4B7D15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86640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3700C-F776-49A4-B4B3-4BB51D5AC8BC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61A41-35D4-454B-97BD-796F4B7D15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32821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3700C-F776-49A4-B4B3-4BB51D5AC8BC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61A41-35D4-454B-97BD-796F4B7D15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6373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3700C-F776-49A4-B4B3-4BB51D5AC8BC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61A41-35D4-454B-97BD-796F4B7D15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4295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3700C-F776-49A4-B4B3-4BB51D5AC8BC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61A41-35D4-454B-97BD-796F4B7D15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75194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3700C-F776-49A4-B4B3-4BB51D5AC8BC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61A41-35D4-454B-97BD-796F4B7D15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11604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3700C-F776-49A4-B4B3-4BB51D5AC8BC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61A41-35D4-454B-97BD-796F4B7D15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848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3700C-F776-49A4-B4B3-4BB51D5AC8BC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61A41-35D4-454B-97BD-796F4B7D15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02778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3700C-F776-49A4-B4B3-4BB51D5AC8BC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61A41-35D4-454B-97BD-796F4B7D15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19473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3700C-F776-49A4-B4B3-4BB51D5AC8BC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261A41-35D4-454B-97BD-796F4B7D15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77939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33700C-F776-49A4-B4B3-4BB51D5AC8BC}" type="datetimeFigureOut">
              <a:rPr lang="en-US" smtClean="0"/>
              <a:t>9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261A41-35D4-454B-97BD-796F4B7D15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40970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C819246E-6E7A-40E2-8AAB-A13775F7373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66443863"/>
              </p:ext>
            </p:extLst>
          </p:nvPr>
        </p:nvGraphicFramePr>
        <p:xfrm>
          <a:off x="761999" y="418768"/>
          <a:ext cx="481716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C819246E-6E7A-40E2-8AAB-A13775F7373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0261816"/>
              </p:ext>
            </p:extLst>
          </p:nvPr>
        </p:nvGraphicFramePr>
        <p:xfrm>
          <a:off x="6476999" y="520147"/>
          <a:ext cx="485361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C819246E-6E7A-40E2-8AAB-A13775F7373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45744645"/>
              </p:ext>
            </p:extLst>
          </p:nvPr>
        </p:nvGraphicFramePr>
        <p:xfrm>
          <a:off x="761997" y="3528392"/>
          <a:ext cx="468464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C819246E-6E7A-40E2-8AAB-A13775F7373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14420083"/>
              </p:ext>
            </p:extLst>
          </p:nvPr>
        </p:nvGraphicFramePr>
        <p:xfrm>
          <a:off x="6476999" y="3528392"/>
          <a:ext cx="485361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10295395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C819246E-6E7A-40E2-8AAB-A13775F7373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50393934"/>
              </p:ext>
            </p:extLst>
          </p:nvPr>
        </p:nvGraphicFramePr>
        <p:xfrm>
          <a:off x="722243" y="838200"/>
          <a:ext cx="481716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C819246E-6E7A-40E2-8AAB-A13775F7373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49490473"/>
              </p:ext>
            </p:extLst>
          </p:nvPr>
        </p:nvGraphicFramePr>
        <p:xfrm>
          <a:off x="6109253" y="838200"/>
          <a:ext cx="5208104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3833673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8</TotalTime>
  <Words>7</Words>
  <Application>Microsoft Office PowerPoint</Application>
  <PresentationFormat>Widescreen</PresentationFormat>
  <Paragraphs>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ONOB PAUL</dc:creator>
  <cp:lastModifiedBy>Pronob J. Paul</cp:lastModifiedBy>
  <cp:revision>9</cp:revision>
  <dcterms:created xsi:type="dcterms:W3CDTF">2016-06-06T05:31:07Z</dcterms:created>
  <dcterms:modified xsi:type="dcterms:W3CDTF">2017-09-12T08:38:16Z</dcterms:modified>
</cp:coreProperties>
</file>